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00" d="100"/>
          <a:sy n="100" d="100"/>
        </p:scale>
        <p:origin x="-29" y="-2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0_1">
  <dgm:title val=""/>
  <dgm:desc val=""/>
  <dgm:catLst>
    <dgm:cat type="mainScheme" pri="10100"/>
  </dgm:catLst>
  <dgm:styleLbl name="node0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lign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ln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vennNode1">
    <dgm:fillClrLst meth="repeat">
      <a:schemeClr val="lt1">
        <a:alpha val="50000"/>
      </a:schemeClr>
    </dgm:fillClrLst>
    <dgm:linClrLst meth="repeat">
      <a:schemeClr val="dk1">
        <a:shade val="80000"/>
      </a:schemeClr>
    </dgm:linClrLst>
    <dgm:effectClrLst/>
    <dgm:txLinClrLst/>
    <dgm:txFillClrLst/>
    <dgm:txEffectClrLst/>
  </dgm:styleLbl>
  <dgm:styleLbl name="node2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3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4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fg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bg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sibTrans1D1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2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3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4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parCh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/>
    <dgm:txEffectClrLst/>
  </dgm:styleLbl>
  <dgm:styleLbl name="parChTrans2D2">
    <dgm:fillClrLst meth="repeat">
      <a:schemeClr val="dk1"/>
    </dgm:fillClrLst>
    <dgm:linClrLst meth="repeat">
      <a:schemeClr val="dk1"/>
    </dgm:linClrLst>
    <dgm:effectClrLst/>
    <dgm:txLinClrLst/>
    <dgm:txFillClrLst/>
    <dgm:txEffectClrLst/>
  </dgm:styleLbl>
  <dgm:styleLbl name="parChTrans2D3">
    <dgm:fillClrLst meth="repeat">
      <a:schemeClr val="dk1"/>
    </dgm:fillClrLst>
    <dgm:linClrLst meth="repeat">
      <a:schemeClr val="dk1"/>
    </dgm:linClrLst>
    <dgm:effectClrLst/>
    <dgm:txLinClrLst/>
    <dgm:txFillClrLst/>
    <dgm:txEffectClrLst/>
  </dgm:styleLbl>
  <dgm:styleLbl name="parChTrans2D4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dk1"/>
    </dgm:fillClrLst>
    <dgm:linClrLst meth="repeat">
      <a:schemeClr val="dk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dk1"/>
    </dgm:fillClrLst>
    <dgm:linClrLst meth="repeat">
      <a:schemeClr val="dk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dk1"/>
    </dgm:fillClrLst>
    <dgm:linClrLst meth="repeat">
      <a:schemeClr val="dk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dk1"/>
    </dgm:fillClrLst>
    <dgm:linClrLst meth="repeat">
      <a:schemeClr val="dk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dk1">
        <a:alpha val="4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dk1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dk1">
        <a:shade val="8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dk1">
        <a:tint val="50000"/>
        <a:alpha val="4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dk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C3AE1E3F-4BB1-41B8-B320-E6E541EE877F}" type="doc">
      <dgm:prSet loTypeId="urn:microsoft.com/office/officeart/2005/8/layout/hierarchy1" loCatId="hierarchy" qsTypeId="urn:microsoft.com/office/officeart/2005/8/quickstyle/simple1" qsCatId="simple" csTypeId="urn:microsoft.com/office/officeart/2005/8/colors/accent0_1" csCatId="mainScheme" phldr="1"/>
      <dgm:spPr/>
      <dgm:t>
        <a:bodyPr/>
        <a:lstStyle/>
        <a:p>
          <a:endParaRPr lang="en-US"/>
        </a:p>
      </dgm:t>
    </dgm:pt>
    <dgm:pt modelId="{323FCB35-71DE-4B41-A68A-9AFE76410811}">
      <dgm:prSet phldrT="[Text]" custT="1"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  <dgm:t>
        <a:bodyPr/>
        <a:lstStyle/>
        <a:p>
          <a:pPr rtl="0"/>
          <a:r>
            <a:rPr lang="en-US" sz="1000" dirty="0" smtClean="0">
              <a:cs typeface="+mj-cs"/>
            </a:rPr>
            <a:t> Umbilical Hernias</a:t>
          </a:r>
        </a:p>
        <a:p>
          <a:pPr rtl="0"/>
          <a:r>
            <a:rPr lang="en-US" sz="1000" smtClean="0">
              <a:cs typeface="+mj-cs"/>
            </a:rPr>
            <a:t>267 calves</a:t>
          </a:r>
          <a:r>
            <a:rPr lang="en-US" sz="1000" dirty="0" smtClean="0">
              <a:cs typeface="+mj-cs"/>
            </a:rPr>
            <a:t/>
          </a:r>
          <a:br>
            <a:rPr lang="en-US" sz="1000" dirty="0" smtClean="0">
              <a:cs typeface="+mj-cs"/>
            </a:rPr>
          </a:br>
          <a:r>
            <a:rPr lang="en-US" sz="1000" dirty="0" smtClean="0">
              <a:cs typeface="+mj-cs"/>
            </a:rPr>
            <a:t>(Husbandry system)</a:t>
          </a:r>
          <a:endParaRPr lang="en-US" sz="1000" dirty="0">
            <a:cs typeface="+mj-cs"/>
          </a:endParaRPr>
        </a:p>
      </dgm:t>
    </dgm:pt>
    <dgm:pt modelId="{33572893-3A83-4976-A931-779C7340D8BD}" type="parTrans" cxnId="{D8B14966-EA4C-49B5-8932-0DFA60D59489}">
      <dgm:prSet/>
      <dgm:spPr/>
      <dgm:t>
        <a:bodyPr/>
        <a:lstStyle/>
        <a:p>
          <a:endParaRPr lang="en-US"/>
        </a:p>
      </dgm:t>
    </dgm:pt>
    <dgm:pt modelId="{B8736D78-39E7-430E-8711-089A39C67DCF}" type="sibTrans" cxnId="{D8B14966-EA4C-49B5-8932-0DFA60D59489}">
      <dgm:prSet/>
      <dgm:spPr/>
      <dgm:t>
        <a:bodyPr/>
        <a:lstStyle/>
        <a:p>
          <a:endParaRPr lang="en-US"/>
        </a:p>
      </dgm:t>
    </dgm:pt>
    <dgm:pt modelId="{B93C0E96-0C44-4DA7-8EF5-7E08452A9D19}">
      <dgm:prSet phldrT="[Text]" custT="1"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  <dgm:t>
        <a:bodyPr/>
        <a:lstStyle/>
        <a:p>
          <a:pPr rtl="0"/>
          <a:r>
            <a:rPr lang="en-US" sz="1000" dirty="0" smtClean="0">
              <a:cs typeface="+mj-cs"/>
            </a:rPr>
            <a:t>Simple 9 (75%)</a:t>
          </a:r>
          <a:endParaRPr lang="en-US" sz="1000" dirty="0">
            <a:cs typeface="+mj-cs"/>
          </a:endParaRPr>
        </a:p>
      </dgm:t>
    </dgm:pt>
    <dgm:pt modelId="{3C45595A-910B-49C7-9896-FB27B7D522D8}" type="parTrans" cxnId="{97E03301-AA66-4898-B286-63240EEB4A67}">
      <dgm:prSet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  <dgm:t>
        <a:bodyPr/>
        <a:lstStyle/>
        <a:p>
          <a:endParaRPr lang="en-US" sz="1000">
            <a:cs typeface="+mj-cs"/>
          </a:endParaRPr>
        </a:p>
      </dgm:t>
    </dgm:pt>
    <dgm:pt modelId="{9C00EEB5-66BD-4077-869A-7D9A32DC7377}" type="sibTrans" cxnId="{97E03301-AA66-4898-B286-63240EEB4A67}">
      <dgm:prSet/>
      <dgm:spPr/>
      <dgm:t>
        <a:bodyPr/>
        <a:lstStyle/>
        <a:p>
          <a:endParaRPr lang="en-US"/>
        </a:p>
      </dgm:t>
    </dgm:pt>
    <dgm:pt modelId="{8897EDD5-7504-40C6-A4CD-6909F5C91B88}">
      <dgm:prSet phldrT="[Text]" custT="1"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  <dgm:t>
        <a:bodyPr/>
        <a:lstStyle/>
        <a:p>
          <a:pPr rtl="0"/>
          <a:r>
            <a:rPr lang="en-US" sz="1000" dirty="0" smtClean="0">
              <a:cs typeface="+mj-cs"/>
            </a:rPr>
            <a:t>Complicated 3 (25%)</a:t>
          </a:r>
          <a:endParaRPr lang="en-US" sz="1000" dirty="0">
            <a:cs typeface="+mj-cs"/>
          </a:endParaRPr>
        </a:p>
      </dgm:t>
    </dgm:pt>
    <dgm:pt modelId="{E506F75C-EE25-433C-BAF2-83523763F7C4}" type="parTrans" cxnId="{863C3344-073B-4F4F-A626-ACBD577C08C7}">
      <dgm:prSet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  <dgm:t>
        <a:bodyPr/>
        <a:lstStyle/>
        <a:p>
          <a:endParaRPr lang="en-US" sz="1000">
            <a:cs typeface="+mj-cs"/>
          </a:endParaRPr>
        </a:p>
      </dgm:t>
    </dgm:pt>
    <dgm:pt modelId="{4FB3FC4C-ACF9-4315-9899-83FB53F954E1}" type="sibTrans" cxnId="{863C3344-073B-4F4F-A626-ACBD577C08C7}">
      <dgm:prSet/>
      <dgm:spPr/>
      <dgm:t>
        <a:bodyPr/>
        <a:lstStyle/>
        <a:p>
          <a:endParaRPr lang="en-US"/>
        </a:p>
      </dgm:t>
    </dgm:pt>
    <dgm:pt modelId="{617F4A82-4DC0-4566-B181-D5EC1A14D7FB}">
      <dgm:prSet phldrT="[Text]" custT="1"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  <dgm:t>
        <a:bodyPr/>
        <a:lstStyle/>
        <a:p>
          <a:pPr rtl="0"/>
          <a:r>
            <a:rPr lang="en-US" sz="1000" dirty="0" smtClean="0">
              <a:cs typeface="+mj-cs"/>
            </a:rPr>
            <a:t>Holstein</a:t>
          </a:r>
        </a:p>
        <a:p>
          <a:pPr rtl="0"/>
          <a:r>
            <a:rPr lang="en-US" sz="1000" dirty="0" smtClean="0">
              <a:cs typeface="+mj-cs"/>
            </a:rPr>
            <a:t>8</a:t>
          </a:r>
          <a:endParaRPr lang="en-US" sz="1000" dirty="0">
            <a:cs typeface="+mj-cs"/>
          </a:endParaRPr>
        </a:p>
      </dgm:t>
    </dgm:pt>
    <dgm:pt modelId="{5C94FED2-C0F0-4167-BEB5-5D8AF949FE21}" type="parTrans" cxnId="{67DEB04F-C181-435E-9FF6-5FADA277D812}">
      <dgm:prSet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  <dgm:t>
        <a:bodyPr/>
        <a:lstStyle/>
        <a:p>
          <a:endParaRPr lang="en-US" sz="1000">
            <a:cs typeface="+mj-cs"/>
          </a:endParaRPr>
        </a:p>
      </dgm:t>
    </dgm:pt>
    <dgm:pt modelId="{20F95872-CC8D-48DD-A4F1-FB67380E54C6}" type="sibTrans" cxnId="{67DEB04F-C181-435E-9FF6-5FADA277D812}">
      <dgm:prSet/>
      <dgm:spPr/>
      <dgm:t>
        <a:bodyPr/>
        <a:lstStyle/>
        <a:p>
          <a:endParaRPr lang="en-US"/>
        </a:p>
      </dgm:t>
    </dgm:pt>
    <dgm:pt modelId="{06F59819-EC31-443F-A17F-793138EA1CE3}">
      <dgm:prSet phldrT="[Text]" custT="1"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  <dgm:t>
        <a:bodyPr/>
        <a:lstStyle/>
        <a:p>
          <a:pPr rtl="0"/>
          <a:r>
            <a:rPr lang="en-US" sz="1000" dirty="0" smtClean="0">
              <a:cs typeface="+mj-cs"/>
            </a:rPr>
            <a:t>Native</a:t>
          </a:r>
        </a:p>
        <a:p>
          <a:pPr rtl="0"/>
          <a:r>
            <a:rPr lang="en-US" sz="1000" dirty="0" smtClean="0">
              <a:cs typeface="+mj-cs"/>
            </a:rPr>
            <a:t>0</a:t>
          </a:r>
          <a:endParaRPr lang="en-US" sz="1000" dirty="0">
            <a:cs typeface="+mj-cs"/>
          </a:endParaRPr>
        </a:p>
      </dgm:t>
    </dgm:pt>
    <dgm:pt modelId="{C0F9CD2B-3E98-4EB7-BE59-8AEDDED0EC18}" type="parTrans" cxnId="{9C71913C-C602-40E0-A01B-6A355E3E5CEF}">
      <dgm:prSet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  <dgm:t>
        <a:bodyPr/>
        <a:lstStyle/>
        <a:p>
          <a:endParaRPr lang="en-US" sz="1000">
            <a:cs typeface="+mj-cs"/>
          </a:endParaRPr>
        </a:p>
      </dgm:t>
    </dgm:pt>
    <dgm:pt modelId="{D9EF762C-6211-4C3E-B571-3494A2AF0469}" type="sibTrans" cxnId="{9C71913C-C602-40E0-A01B-6A355E3E5CEF}">
      <dgm:prSet/>
      <dgm:spPr/>
      <dgm:t>
        <a:bodyPr/>
        <a:lstStyle/>
        <a:p>
          <a:endParaRPr lang="en-US"/>
        </a:p>
      </dgm:t>
    </dgm:pt>
    <dgm:pt modelId="{0FBA54FB-0EE5-405C-9DA9-FDC9664C2367}">
      <dgm:prSet phldrT="[Text]" custT="1"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  <dgm:t>
        <a:bodyPr/>
        <a:lstStyle/>
        <a:p>
          <a:pPr rtl="0"/>
          <a:r>
            <a:rPr lang="en-US" sz="1000" dirty="0" smtClean="0">
              <a:cs typeface="+mj-cs"/>
            </a:rPr>
            <a:t>Others</a:t>
          </a:r>
        </a:p>
        <a:p>
          <a:pPr rtl="0"/>
          <a:r>
            <a:rPr lang="en-US" sz="1000" dirty="0" smtClean="0">
              <a:cs typeface="+mj-cs"/>
            </a:rPr>
            <a:t>1</a:t>
          </a:r>
          <a:endParaRPr lang="en-US" sz="1000" dirty="0">
            <a:cs typeface="+mj-cs"/>
          </a:endParaRPr>
        </a:p>
      </dgm:t>
    </dgm:pt>
    <dgm:pt modelId="{01D7A416-958E-48CB-AA04-B4A4E9657AA8}" type="parTrans" cxnId="{991F8771-8149-4D6A-9F3B-816BD285E895}">
      <dgm:prSet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  <dgm:t>
        <a:bodyPr/>
        <a:lstStyle/>
        <a:p>
          <a:endParaRPr lang="en-US" sz="1000">
            <a:cs typeface="+mj-cs"/>
          </a:endParaRPr>
        </a:p>
      </dgm:t>
    </dgm:pt>
    <dgm:pt modelId="{76145424-CC2E-4C9C-B6BF-E371805219D0}" type="sibTrans" cxnId="{991F8771-8149-4D6A-9F3B-816BD285E895}">
      <dgm:prSet/>
      <dgm:spPr/>
      <dgm:t>
        <a:bodyPr/>
        <a:lstStyle/>
        <a:p>
          <a:endParaRPr lang="en-US"/>
        </a:p>
      </dgm:t>
    </dgm:pt>
    <dgm:pt modelId="{B7B309C5-64A5-46E3-9620-C0A0B246341A}">
      <dgm:prSet phldrT="[Text]" custT="1"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  <dgm:t>
        <a:bodyPr/>
        <a:lstStyle/>
        <a:p>
          <a:pPr rtl="0"/>
          <a:r>
            <a:rPr lang="en-US" sz="1000" dirty="0" smtClean="0">
              <a:cs typeface="+mj-cs"/>
            </a:rPr>
            <a:t>Holstein</a:t>
          </a:r>
        </a:p>
        <a:p>
          <a:pPr rtl="0"/>
          <a:r>
            <a:rPr lang="en-US" sz="1000" dirty="0" smtClean="0">
              <a:cs typeface="+mj-cs"/>
            </a:rPr>
            <a:t>2</a:t>
          </a:r>
          <a:endParaRPr lang="en-US" sz="1000" dirty="0">
            <a:cs typeface="+mj-cs"/>
          </a:endParaRPr>
        </a:p>
      </dgm:t>
    </dgm:pt>
    <dgm:pt modelId="{3F9F0D71-0D4B-4B85-AAEB-0137C402AA2F}" type="parTrans" cxnId="{3B6B5BC9-3B03-4A5D-BBDE-443E1C7871DF}">
      <dgm:prSet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  <dgm:t>
        <a:bodyPr/>
        <a:lstStyle/>
        <a:p>
          <a:endParaRPr lang="en-US" sz="1000">
            <a:cs typeface="+mj-cs"/>
          </a:endParaRPr>
        </a:p>
      </dgm:t>
    </dgm:pt>
    <dgm:pt modelId="{ADB6394B-023A-44FE-BE99-8A28C8DECAE7}" type="sibTrans" cxnId="{3B6B5BC9-3B03-4A5D-BBDE-443E1C7871DF}">
      <dgm:prSet/>
      <dgm:spPr/>
      <dgm:t>
        <a:bodyPr/>
        <a:lstStyle/>
        <a:p>
          <a:endParaRPr lang="en-US"/>
        </a:p>
      </dgm:t>
    </dgm:pt>
    <dgm:pt modelId="{C87AFAC8-39A0-48CE-8522-4086E06F865D}">
      <dgm:prSet phldrT="[Text]" custT="1"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  <dgm:t>
        <a:bodyPr/>
        <a:lstStyle/>
        <a:p>
          <a:pPr rtl="0"/>
          <a:r>
            <a:rPr lang="en-US" sz="1000" dirty="0" smtClean="0">
              <a:cs typeface="+mj-cs"/>
            </a:rPr>
            <a:t>Native</a:t>
          </a:r>
        </a:p>
        <a:p>
          <a:pPr rtl="0"/>
          <a:r>
            <a:rPr lang="en-US" sz="1000" dirty="0" smtClean="0">
              <a:cs typeface="+mj-cs"/>
            </a:rPr>
            <a:t>0</a:t>
          </a:r>
          <a:endParaRPr lang="en-US" sz="1000" dirty="0">
            <a:cs typeface="+mj-cs"/>
          </a:endParaRPr>
        </a:p>
      </dgm:t>
    </dgm:pt>
    <dgm:pt modelId="{AAB879FB-B431-425F-9F64-6AC0D9C7100D}" type="parTrans" cxnId="{EAA99D04-E60B-49AB-A2CB-EB2057732F04}">
      <dgm:prSet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  <dgm:t>
        <a:bodyPr/>
        <a:lstStyle/>
        <a:p>
          <a:endParaRPr lang="en-US" sz="1000">
            <a:cs typeface="+mj-cs"/>
          </a:endParaRPr>
        </a:p>
      </dgm:t>
    </dgm:pt>
    <dgm:pt modelId="{F2B9D162-B7D2-4A93-ACBA-CAF6D21F599A}" type="sibTrans" cxnId="{EAA99D04-E60B-49AB-A2CB-EB2057732F04}">
      <dgm:prSet/>
      <dgm:spPr/>
      <dgm:t>
        <a:bodyPr/>
        <a:lstStyle/>
        <a:p>
          <a:endParaRPr lang="en-US"/>
        </a:p>
      </dgm:t>
    </dgm:pt>
    <dgm:pt modelId="{A0E098DB-BB34-4B42-ABD1-9C75ED506DEC}">
      <dgm:prSet phldrT="[Text]" custT="1"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  <dgm:t>
        <a:bodyPr/>
        <a:lstStyle/>
        <a:p>
          <a:pPr rtl="0"/>
          <a:r>
            <a:rPr lang="en-US" sz="1000" dirty="0" smtClean="0">
              <a:cs typeface="+mj-cs"/>
            </a:rPr>
            <a:t>Others</a:t>
          </a:r>
        </a:p>
        <a:p>
          <a:pPr rtl="0"/>
          <a:r>
            <a:rPr lang="en-US" sz="1000" dirty="0" smtClean="0">
              <a:cs typeface="+mj-cs"/>
            </a:rPr>
            <a:t>1</a:t>
          </a:r>
          <a:endParaRPr lang="en-US" sz="1000" dirty="0">
            <a:cs typeface="+mj-cs"/>
          </a:endParaRPr>
        </a:p>
      </dgm:t>
    </dgm:pt>
    <dgm:pt modelId="{0DF04010-629C-4F5A-8855-29BACB84498A}" type="parTrans" cxnId="{6ADA9C4C-B207-4833-8716-2C619EEF1E00}">
      <dgm:prSet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  <dgm:t>
        <a:bodyPr/>
        <a:lstStyle/>
        <a:p>
          <a:endParaRPr lang="en-US" sz="1000">
            <a:cs typeface="+mj-cs"/>
          </a:endParaRPr>
        </a:p>
      </dgm:t>
    </dgm:pt>
    <dgm:pt modelId="{E5845F04-B8D4-4F70-A90E-C20A68524CD3}" type="sibTrans" cxnId="{6ADA9C4C-B207-4833-8716-2C619EEF1E00}">
      <dgm:prSet/>
      <dgm:spPr/>
      <dgm:t>
        <a:bodyPr/>
        <a:lstStyle/>
        <a:p>
          <a:endParaRPr lang="en-US"/>
        </a:p>
      </dgm:t>
    </dgm:pt>
    <dgm:pt modelId="{1A34E547-DDC2-4563-ACB2-3E924F9BFEA8}">
      <dgm:prSet phldrT="[Text]" custT="1"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  <dgm:t>
        <a:bodyPr/>
        <a:lstStyle/>
        <a:p>
          <a:pPr rtl="0"/>
          <a:r>
            <a:rPr lang="en-US" sz="1000" dirty="0" smtClean="0">
              <a:cs typeface="+mj-cs"/>
            </a:rPr>
            <a:t>Range 255 (95.5%)</a:t>
          </a:r>
        </a:p>
      </dgm:t>
    </dgm:pt>
    <dgm:pt modelId="{5E504991-298D-40D2-A77C-63634331796F}" type="parTrans" cxnId="{75EEA75E-2110-4653-963D-9AA2E8D99B8D}">
      <dgm:prSet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  <dgm:t>
        <a:bodyPr/>
        <a:lstStyle/>
        <a:p>
          <a:endParaRPr lang="en-US" sz="1000">
            <a:cs typeface="+mj-cs"/>
          </a:endParaRPr>
        </a:p>
      </dgm:t>
    </dgm:pt>
    <dgm:pt modelId="{92BB240C-3E70-4C74-B761-CC412E4FF58F}" type="sibTrans" cxnId="{75EEA75E-2110-4653-963D-9AA2E8D99B8D}">
      <dgm:prSet/>
      <dgm:spPr/>
      <dgm:t>
        <a:bodyPr/>
        <a:lstStyle/>
        <a:p>
          <a:endParaRPr lang="en-US"/>
        </a:p>
      </dgm:t>
    </dgm:pt>
    <dgm:pt modelId="{39F5AD40-E28B-41AA-9A1E-F07F29E2C5E0}">
      <dgm:prSet phldrT="[Text]" custT="1"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  <dgm:t>
        <a:bodyPr/>
        <a:lstStyle/>
        <a:p>
          <a:pPr rtl="0"/>
          <a:r>
            <a:rPr lang="en-US" sz="1000" dirty="0" smtClean="0">
              <a:cs typeface="+mj-cs"/>
            </a:rPr>
            <a:t>Smallholder 12 (4.5%) </a:t>
          </a:r>
        </a:p>
      </dgm:t>
    </dgm:pt>
    <dgm:pt modelId="{C8346F43-EBC3-4009-85E3-DB4742C30E9A}" type="parTrans" cxnId="{76053BBA-1D57-4EBF-8783-046D4B319683}">
      <dgm:prSet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  <dgm:t>
        <a:bodyPr/>
        <a:lstStyle/>
        <a:p>
          <a:endParaRPr lang="en-US" sz="1000">
            <a:cs typeface="+mj-cs"/>
          </a:endParaRPr>
        </a:p>
      </dgm:t>
    </dgm:pt>
    <dgm:pt modelId="{3ABA5351-5722-4F4E-B2E2-D31354B757E7}" type="sibTrans" cxnId="{76053BBA-1D57-4EBF-8783-046D4B319683}">
      <dgm:prSet/>
      <dgm:spPr/>
      <dgm:t>
        <a:bodyPr/>
        <a:lstStyle/>
        <a:p>
          <a:endParaRPr lang="en-US"/>
        </a:p>
      </dgm:t>
    </dgm:pt>
    <dgm:pt modelId="{AF33832F-32CC-40AF-883E-CDFE523B1FA2}">
      <dgm:prSet phldrT="[Text]" custT="1"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  <dgm:t>
        <a:bodyPr/>
        <a:lstStyle/>
        <a:p>
          <a:pPr rtl="0"/>
          <a:r>
            <a:rPr lang="en-US" sz="1000" dirty="0" smtClean="0">
              <a:cs typeface="+mj-cs"/>
            </a:rPr>
            <a:t>Simple 220 (86%)</a:t>
          </a:r>
        </a:p>
      </dgm:t>
    </dgm:pt>
    <dgm:pt modelId="{ECD65FD5-969F-4192-9A4F-A7A1B759592C}" type="parTrans" cxnId="{484F7548-93C4-4706-BC71-8DF3E7C253B6}">
      <dgm:prSet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  <dgm:t>
        <a:bodyPr/>
        <a:lstStyle/>
        <a:p>
          <a:endParaRPr lang="en-US" sz="1000">
            <a:cs typeface="+mj-cs"/>
          </a:endParaRPr>
        </a:p>
      </dgm:t>
    </dgm:pt>
    <dgm:pt modelId="{15094C85-920B-4729-A35C-F42AF833D9ED}" type="sibTrans" cxnId="{484F7548-93C4-4706-BC71-8DF3E7C253B6}">
      <dgm:prSet/>
      <dgm:spPr/>
      <dgm:t>
        <a:bodyPr/>
        <a:lstStyle/>
        <a:p>
          <a:endParaRPr lang="en-US"/>
        </a:p>
      </dgm:t>
    </dgm:pt>
    <dgm:pt modelId="{930720CD-072F-4DEA-AED2-E8EA6CEB0B46}">
      <dgm:prSet phldrT="[Text]" custT="1"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  <dgm:t>
        <a:bodyPr/>
        <a:lstStyle/>
        <a:p>
          <a:pPr rtl="0"/>
          <a:r>
            <a:rPr lang="en-US" sz="1000" dirty="0" smtClean="0">
              <a:cs typeface="+mj-cs"/>
            </a:rPr>
            <a:t>Holstein</a:t>
          </a:r>
        </a:p>
        <a:p>
          <a:pPr rtl="0"/>
          <a:r>
            <a:rPr lang="en-US" sz="1000" dirty="0" smtClean="0">
              <a:cs typeface="+mj-cs"/>
            </a:rPr>
            <a:t>188 (85%)</a:t>
          </a:r>
          <a:endParaRPr lang="en-US" sz="1000" dirty="0">
            <a:cs typeface="+mj-cs"/>
          </a:endParaRPr>
        </a:p>
      </dgm:t>
    </dgm:pt>
    <dgm:pt modelId="{7E35767A-4A8A-4B5F-86ED-9E6910D8A4C8}" type="parTrans" cxnId="{DF014D6E-2FDB-41BE-86C8-CE1B45759002}">
      <dgm:prSet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  <dgm:t>
        <a:bodyPr/>
        <a:lstStyle/>
        <a:p>
          <a:endParaRPr lang="en-US" sz="1000">
            <a:cs typeface="+mj-cs"/>
          </a:endParaRPr>
        </a:p>
      </dgm:t>
    </dgm:pt>
    <dgm:pt modelId="{7FDED4A9-3A88-49C5-99CF-11216408E304}" type="sibTrans" cxnId="{DF014D6E-2FDB-41BE-86C8-CE1B45759002}">
      <dgm:prSet/>
      <dgm:spPr/>
      <dgm:t>
        <a:bodyPr/>
        <a:lstStyle/>
        <a:p>
          <a:endParaRPr lang="en-US"/>
        </a:p>
      </dgm:t>
    </dgm:pt>
    <dgm:pt modelId="{AEE26733-4C36-48CC-8607-9B1FDB74E85C}">
      <dgm:prSet phldrT="[Text]" custT="1"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  <dgm:t>
        <a:bodyPr/>
        <a:lstStyle/>
        <a:p>
          <a:pPr rtl="0"/>
          <a:r>
            <a:rPr lang="en-US" sz="1000" dirty="0" smtClean="0">
              <a:cs typeface="+mj-cs"/>
            </a:rPr>
            <a:t>Native</a:t>
          </a:r>
        </a:p>
        <a:p>
          <a:pPr rtl="0"/>
          <a:r>
            <a:rPr lang="en-US" sz="1000" dirty="0" smtClean="0">
              <a:cs typeface="+mj-cs"/>
            </a:rPr>
            <a:t>21 (10%)</a:t>
          </a:r>
          <a:endParaRPr lang="en-US" sz="1000" dirty="0">
            <a:cs typeface="+mj-cs"/>
          </a:endParaRPr>
        </a:p>
      </dgm:t>
    </dgm:pt>
    <dgm:pt modelId="{5090B564-B98E-4A91-871A-6AC1F9D07EDC}" type="parTrans" cxnId="{7130598C-2B78-4D08-B8D8-8B9A54A1FDC0}">
      <dgm:prSet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  <dgm:t>
        <a:bodyPr/>
        <a:lstStyle/>
        <a:p>
          <a:endParaRPr lang="en-US" sz="1000">
            <a:cs typeface="+mj-cs"/>
          </a:endParaRPr>
        </a:p>
      </dgm:t>
    </dgm:pt>
    <dgm:pt modelId="{AFDAEB4D-FEFF-4411-A37C-17B62E978BC0}" type="sibTrans" cxnId="{7130598C-2B78-4D08-B8D8-8B9A54A1FDC0}">
      <dgm:prSet/>
      <dgm:spPr/>
      <dgm:t>
        <a:bodyPr/>
        <a:lstStyle/>
        <a:p>
          <a:endParaRPr lang="en-US"/>
        </a:p>
      </dgm:t>
    </dgm:pt>
    <dgm:pt modelId="{68AB00C8-16B6-41E6-B8A5-389DF5736300}">
      <dgm:prSet phldrT="[Text]" custT="1"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  <dgm:t>
        <a:bodyPr/>
        <a:lstStyle/>
        <a:p>
          <a:pPr rtl="0"/>
          <a:r>
            <a:rPr lang="en-US" sz="1000" dirty="0" smtClean="0">
              <a:cs typeface="+mj-cs"/>
            </a:rPr>
            <a:t>Others</a:t>
          </a:r>
        </a:p>
        <a:p>
          <a:pPr rtl="0"/>
          <a:r>
            <a:rPr lang="en-US" sz="1000" dirty="0" smtClean="0">
              <a:cs typeface="+mj-cs"/>
            </a:rPr>
            <a:t>11 (5%)</a:t>
          </a:r>
          <a:endParaRPr lang="en-US" sz="1000" dirty="0">
            <a:cs typeface="+mj-cs"/>
          </a:endParaRPr>
        </a:p>
      </dgm:t>
    </dgm:pt>
    <dgm:pt modelId="{A89F964B-AE4D-441A-88D7-19FFD554E876}" type="parTrans" cxnId="{82F9A541-52C7-439C-B703-B19769C5E665}">
      <dgm:prSet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  <dgm:t>
        <a:bodyPr/>
        <a:lstStyle/>
        <a:p>
          <a:endParaRPr lang="en-US" sz="1000">
            <a:cs typeface="+mj-cs"/>
          </a:endParaRPr>
        </a:p>
      </dgm:t>
    </dgm:pt>
    <dgm:pt modelId="{A79DF145-F077-413D-A7B1-7C19EEF4AA83}" type="sibTrans" cxnId="{82F9A541-52C7-439C-B703-B19769C5E665}">
      <dgm:prSet/>
      <dgm:spPr/>
      <dgm:t>
        <a:bodyPr/>
        <a:lstStyle/>
        <a:p>
          <a:endParaRPr lang="en-US"/>
        </a:p>
      </dgm:t>
    </dgm:pt>
    <dgm:pt modelId="{DFCF81B1-7BF0-4982-9527-6D7378767CE5}">
      <dgm:prSet phldrT="[Text]" custT="1"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  <dgm:t>
        <a:bodyPr/>
        <a:lstStyle/>
        <a:p>
          <a:pPr rtl="0"/>
          <a:r>
            <a:rPr lang="en-US" sz="1000" dirty="0" smtClean="0">
              <a:cs typeface="+mj-cs"/>
            </a:rPr>
            <a:t>Complicated 35 (14%)</a:t>
          </a:r>
          <a:endParaRPr lang="en-US" sz="1000" dirty="0">
            <a:cs typeface="+mj-cs"/>
          </a:endParaRPr>
        </a:p>
      </dgm:t>
    </dgm:pt>
    <dgm:pt modelId="{B68C1DA2-BC92-4706-919D-B1E3C6FCEF47}" type="parTrans" cxnId="{F52496C0-AD3D-446E-90E1-CC34984D3CCD}">
      <dgm:prSet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  <dgm:t>
        <a:bodyPr/>
        <a:lstStyle/>
        <a:p>
          <a:endParaRPr lang="en-US" sz="1000">
            <a:cs typeface="+mj-cs"/>
          </a:endParaRPr>
        </a:p>
      </dgm:t>
    </dgm:pt>
    <dgm:pt modelId="{0544A411-3AD8-45F2-BEE6-AB7EE2310B9F}" type="sibTrans" cxnId="{F52496C0-AD3D-446E-90E1-CC34984D3CCD}">
      <dgm:prSet/>
      <dgm:spPr/>
      <dgm:t>
        <a:bodyPr/>
        <a:lstStyle/>
        <a:p>
          <a:endParaRPr lang="en-US"/>
        </a:p>
      </dgm:t>
    </dgm:pt>
    <dgm:pt modelId="{5B6A839D-C3C7-49C0-AD60-55F3773149FD}">
      <dgm:prSet phldrT="[Text]" custT="1"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  <dgm:t>
        <a:bodyPr/>
        <a:lstStyle/>
        <a:p>
          <a:pPr rtl="0"/>
          <a:r>
            <a:rPr lang="en-US" sz="1000" dirty="0" smtClean="0">
              <a:cs typeface="+mj-cs"/>
            </a:rPr>
            <a:t>Holstein</a:t>
          </a:r>
        </a:p>
        <a:p>
          <a:pPr rtl="0"/>
          <a:r>
            <a:rPr lang="en-US" sz="1000" dirty="0" smtClean="0">
              <a:cs typeface="+mj-cs"/>
            </a:rPr>
            <a:t>28 (80%)</a:t>
          </a:r>
          <a:endParaRPr lang="en-US" sz="1000" dirty="0">
            <a:cs typeface="+mj-cs"/>
          </a:endParaRPr>
        </a:p>
      </dgm:t>
    </dgm:pt>
    <dgm:pt modelId="{DCE52416-E466-47D0-BF34-B1373ADD5F5F}" type="parTrans" cxnId="{82F4A701-6DAA-486E-9AA8-D1CBC2B70C62}">
      <dgm:prSet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  <dgm:t>
        <a:bodyPr/>
        <a:lstStyle/>
        <a:p>
          <a:endParaRPr lang="en-US" sz="1000">
            <a:cs typeface="+mj-cs"/>
          </a:endParaRPr>
        </a:p>
      </dgm:t>
    </dgm:pt>
    <dgm:pt modelId="{9CF261A2-D173-4955-950A-16E24AAEC61C}" type="sibTrans" cxnId="{82F4A701-6DAA-486E-9AA8-D1CBC2B70C62}">
      <dgm:prSet/>
      <dgm:spPr/>
      <dgm:t>
        <a:bodyPr/>
        <a:lstStyle/>
        <a:p>
          <a:endParaRPr lang="en-US"/>
        </a:p>
      </dgm:t>
    </dgm:pt>
    <dgm:pt modelId="{FE644E46-A0D2-4C2C-B20E-E8C0D946744D}">
      <dgm:prSet phldrT="[Text]" custT="1"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  <dgm:t>
        <a:bodyPr/>
        <a:lstStyle/>
        <a:p>
          <a:pPr rtl="0"/>
          <a:r>
            <a:rPr lang="en-US" sz="1000" dirty="0" smtClean="0">
              <a:cs typeface="+mj-cs"/>
            </a:rPr>
            <a:t>Native</a:t>
          </a:r>
        </a:p>
        <a:p>
          <a:pPr rtl="0"/>
          <a:r>
            <a:rPr lang="en-US" sz="1000" dirty="0" smtClean="0">
              <a:cs typeface="+mj-cs"/>
            </a:rPr>
            <a:t>5 (14%)</a:t>
          </a:r>
          <a:endParaRPr lang="en-US" sz="1000" dirty="0">
            <a:cs typeface="+mj-cs"/>
          </a:endParaRPr>
        </a:p>
      </dgm:t>
    </dgm:pt>
    <dgm:pt modelId="{620BB554-384C-477E-B06B-FBA72951148F}" type="parTrans" cxnId="{E8401C8D-CC01-4A20-B9CC-2D803DD3A210}">
      <dgm:prSet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  <dgm:t>
        <a:bodyPr/>
        <a:lstStyle/>
        <a:p>
          <a:endParaRPr lang="en-US" sz="1000">
            <a:cs typeface="+mj-cs"/>
          </a:endParaRPr>
        </a:p>
      </dgm:t>
    </dgm:pt>
    <dgm:pt modelId="{E7286029-EFDB-414E-B822-1EEDC6FF8738}" type="sibTrans" cxnId="{E8401C8D-CC01-4A20-B9CC-2D803DD3A210}">
      <dgm:prSet/>
      <dgm:spPr/>
      <dgm:t>
        <a:bodyPr/>
        <a:lstStyle/>
        <a:p>
          <a:endParaRPr lang="en-US"/>
        </a:p>
      </dgm:t>
    </dgm:pt>
    <dgm:pt modelId="{E54523CE-5A26-49D4-92ED-8129E085E1E3}">
      <dgm:prSet phldrT="[Text]" custT="1"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  <dgm:t>
        <a:bodyPr/>
        <a:lstStyle/>
        <a:p>
          <a:pPr rtl="0"/>
          <a:r>
            <a:rPr lang="en-US" sz="1000" dirty="0" smtClean="0">
              <a:cs typeface="+mj-cs"/>
            </a:rPr>
            <a:t>Others</a:t>
          </a:r>
        </a:p>
        <a:p>
          <a:pPr rtl="0"/>
          <a:r>
            <a:rPr lang="en-US" sz="1000" dirty="0" smtClean="0">
              <a:cs typeface="+mj-cs"/>
            </a:rPr>
            <a:t>2 (6%)</a:t>
          </a:r>
          <a:endParaRPr lang="en-US" sz="1000" dirty="0">
            <a:cs typeface="+mj-cs"/>
          </a:endParaRPr>
        </a:p>
      </dgm:t>
    </dgm:pt>
    <dgm:pt modelId="{3D69239F-55A9-4322-AB85-3ABCEA8D90DD}" type="parTrans" cxnId="{3CDF5B5E-001F-4AB1-A9E3-FC8CD2EB216C}">
      <dgm:prSet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  <dgm:t>
        <a:bodyPr/>
        <a:lstStyle/>
        <a:p>
          <a:endParaRPr lang="en-US" sz="1000">
            <a:cs typeface="+mj-cs"/>
          </a:endParaRPr>
        </a:p>
      </dgm:t>
    </dgm:pt>
    <dgm:pt modelId="{B5E2EDC1-F1E0-487F-B001-7B9C0A02AE92}" type="sibTrans" cxnId="{3CDF5B5E-001F-4AB1-A9E3-FC8CD2EB216C}">
      <dgm:prSet/>
      <dgm:spPr/>
      <dgm:t>
        <a:bodyPr/>
        <a:lstStyle/>
        <a:p>
          <a:endParaRPr lang="en-US"/>
        </a:p>
      </dgm:t>
    </dgm:pt>
    <dgm:pt modelId="{0E8E3C61-C209-4BBF-B1BB-F9A0D40C092E}" type="pres">
      <dgm:prSet presAssocID="{C3AE1E3F-4BB1-41B8-B320-E6E541EE877F}" presName="hierChild1" presStyleCnt="0">
        <dgm:presLayoutVars>
          <dgm:chPref val="1"/>
          <dgm:dir/>
          <dgm:animOne val="branch"/>
          <dgm:animLvl val="lvl"/>
          <dgm:resizeHandles/>
        </dgm:presLayoutVars>
      </dgm:prSet>
      <dgm:spPr/>
    </dgm:pt>
    <dgm:pt modelId="{4D279FF0-3975-45F8-A23C-C6B8897830B5}" type="pres">
      <dgm:prSet presAssocID="{323FCB35-71DE-4B41-A68A-9AFE76410811}" presName="hierRoot1" presStyleCnt="0"/>
      <dgm:spPr/>
    </dgm:pt>
    <dgm:pt modelId="{C45C86DC-BD7C-4896-BF05-7035EA9D0029}" type="pres">
      <dgm:prSet presAssocID="{323FCB35-71DE-4B41-A68A-9AFE76410811}" presName="composite" presStyleCnt="0"/>
      <dgm:spPr/>
    </dgm:pt>
    <dgm:pt modelId="{B86B6C38-1EA5-42F9-A2F5-D56D42BC74CC}" type="pres">
      <dgm:prSet presAssocID="{323FCB35-71DE-4B41-A68A-9AFE76410811}" presName="background" presStyleLbl="node0" presStyleIdx="0" presStyleCnt="1"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</dgm:pt>
    <dgm:pt modelId="{9A3FB502-E9FE-4A87-B7A2-97A20E62DC1B}" type="pres">
      <dgm:prSet presAssocID="{323FCB35-71DE-4B41-A68A-9AFE76410811}" presName="text" presStyleLbl="fgAcc0" presStyleIdx="0" presStyleCnt="1" custScaleX="314584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19F8EF68-FCDE-460B-B255-36A528E76163}" type="pres">
      <dgm:prSet presAssocID="{323FCB35-71DE-4B41-A68A-9AFE76410811}" presName="hierChild2" presStyleCnt="0"/>
      <dgm:spPr/>
    </dgm:pt>
    <dgm:pt modelId="{0F83E8E0-FBCA-48D3-89A9-716E3BD7259E}" type="pres">
      <dgm:prSet presAssocID="{5E504991-298D-40D2-A77C-63634331796F}" presName="Name10" presStyleLbl="parChTrans1D2" presStyleIdx="0" presStyleCnt="2"/>
      <dgm:spPr/>
    </dgm:pt>
    <dgm:pt modelId="{E85C31D1-9AB0-4460-94D9-CA9016972314}" type="pres">
      <dgm:prSet presAssocID="{1A34E547-DDC2-4563-ACB2-3E924F9BFEA8}" presName="hierRoot2" presStyleCnt="0"/>
      <dgm:spPr/>
    </dgm:pt>
    <dgm:pt modelId="{B9DFA751-C3C5-47B5-8198-56A61CCA09FF}" type="pres">
      <dgm:prSet presAssocID="{1A34E547-DDC2-4563-ACB2-3E924F9BFEA8}" presName="composite2" presStyleCnt="0"/>
      <dgm:spPr/>
    </dgm:pt>
    <dgm:pt modelId="{85DC020B-8793-4E48-BDD0-59483AE3BE28}" type="pres">
      <dgm:prSet presAssocID="{1A34E547-DDC2-4563-ACB2-3E924F9BFEA8}" presName="background2" presStyleLbl="node2" presStyleIdx="0" presStyleCnt="2"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</dgm:pt>
    <dgm:pt modelId="{DA4503CF-7324-420D-949A-A9ADB4B56557}" type="pres">
      <dgm:prSet presAssocID="{1A34E547-DDC2-4563-ACB2-3E924F9BFEA8}" presName="text2" presStyleLbl="fgAcc2" presStyleIdx="0" presStyleCnt="2" custScaleX="178605">
        <dgm:presLayoutVars>
          <dgm:chPref val="3"/>
        </dgm:presLayoutVars>
      </dgm:prSet>
      <dgm:spPr/>
    </dgm:pt>
    <dgm:pt modelId="{EB9C0338-C611-4AE4-ACA5-B185E4D89EDE}" type="pres">
      <dgm:prSet presAssocID="{1A34E547-DDC2-4563-ACB2-3E924F9BFEA8}" presName="hierChild3" presStyleCnt="0"/>
      <dgm:spPr/>
    </dgm:pt>
    <dgm:pt modelId="{01505EC1-C6BB-4A03-A691-B7B56C6803A3}" type="pres">
      <dgm:prSet presAssocID="{ECD65FD5-969F-4192-9A4F-A7A1B759592C}" presName="Name17" presStyleLbl="parChTrans1D3" presStyleIdx="0" presStyleCnt="4"/>
      <dgm:spPr/>
    </dgm:pt>
    <dgm:pt modelId="{F5435A33-CB3F-4AB1-A45B-F718E60C53A5}" type="pres">
      <dgm:prSet presAssocID="{AF33832F-32CC-40AF-883E-CDFE523B1FA2}" presName="hierRoot3" presStyleCnt="0"/>
      <dgm:spPr/>
    </dgm:pt>
    <dgm:pt modelId="{75340DEB-DD6B-4AA4-AB95-0955AB14B5F1}" type="pres">
      <dgm:prSet presAssocID="{AF33832F-32CC-40AF-883E-CDFE523B1FA2}" presName="composite3" presStyleCnt="0"/>
      <dgm:spPr/>
    </dgm:pt>
    <dgm:pt modelId="{A89D4233-94D6-4570-96E9-4153E0AE9554}" type="pres">
      <dgm:prSet presAssocID="{AF33832F-32CC-40AF-883E-CDFE523B1FA2}" presName="background3" presStyleLbl="node3" presStyleIdx="0" presStyleCnt="4"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</dgm:pt>
    <dgm:pt modelId="{9DF54347-2A12-4809-AACE-6706A932FCBD}" type="pres">
      <dgm:prSet presAssocID="{AF33832F-32CC-40AF-883E-CDFE523B1FA2}" presName="text3" presStyleLbl="fgAcc3" presStyleIdx="0" presStyleCnt="4" custScaleX="137492">
        <dgm:presLayoutVars>
          <dgm:chPref val="3"/>
        </dgm:presLayoutVars>
      </dgm:prSet>
      <dgm:spPr/>
    </dgm:pt>
    <dgm:pt modelId="{43C35C8E-7909-4970-AD95-4357F73BEA89}" type="pres">
      <dgm:prSet presAssocID="{AF33832F-32CC-40AF-883E-CDFE523B1FA2}" presName="hierChild4" presStyleCnt="0"/>
      <dgm:spPr/>
    </dgm:pt>
    <dgm:pt modelId="{5859CEB4-C93E-4FB0-A2E0-8EC5AD91AE86}" type="pres">
      <dgm:prSet presAssocID="{7E35767A-4A8A-4B5F-86ED-9E6910D8A4C8}" presName="Name23" presStyleLbl="parChTrans1D4" presStyleIdx="0" presStyleCnt="12"/>
      <dgm:spPr/>
    </dgm:pt>
    <dgm:pt modelId="{AF4B2DDC-F290-4FA3-B662-58C33ADBF3DD}" type="pres">
      <dgm:prSet presAssocID="{930720CD-072F-4DEA-AED2-E8EA6CEB0B46}" presName="hierRoot4" presStyleCnt="0"/>
      <dgm:spPr/>
    </dgm:pt>
    <dgm:pt modelId="{B53B3874-A5B2-4EE6-99CB-452465941B10}" type="pres">
      <dgm:prSet presAssocID="{930720CD-072F-4DEA-AED2-E8EA6CEB0B46}" presName="composite4" presStyleCnt="0"/>
      <dgm:spPr/>
    </dgm:pt>
    <dgm:pt modelId="{7380D38D-EDC3-4B3C-8496-B444B2B782D3}" type="pres">
      <dgm:prSet presAssocID="{930720CD-072F-4DEA-AED2-E8EA6CEB0B46}" presName="background4" presStyleLbl="node4" presStyleIdx="0" presStyleCnt="12"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</dgm:pt>
    <dgm:pt modelId="{52D058CF-23E0-4170-85BD-794F8B908DBC}" type="pres">
      <dgm:prSet presAssocID="{930720CD-072F-4DEA-AED2-E8EA6CEB0B46}" presName="text4" presStyleLbl="fgAcc4" presStyleIdx="0" presStyleCnt="12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7AA89F80-DB34-4671-A873-435577660511}" type="pres">
      <dgm:prSet presAssocID="{930720CD-072F-4DEA-AED2-E8EA6CEB0B46}" presName="hierChild5" presStyleCnt="0"/>
      <dgm:spPr/>
    </dgm:pt>
    <dgm:pt modelId="{8DCF3E0D-EDCC-4246-B500-CBA6C0293F45}" type="pres">
      <dgm:prSet presAssocID="{5090B564-B98E-4A91-871A-6AC1F9D07EDC}" presName="Name23" presStyleLbl="parChTrans1D4" presStyleIdx="1" presStyleCnt="12"/>
      <dgm:spPr/>
    </dgm:pt>
    <dgm:pt modelId="{8909BF53-F4D5-48B0-9C25-3DE3E4CCF1A1}" type="pres">
      <dgm:prSet presAssocID="{AEE26733-4C36-48CC-8607-9B1FDB74E85C}" presName="hierRoot4" presStyleCnt="0"/>
      <dgm:spPr/>
    </dgm:pt>
    <dgm:pt modelId="{38CD6E5D-CCB1-4BF8-B779-2A55C8329BE7}" type="pres">
      <dgm:prSet presAssocID="{AEE26733-4C36-48CC-8607-9B1FDB74E85C}" presName="composite4" presStyleCnt="0"/>
      <dgm:spPr/>
    </dgm:pt>
    <dgm:pt modelId="{BDE80D1C-FF7C-4B6A-860E-317787A645EA}" type="pres">
      <dgm:prSet presAssocID="{AEE26733-4C36-48CC-8607-9B1FDB74E85C}" presName="background4" presStyleLbl="node4" presStyleIdx="1" presStyleCnt="12"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</dgm:pt>
    <dgm:pt modelId="{8F9CB4A8-6BB4-4568-B5FA-93236D5DC3C2}" type="pres">
      <dgm:prSet presAssocID="{AEE26733-4C36-48CC-8607-9B1FDB74E85C}" presName="text4" presStyleLbl="fgAcc4" presStyleIdx="1" presStyleCnt="12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527DAA8A-4607-45F5-8F48-D807E3530F55}" type="pres">
      <dgm:prSet presAssocID="{AEE26733-4C36-48CC-8607-9B1FDB74E85C}" presName="hierChild5" presStyleCnt="0"/>
      <dgm:spPr/>
    </dgm:pt>
    <dgm:pt modelId="{224C7AFB-EFC6-4969-A7C0-594DF5C1F756}" type="pres">
      <dgm:prSet presAssocID="{A89F964B-AE4D-441A-88D7-19FFD554E876}" presName="Name23" presStyleLbl="parChTrans1D4" presStyleIdx="2" presStyleCnt="12"/>
      <dgm:spPr/>
    </dgm:pt>
    <dgm:pt modelId="{65801E3D-78D8-494E-A1C3-1A1E16B60A9F}" type="pres">
      <dgm:prSet presAssocID="{68AB00C8-16B6-41E6-B8A5-389DF5736300}" presName="hierRoot4" presStyleCnt="0"/>
      <dgm:spPr/>
    </dgm:pt>
    <dgm:pt modelId="{6D67E7C1-9873-40F9-A284-07291DD9AF56}" type="pres">
      <dgm:prSet presAssocID="{68AB00C8-16B6-41E6-B8A5-389DF5736300}" presName="composite4" presStyleCnt="0"/>
      <dgm:spPr/>
    </dgm:pt>
    <dgm:pt modelId="{7C0C4BDE-CCDA-42F6-9D3C-32057049B235}" type="pres">
      <dgm:prSet presAssocID="{68AB00C8-16B6-41E6-B8A5-389DF5736300}" presName="background4" presStyleLbl="node4" presStyleIdx="2" presStyleCnt="12"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</dgm:pt>
    <dgm:pt modelId="{0B370476-F647-48C4-92F7-EFAD0F281B39}" type="pres">
      <dgm:prSet presAssocID="{68AB00C8-16B6-41E6-B8A5-389DF5736300}" presName="text4" presStyleLbl="fgAcc4" presStyleIdx="2" presStyleCnt="12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D34E2F35-87B2-453D-9343-92061744D269}" type="pres">
      <dgm:prSet presAssocID="{68AB00C8-16B6-41E6-B8A5-389DF5736300}" presName="hierChild5" presStyleCnt="0"/>
      <dgm:spPr/>
    </dgm:pt>
    <dgm:pt modelId="{62C5452C-9150-47E4-A9D0-D8F29A94BF1C}" type="pres">
      <dgm:prSet presAssocID="{B68C1DA2-BC92-4706-919D-B1E3C6FCEF47}" presName="Name17" presStyleLbl="parChTrans1D3" presStyleIdx="1" presStyleCnt="4"/>
      <dgm:spPr/>
    </dgm:pt>
    <dgm:pt modelId="{54B96B94-87DE-4AFB-BC17-35B690B75906}" type="pres">
      <dgm:prSet presAssocID="{DFCF81B1-7BF0-4982-9527-6D7378767CE5}" presName="hierRoot3" presStyleCnt="0"/>
      <dgm:spPr/>
    </dgm:pt>
    <dgm:pt modelId="{57B318EA-689F-46CA-9C34-2669AF592027}" type="pres">
      <dgm:prSet presAssocID="{DFCF81B1-7BF0-4982-9527-6D7378767CE5}" presName="composite3" presStyleCnt="0"/>
      <dgm:spPr/>
    </dgm:pt>
    <dgm:pt modelId="{728A4A9E-147B-4685-8298-B02A1D7F35E7}" type="pres">
      <dgm:prSet presAssocID="{DFCF81B1-7BF0-4982-9527-6D7378767CE5}" presName="background3" presStyleLbl="node3" presStyleIdx="1" presStyleCnt="4"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</dgm:pt>
    <dgm:pt modelId="{FEDF974C-2D37-48B2-8380-3C7A241028C8}" type="pres">
      <dgm:prSet presAssocID="{DFCF81B1-7BF0-4982-9527-6D7378767CE5}" presName="text3" presStyleLbl="fgAcc3" presStyleIdx="1" presStyleCnt="4" custScaleX="158405">
        <dgm:presLayoutVars>
          <dgm:chPref val="3"/>
        </dgm:presLayoutVars>
      </dgm:prSet>
      <dgm:spPr/>
    </dgm:pt>
    <dgm:pt modelId="{EE2F683B-BFE7-4A17-88FF-8F4BDA1428A3}" type="pres">
      <dgm:prSet presAssocID="{DFCF81B1-7BF0-4982-9527-6D7378767CE5}" presName="hierChild4" presStyleCnt="0"/>
      <dgm:spPr/>
    </dgm:pt>
    <dgm:pt modelId="{5E7E06BD-DE2E-40D3-8FF0-FC211521CD4F}" type="pres">
      <dgm:prSet presAssocID="{DCE52416-E466-47D0-BF34-B1373ADD5F5F}" presName="Name23" presStyleLbl="parChTrans1D4" presStyleIdx="3" presStyleCnt="12"/>
      <dgm:spPr/>
    </dgm:pt>
    <dgm:pt modelId="{5197D112-8018-4BF4-A4D3-56A4A7DA0A40}" type="pres">
      <dgm:prSet presAssocID="{5B6A839D-C3C7-49C0-AD60-55F3773149FD}" presName="hierRoot4" presStyleCnt="0"/>
      <dgm:spPr/>
    </dgm:pt>
    <dgm:pt modelId="{AC1464DD-A543-4CE5-A13B-BDF087C7C198}" type="pres">
      <dgm:prSet presAssocID="{5B6A839D-C3C7-49C0-AD60-55F3773149FD}" presName="composite4" presStyleCnt="0"/>
      <dgm:spPr/>
    </dgm:pt>
    <dgm:pt modelId="{87F3E96A-9184-487D-A9E8-C7ECE40AE56F}" type="pres">
      <dgm:prSet presAssocID="{5B6A839D-C3C7-49C0-AD60-55F3773149FD}" presName="background4" presStyleLbl="node4" presStyleIdx="3" presStyleCnt="12"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</dgm:pt>
    <dgm:pt modelId="{1E113764-AC88-46F8-8C69-71913DC3F1AC}" type="pres">
      <dgm:prSet presAssocID="{5B6A839D-C3C7-49C0-AD60-55F3773149FD}" presName="text4" presStyleLbl="fgAcc4" presStyleIdx="3" presStyleCnt="12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91D0C354-1247-4745-AB19-03E4A62E2AC8}" type="pres">
      <dgm:prSet presAssocID="{5B6A839D-C3C7-49C0-AD60-55F3773149FD}" presName="hierChild5" presStyleCnt="0"/>
      <dgm:spPr/>
    </dgm:pt>
    <dgm:pt modelId="{89289DB7-0E13-4434-BB61-4276BB77D10B}" type="pres">
      <dgm:prSet presAssocID="{620BB554-384C-477E-B06B-FBA72951148F}" presName="Name23" presStyleLbl="parChTrans1D4" presStyleIdx="4" presStyleCnt="12"/>
      <dgm:spPr/>
    </dgm:pt>
    <dgm:pt modelId="{2C1C0872-3BF6-4EC0-A0D1-E1C6D5C7BC28}" type="pres">
      <dgm:prSet presAssocID="{FE644E46-A0D2-4C2C-B20E-E8C0D946744D}" presName="hierRoot4" presStyleCnt="0"/>
      <dgm:spPr/>
    </dgm:pt>
    <dgm:pt modelId="{592EC76B-98DD-49B1-AABC-4E2E434850DC}" type="pres">
      <dgm:prSet presAssocID="{FE644E46-A0D2-4C2C-B20E-E8C0D946744D}" presName="composite4" presStyleCnt="0"/>
      <dgm:spPr/>
    </dgm:pt>
    <dgm:pt modelId="{78353A0F-6FE0-4847-A281-52CC821EE4B6}" type="pres">
      <dgm:prSet presAssocID="{FE644E46-A0D2-4C2C-B20E-E8C0D946744D}" presName="background4" presStyleLbl="node4" presStyleIdx="4" presStyleCnt="12"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</dgm:pt>
    <dgm:pt modelId="{F5E0BE3A-20F2-46FD-87E9-3EFF6A3D06DA}" type="pres">
      <dgm:prSet presAssocID="{FE644E46-A0D2-4C2C-B20E-E8C0D946744D}" presName="text4" presStyleLbl="fgAcc4" presStyleIdx="4" presStyleCnt="12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982BD893-7E09-4B71-BA36-471AEF05B5E2}" type="pres">
      <dgm:prSet presAssocID="{FE644E46-A0D2-4C2C-B20E-E8C0D946744D}" presName="hierChild5" presStyleCnt="0"/>
      <dgm:spPr/>
    </dgm:pt>
    <dgm:pt modelId="{A12B5581-E817-4595-9EC3-F125D651CF57}" type="pres">
      <dgm:prSet presAssocID="{3D69239F-55A9-4322-AB85-3ABCEA8D90DD}" presName="Name23" presStyleLbl="parChTrans1D4" presStyleIdx="5" presStyleCnt="12"/>
      <dgm:spPr/>
    </dgm:pt>
    <dgm:pt modelId="{F52376A7-5D47-4546-99FE-02C7B1457247}" type="pres">
      <dgm:prSet presAssocID="{E54523CE-5A26-49D4-92ED-8129E085E1E3}" presName="hierRoot4" presStyleCnt="0"/>
      <dgm:spPr/>
    </dgm:pt>
    <dgm:pt modelId="{B6531A0C-0B26-46F7-838C-41324A8800C2}" type="pres">
      <dgm:prSet presAssocID="{E54523CE-5A26-49D4-92ED-8129E085E1E3}" presName="composite4" presStyleCnt="0"/>
      <dgm:spPr/>
    </dgm:pt>
    <dgm:pt modelId="{8D345DFC-9463-412A-9124-127DCD7D9959}" type="pres">
      <dgm:prSet presAssocID="{E54523CE-5A26-49D4-92ED-8129E085E1E3}" presName="background4" presStyleLbl="node4" presStyleIdx="5" presStyleCnt="12"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</dgm:pt>
    <dgm:pt modelId="{F42F99AC-F994-4ECA-A1A2-88DDB335B4F0}" type="pres">
      <dgm:prSet presAssocID="{E54523CE-5A26-49D4-92ED-8129E085E1E3}" presName="text4" presStyleLbl="fgAcc4" presStyleIdx="5" presStyleCnt="12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B47684E5-9700-46FB-BC60-CEF98AAED46E}" type="pres">
      <dgm:prSet presAssocID="{E54523CE-5A26-49D4-92ED-8129E085E1E3}" presName="hierChild5" presStyleCnt="0"/>
      <dgm:spPr/>
    </dgm:pt>
    <dgm:pt modelId="{6B7E7703-4CBD-4EF0-92DF-960E1C376C3D}" type="pres">
      <dgm:prSet presAssocID="{C8346F43-EBC3-4009-85E3-DB4742C30E9A}" presName="Name10" presStyleLbl="parChTrans1D2" presStyleIdx="1" presStyleCnt="2"/>
      <dgm:spPr/>
    </dgm:pt>
    <dgm:pt modelId="{57139C8D-3269-4839-9E55-6F9B018DC12B}" type="pres">
      <dgm:prSet presAssocID="{39F5AD40-E28B-41AA-9A1E-F07F29E2C5E0}" presName="hierRoot2" presStyleCnt="0"/>
      <dgm:spPr/>
    </dgm:pt>
    <dgm:pt modelId="{A2FF242A-F616-4311-9E14-80BE6A977774}" type="pres">
      <dgm:prSet presAssocID="{39F5AD40-E28B-41AA-9A1E-F07F29E2C5E0}" presName="composite2" presStyleCnt="0"/>
      <dgm:spPr/>
    </dgm:pt>
    <dgm:pt modelId="{B0D02396-8B89-45C2-8AC2-36F3D63187CD}" type="pres">
      <dgm:prSet presAssocID="{39F5AD40-E28B-41AA-9A1E-F07F29E2C5E0}" presName="background2" presStyleLbl="node2" presStyleIdx="1" presStyleCnt="2"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</dgm:pt>
    <dgm:pt modelId="{14E36AB6-049D-4632-BB1C-F9F633A2FC42}" type="pres">
      <dgm:prSet presAssocID="{39F5AD40-E28B-41AA-9A1E-F07F29E2C5E0}" presName="text2" presStyleLbl="fgAcc2" presStyleIdx="1" presStyleCnt="2" custScaleX="191066">
        <dgm:presLayoutVars>
          <dgm:chPref val="3"/>
        </dgm:presLayoutVars>
      </dgm:prSet>
      <dgm:spPr/>
    </dgm:pt>
    <dgm:pt modelId="{0D7264D4-D04F-4DC1-B3E8-354462CFC5F7}" type="pres">
      <dgm:prSet presAssocID="{39F5AD40-E28B-41AA-9A1E-F07F29E2C5E0}" presName="hierChild3" presStyleCnt="0"/>
      <dgm:spPr/>
    </dgm:pt>
    <dgm:pt modelId="{5035B9DA-AD92-4068-9FA2-E074456674CE}" type="pres">
      <dgm:prSet presAssocID="{3C45595A-910B-49C7-9896-FB27B7D522D8}" presName="Name17" presStyleLbl="parChTrans1D3" presStyleIdx="2" presStyleCnt="4"/>
      <dgm:spPr/>
    </dgm:pt>
    <dgm:pt modelId="{2D211F3F-8B4A-4BAF-B73A-AB5A8D25F3AE}" type="pres">
      <dgm:prSet presAssocID="{B93C0E96-0C44-4DA7-8EF5-7E08452A9D19}" presName="hierRoot3" presStyleCnt="0"/>
      <dgm:spPr/>
    </dgm:pt>
    <dgm:pt modelId="{DAF1ABEB-A6F6-46DF-9F03-7B35A13D0F06}" type="pres">
      <dgm:prSet presAssocID="{B93C0E96-0C44-4DA7-8EF5-7E08452A9D19}" presName="composite3" presStyleCnt="0"/>
      <dgm:spPr/>
    </dgm:pt>
    <dgm:pt modelId="{3B0F15E5-BC52-4328-95A4-A69A94BBA697}" type="pres">
      <dgm:prSet presAssocID="{B93C0E96-0C44-4DA7-8EF5-7E08452A9D19}" presName="background3" presStyleLbl="node3" presStyleIdx="2" presStyleCnt="4"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</dgm:pt>
    <dgm:pt modelId="{C5BC661E-CF8F-49BE-ADB4-818ACAE05F51}" type="pres">
      <dgm:prSet presAssocID="{B93C0E96-0C44-4DA7-8EF5-7E08452A9D19}" presName="text3" presStyleLbl="fgAcc3" presStyleIdx="2" presStyleCnt="4" custScaleX="142539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62E70D2F-137A-4120-8465-DD92DAF7CBA2}" type="pres">
      <dgm:prSet presAssocID="{B93C0E96-0C44-4DA7-8EF5-7E08452A9D19}" presName="hierChild4" presStyleCnt="0"/>
      <dgm:spPr/>
    </dgm:pt>
    <dgm:pt modelId="{514934A7-0531-406F-8444-2D12F94C5393}" type="pres">
      <dgm:prSet presAssocID="{5C94FED2-C0F0-4167-BEB5-5D8AF949FE21}" presName="Name23" presStyleLbl="parChTrans1D4" presStyleIdx="6" presStyleCnt="12"/>
      <dgm:spPr/>
    </dgm:pt>
    <dgm:pt modelId="{975D4C49-0A5E-4301-9936-8B573B14A6F7}" type="pres">
      <dgm:prSet presAssocID="{617F4A82-4DC0-4566-B181-D5EC1A14D7FB}" presName="hierRoot4" presStyleCnt="0"/>
      <dgm:spPr/>
    </dgm:pt>
    <dgm:pt modelId="{AC2EA95D-3438-4CB0-9B54-00B6F52396BE}" type="pres">
      <dgm:prSet presAssocID="{617F4A82-4DC0-4566-B181-D5EC1A14D7FB}" presName="composite4" presStyleCnt="0"/>
      <dgm:spPr/>
    </dgm:pt>
    <dgm:pt modelId="{D7E8AD84-9A55-412F-959B-0B9AE1301B6D}" type="pres">
      <dgm:prSet presAssocID="{617F4A82-4DC0-4566-B181-D5EC1A14D7FB}" presName="background4" presStyleLbl="node4" presStyleIdx="6" presStyleCnt="12"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</dgm:pt>
    <dgm:pt modelId="{0E551DDB-8AE4-4A24-B7CB-F16BE43C6E88}" type="pres">
      <dgm:prSet presAssocID="{617F4A82-4DC0-4566-B181-D5EC1A14D7FB}" presName="text4" presStyleLbl="fgAcc4" presStyleIdx="6" presStyleCnt="12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B7E22775-4DE0-421A-99D1-67A66D20F8CF}" type="pres">
      <dgm:prSet presAssocID="{617F4A82-4DC0-4566-B181-D5EC1A14D7FB}" presName="hierChild5" presStyleCnt="0"/>
      <dgm:spPr/>
    </dgm:pt>
    <dgm:pt modelId="{381B9CD4-1D79-49CF-9253-8E82403AB37C}" type="pres">
      <dgm:prSet presAssocID="{C0F9CD2B-3E98-4EB7-BE59-8AEDDED0EC18}" presName="Name23" presStyleLbl="parChTrans1D4" presStyleIdx="7" presStyleCnt="12"/>
      <dgm:spPr/>
    </dgm:pt>
    <dgm:pt modelId="{0299E928-B631-4171-A008-643B8DECC8E3}" type="pres">
      <dgm:prSet presAssocID="{06F59819-EC31-443F-A17F-793138EA1CE3}" presName="hierRoot4" presStyleCnt="0"/>
      <dgm:spPr/>
    </dgm:pt>
    <dgm:pt modelId="{9954B51F-5ADE-4AD6-97FB-D3FF46B7FFE1}" type="pres">
      <dgm:prSet presAssocID="{06F59819-EC31-443F-A17F-793138EA1CE3}" presName="composite4" presStyleCnt="0"/>
      <dgm:spPr/>
    </dgm:pt>
    <dgm:pt modelId="{84C848DC-742D-4281-8FBA-7D2E6EEACB49}" type="pres">
      <dgm:prSet presAssocID="{06F59819-EC31-443F-A17F-793138EA1CE3}" presName="background4" presStyleLbl="node4" presStyleIdx="7" presStyleCnt="12"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</dgm:pt>
    <dgm:pt modelId="{004916B4-CFB9-45D9-A110-8E508FA98D6E}" type="pres">
      <dgm:prSet presAssocID="{06F59819-EC31-443F-A17F-793138EA1CE3}" presName="text4" presStyleLbl="fgAcc4" presStyleIdx="7" presStyleCnt="12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B9B00D75-9C84-41EB-AE94-7FAA992590F4}" type="pres">
      <dgm:prSet presAssocID="{06F59819-EC31-443F-A17F-793138EA1CE3}" presName="hierChild5" presStyleCnt="0"/>
      <dgm:spPr/>
    </dgm:pt>
    <dgm:pt modelId="{0EA5458F-EC01-42C8-A919-83F455905C5D}" type="pres">
      <dgm:prSet presAssocID="{01D7A416-958E-48CB-AA04-B4A4E9657AA8}" presName="Name23" presStyleLbl="parChTrans1D4" presStyleIdx="8" presStyleCnt="12"/>
      <dgm:spPr/>
    </dgm:pt>
    <dgm:pt modelId="{34BA7749-67EA-423F-8D74-AA1F2719BBD3}" type="pres">
      <dgm:prSet presAssocID="{0FBA54FB-0EE5-405C-9DA9-FDC9664C2367}" presName="hierRoot4" presStyleCnt="0"/>
      <dgm:spPr/>
    </dgm:pt>
    <dgm:pt modelId="{B74E2249-6DD0-439C-8476-0E939F7100A1}" type="pres">
      <dgm:prSet presAssocID="{0FBA54FB-0EE5-405C-9DA9-FDC9664C2367}" presName="composite4" presStyleCnt="0"/>
      <dgm:spPr/>
    </dgm:pt>
    <dgm:pt modelId="{DD37CAD5-583C-4E88-BBFF-AB7E89C63E39}" type="pres">
      <dgm:prSet presAssocID="{0FBA54FB-0EE5-405C-9DA9-FDC9664C2367}" presName="background4" presStyleLbl="node4" presStyleIdx="8" presStyleCnt="12"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</dgm:pt>
    <dgm:pt modelId="{BD8E69F2-63AE-4532-855E-10C863ACFAC9}" type="pres">
      <dgm:prSet presAssocID="{0FBA54FB-0EE5-405C-9DA9-FDC9664C2367}" presName="text4" presStyleLbl="fgAcc4" presStyleIdx="8" presStyleCnt="12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1276F47B-CE0A-43D6-8239-D088C74EDF57}" type="pres">
      <dgm:prSet presAssocID="{0FBA54FB-0EE5-405C-9DA9-FDC9664C2367}" presName="hierChild5" presStyleCnt="0"/>
      <dgm:spPr/>
    </dgm:pt>
    <dgm:pt modelId="{8A0152D2-DA54-4DBB-8107-22485DFBED20}" type="pres">
      <dgm:prSet presAssocID="{E506F75C-EE25-433C-BAF2-83523763F7C4}" presName="Name17" presStyleLbl="parChTrans1D3" presStyleIdx="3" presStyleCnt="4"/>
      <dgm:spPr/>
    </dgm:pt>
    <dgm:pt modelId="{4F75829C-29D7-4553-B850-47FBC5131D3E}" type="pres">
      <dgm:prSet presAssocID="{8897EDD5-7504-40C6-A4CD-6909F5C91B88}" presName="hierRoot3" presStyleCnt="0"/>
      <dgm:spPr/>
    </dgm:pt>
    <dgm:pt modelId="{7D77C575-4A99-4F6E-9334-A5D1918135D9}" type="pres">
      <dgm:prSet presAssocID="{8897EDD5-7504-40C6-A4CD-6909F5C91B88}" presName="composite3" presStyleCnt="0"/>
      <dgm:spPr/>
    </dgm:pt>
    <dgm:pt modelId="{64832586-715F-4AC3-B3F7-8A64339DD70D}" type="pres">
      <dgm:prSet presAssocID="{8897EDD5-7504-40C6-A4CD-6909F5C91B88}" presName="background3" presStyleLbl="node3" presStyleIdx="3" presStyleCnt="4"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</dgm:pt>
    <dgm:pt modelId="{22380030-06A3-413E-BE9B-63E74E763B1B}" type="pres">
      <dgm:prSet presAssocID="{8897EDD5-7504-40C6-A4CD-6909F5C91B88}" presName="text3" presStyleLbl="fgAcc3" presStyleIdx="3" presStyleCnt="4" custScaleX="145062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EC726021-1599-44DB-A7BD-DABFEB445716}" type="pres">
      <dgm:prSet presAssocID="{8897EDD5-7504-40C6-A4CD-6909F5C91B88}" presName="hierChild4" presStyleCnt="0"/>
      <dgm:spPr/>
    </dgm:pt>
    <dgm:pt modelId="{2CA1E815-1B54-418A-AA5F-C2F89903A4A4}" type="pres">
      <dgm:prSet presAssocID="{3F9F0D71-0D4B-4B85-AAEB-0137C402AA2F}" presName="Name23" presStyleLbl="parChTrans1D4" presStyleIdx="9" presStyleCnt="12"/>
      <dgm:spPr/>
    </dgm:pt>
    <dgm:pt modelId="{DE29564C-9C0E-4D98-8B47-F2D244E38788}" type="pres">
      <dgm:prSet presAssocID="{B7B309C5-64A5-46E3-9620-C0A0B246341A}" presName="hierRoot4" presStyleCnt="0"/>
      <dgm:spPr/>
    </dgm:pt>
    <dgm:pt modelId="{EFE6174F-BEBF-47F2-B652-47F22A9C9FBD}" type="pres">
      <dgm:prSet presAssocID="{B7B309C5-64A5-46E3-9620-C0A0B246341A}" presName="composite4" presStyleCnt="0"/>
      <dgm:spPr/>
    </dgm:pt>
    <dgm:pt modelId="{647246EF-7206-4029-A4D2-D57775829928}" type="pres">
      <dgm:prSet presAssocID="{B7B309C5-64A5-46E3-9620-C0A0B246341A}" presName="background4" presStyleLbl="node4" presStyleIdx="9" presStyleCnt="12"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</dgm:pt>
    <dgm:pt modelId="{20BCFE9A-C10D-49DB-8521-E8ACB9409F65}" type="pres">
      <dgm:prSet presAssocID="{B7B309C5-64A5-46E3-9620-C0A0B246341A}" presName="text4" presStyleLbl="fgAcc4" presStyleIdx="9" presStyleCnt="12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6F1AEC0E-E7D1-4384-803F-0716FF4A58AD}" type="pres">
      <dgm:prSet presAssocID="{B7B309C5-64A5-46E3-9620-C0A0B246341A}" presName="hierChild5" presStyleCnt="0"/>
      <dgm:spPr/>
    </dgm:pt>
    <dgm:pt modelId="{5D2FC06B-85C4-4578-8CD9-0BCDF54D2D73}" type="pres">
      <dgm:prSet presAssocID="{AAB879FB-B431-425F-9F64-6AC0D9C7100D}" presName="Name23" presStyleLbl="parChTrans1D4" presStyleIdx="10" presStyleCnt="12"/>
      <dgm:spPr/>
    </dgm:pt>
    <dgm:pt modelId="{4393AB7A-3150-451B-9C72-C6A574B22DDD}" type="pres">
      <dgm:prSet presAssocID="{C87AFAC8-39A0-48CE-8522-4086E06F865D}" presName="hierRoot4" presStyleCnt="0"/>
      <dgm:spPr/>
    </dgm:pt>
    <dgm:pt modelId="{6138E41B-0E92-4880-93B4-DB0F6DF43214}" type="pres">
      <dgm:prSet presAssocID="{C87AFAC8-39A0-48CE-8522-4086E06F865D}" presName="composite4" presStyleCnt="0"/>
      <dgm:spPr/>
    </dgm:pt>
    <dgm:pt modelId="{10496025-7742-4987-80BB-AD3BA5F5AD31}" type="pres">
      <dgm:prSet presAssocID="{C87AFAC8-39A0-48CE-8522-4086E06F865D}" presName="background4" presStyleLbl="node4" presStyleIdx="10" presStyleCnt="12"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</dgm:pt>
    <dgm:pt modelId="{61D15AC1-C4BA-486B-A371-6B8A05681208}" type="pres">
      <dgm:prSet presAssocID="{C87AFAC8-39A0-48CE-8522-4086E06F865D}" presName="text4" presStyleLbl="fgAcc4" presStyleIdx="10" presStyleCnt="12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89688DC5-6313-48B4-B933-7A6A3DC08DCA}" type="pres">
      <dgm:prSet presAssocID="{C87AFAC8-39A0-48CE-8522-4086E06F865D}" presName="hierChild5" presStyleCnt="0"/>
      <dgm:spPr/>
    </dgm:pt>
    <dgm:pt modelId="{2208B9B7-B32A-41EA-AD76-C255F94111E1}" type="pres">
      <dgm:prSet presAssocID="{0DF04010-629C-4F5A-8855-29BACB84498A}" presName="Name23" presStyleLbl="parChTrans1D4" presStyleIdx="11" presStyleCnt="12"/>
      <dgm:spPr/>
    </dgm:pt>
    <dgm:pt modelId="{6554EE1B-1DAF-4524-B3EF-0488BC0B60C4}" type="pres">
      <dgm:prSet presAssocID="{A0E098DB-BB34-4B42-ABD1-9C75ED506DEC}" presName="hierRoot4" presStyleCnt="0"/>
      <dgm:spPr/>
    </dgm:pt>
    <dgm:pt modelId="{AF2435EB-9CA0-4843-AC45-F84B1DA95D53}" type="pres">
      <dgm:prSet presAssocID="{A0E098DB-BB34-4B42-ABD1-9C75ED506DEC}" presName="composite4" presStyleCnt="0"/>
      <dgm:spPr/>
    </dgm:pt>
    <dgm:pt modelId="{10E1FA96-19F5-440B-A4E0-AF0DC38FB8D1}" type="pres">
      <dgm:prSet presAssocID="{A0E098DB-BB34-4B42-ABD1-9C75ED506DEC}" presName="background4" presStyleLbl="node4" presStyleIdx="11" presStyleCnt="12">
        <dgm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dgm:style>
      </dgm:prSet>
      <dgm:spPr/>
    </dgm:pt>
    <dgm:pt modelId="{B2D96498-F065-49BE-95C9-80EB16D43058}" type="pres">
      <dgm:prSet presAssocID="{A0E098DB-BB34-4B42-ABD1-9C75ED506DEC}" presName="text4" presStyleLbl="fgAcc4" presStyleIdx="11" presStyleCnt="12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F01EE8ED-ECED-467D-A0CD-A9C732AF7872}" type="pres">
      <dgm:prSet presAssocID="{A0E098DB-BB34-4B42-ABD1-9C75ED506DEC}" presName="hierChild5" presStyleCnt="0"/>
      <dgm:spPr/>
    </dgm:pt>
  </dgm:ptLst>
  <dgm:cxnLst>
    <dgm:cxn modelId="{0D87A9AE-DA72-49E3-9C25-3969D13AD398}" type="presOf" srcId="{A89F964B-AE4D-441A-88D7-19FFD554E876}" destId="{224C7AFB-EFC6-4969-A7C0-594DF5C1F756}" srcOrd="0" destOrd="0" presId="urn:microsoft.com/office/officeart/2005/8/layout/hierarchy1"/>
    <dgm:cxn modelId="{3CDF5B5E-001F-4AB1-A9E3-FC8CD2EB216C}" srcId="{DFCF81B1-7BF0-4982-9527-6D7378767CE5}" destId="{E54523CE-5A26-49D4-92ED-8129E085E1E3}" srcOrd="2" destOrd="0" parTransId="{3D69239F-55A9-4322-AB85-3ABCEA8D90DD}" sibTransId="{B5E2EDC1-F1E0-487F-B001-7B9C0A02AE92}"/>
    <dgm:cxn modelId="{1A3833EB-6505-46AB-B6D9-D26ECAB98B87}" type="presOf" srcId="{E54523CE-5A26-49D4-92ED-8129E085E1E3}" destId="{F42F99AC-F994-4ECA-A1A2-88DDB335B4F0}" srcOrd="0" destOrd="0" presId="urn:microsoft.com/office/officeart/2005/8/layout/hierarchy1"/>
    <dgm:cxn modelId="{25E55E32-201C-48D6-9192-6A7BFC2925A2}" type="presOf" srcId="{620BB554-384C-477E-B06B-FBA72951148F}" destId="{89289DB7-0E13-4434-BB61-4276BB77D10B}" srcOrd="0" destOrd="0" presId="urn:microsoft.com/office/officeart/2005/8/layout/hierarchy1"/>
    <dgm:cxn modelId="{82F4A701-6DAA-486E-9AA8-D1CBC2B70C62}" srcId="{DFCF81B1-7BF0-4982-9527-6D7378767CE5}" destId="{5B6A839D-C3C7-49C0-AD60-55F3773149FD}" srcOrd="0" destOrd="0" parTransId="{DCE52416-E466-47D0-BF34-B1373ADD5F5F}" sibTransId="{9CF261A2-D173-4955-950A-16E24AAEC61C}"/>
    <dgm:cxn modelId="{9F7BF6B0-48D9-467B-94DA-054F3F863A50}" type="presOf" srcId="{1A34E547-DDC2-4563-ACB2-3E924F9BFEA8}" destId="{DA4503CF-7324-420D-949A-A9ADB4B56557}" srcOrd="0" destOrd="0" presId="urn:microsoft.com/office/officeart/2005/8/layout/hierarchy1"/>
    <dgm:cxn modelId="{79051285-F6F8-4C1B-B7EC-EF594802A20D}" type="presOf" srcId="{B93C0E96-0C44-4DA7-8EF5-7E08452A9D19}" destId="{C5BC661E-CF8F-49BE-ADB4-818ACAE05F51}" srcOrd="0" destOrd="0" presId="urn:microsoft.com/office/officeart/2005/8/layout/hierarchy1"/>
    <dgm:cxn modelId="{6ADA9C4C-B207-4833-8716-2C619EEF1E00}" srcId="{8897EDD5-7504-40C6-A4CD-6909F5C91B88}" destId="{A0E098DB-BB34-4B42-ABD1-9C75ED506DEC}" srcOrd="2" destOrd="0" parTransId="{0DF04010-629C-4F5A-8855-29BACB84498A}" sibTransId="{E5845F04-B8D4-4F70-A90E-C20A68524CD3}"/>
    <dgm:cxn modelId="{BA657DF5-753F-426B-B980-1A26227C8199}" type="presOf" srcId="{DFCF81B1-7BF0-4982-9527-6D7378767CE5}" destId="{FEDF974C-2D37-48B2-8380-3C7A241028C8}" srcOrd="0" destOrd="0" presId="urn:microsoft.com/office/officeart/2005/8/layout/hierarchy1"/>
    <dgm:cxn modelId="{AC5F36E9-7347-4F5A-B592-F80985197AA2}" type="presOf" srcId="{A0E098DB-BB34-4B42-ABD1-9C75ED506DEC}" destId="{B2D96498-F065-49BE-95C9-80EB16D43058}" srcOrd="0" destOrd="0" presId="urn:microsoft.com/office/officeart/2005/8/layout/hierarchy1"/>
    <dgm:cxn modelId="{991F8771-8149-4D6A-9F3B-816BD285E895}" srcId="{B93C0E96-0C44-4DA7-8EF5-7E08452A9D19}" destId="{0FBA54FB-0EE5-405C-9DA9-FDC9664C2367}" srcOrd="2" destOrd="0" parTransId="{01D7A416-958E-48CB-AA04-B4A4E9657AA8}" sibTransId="{76145424-CC2E-4C9C-B6BF-E371805219D0}"/>
    <dgm:cxn modelId="{F52496C0-AD3D-446E-90E1-CC34984D3CCD}" srcId="{1A34E547-DDC2-4563-ACB2-3E924F9BFEA8}" destId="{DFCF81B1-7BF0-4982-9527-6D7378767CE5}" srcOrd="1" destOrd="0" parTransId="{B68C1DA2-BC92-4706-919D-B1E3C6FCEF47}" sibTransId="{0544A411-3AD8-45F2-BEE6-AB7EE2310B9F}"/>
    <dgm:cxn modelId="{67DEB04F-C181-435E-9FF6-5FADA277D812}" srcId="{B93C0E96-0C44-4DA7-8EF5-7E08452A9D19}" destId="{617F4A82-4DC0-4566-B181-D5EC1A14D7FB}" srcOrd="0" destOrd="0" parTransId="{5C94FED2-C0F0-4167-BEB5-5D8AF949FE21}" sibTransId="{20F95872-CC8D-48DD-A4F1-FB67380E54C6}"/>
    <dgm:cxn modelId="{75EEA75E-2110-4653-963D-9AA2E8D99B8D}" srcId="{323FCB35-71DE-4B41-A68A-9AFE76410811}" destId="{1A34E547-DDC2-4563-ACB2-3E924F9BFEA8}" srcOrd="0" destOrd="0" parTransId="{5E504991-298D-40D2-A77C-63634331796F}" sibTransId="{92BB240C-3E70-4C74-B761-CC412E4FF58F}"/>
    <dgm:cxn modelId="{EAA99D04-E60B-49AB-A2CB-EB2057732F04}" srcId="{8897EDD5-7504-40C6-A4CD-6909F5C91B88}" destId="{C87AFAC8-39A0-48CE-8522-4086E06F865D}" srcOrd="1" destOrd="0" parTransId="{AAB879FB-B431-425F-9F64-6AC0D9C7100D}" sibTransId="{F2B9D162-B7D2-4A93-ACBA-CAF6D21F599A}"/>
    <dgm:cxn modelId="{31E3CDC6-87D1-42FE-BAB6-320E1727644D}" type="presOf" srcId="{5B6A839D-C3C7-49C0-AD60-55F3773149FD}" destId="{1E113764-AC88-46F8-8C69-71913DC3F1AC}" srcOrd="0" destOrd="0" presId="urn:microsoft.com/office/officeart/2005/8/layout/hierarchy1"/>
    <dgm:cxn modelId="{87579E5E-EE5C-4143-8766-B3FB88CCA0C8}" type="presOf" srcId="{39F5AD40-E28B-41AA-9A1E-F07F29E2C5E0}" destId="{14E36AB6-049D-4632-BB1C-F9F633A2FC42}" srcOrd="0" destOrd="0" presId="urn:microsoft.com/office/officeart/2005/8/layout/hierarchy1"/>
    <dgm:cxn modelId="{9F52FDFD-73EC-4366-8BB3-5E5845CF1E76}" type="presOf" srcId="{FE644E46-A0D2-4C2C-B20E-E8C0D946744D}" destId="{F5E0BE3A-20F2-46FD-87E9-3EFF6A3D06DA}" srcOrd="0" destOrd="0" presId="urn:microsoft.com/office/officeart/2005/8/layout/hierarchy1"/>
    <dgm:cxn modelId="{F2AEA534-2EBB-49E4-9B09-29DCEB0461AA}" type="presOf" srcId="{C8346F43-EBC3-4009-85E3-DB4742C30E9A}" destId="{6B7E7703-4CBD-4EF0-92DF-960E1C376C3D}" srcOrd="0" destOrd="0" presId="urn:microsoft.com/office/officeart/2005/8/layout/hierarchy1"/>
    <dgm:cxn modelId="{30C0E9C2-5AD9-4502-A915-6EF2341FB96A}" type="presOf" srcId="{AAB879FB-B431-425F-9F64-6AC0D9C7100D}" destId="{5D2FC06B-85C4-4578-8CD9-0BCDF54D2D73}" srcOrd="0" destOrd="0" presId="urn:microsoft.com/office/officeart/2005/8/layout/hierarchy1"/>
    <dgm:cxn modelId="{863C3344-073B-4F4F-A626-ACBD577C08C7}" srcId="{39F5AD40-E28B-41AA-9A1E-F07F29E2C5E0}" destId="{8897EDD5-7504-40C6-A4CD-6909F5C91B88}" srcOrd="1" destOrd="0" parTransId="{E506F75C-EE25-433C-BAF2-83523763F7C4}" sibTransId="{4FB3FC4C-ACF9-4315-9899-83FB53F954E1}"/>
    <dgm:cxn modelId="{83FD4E3D-623C-4FDB-A2EE-012034D3F5AD}" type="presOf" srcId="{AF33832F-32CC-40AF-883E-CDFE523B1FA2}" destId="{9DF54347-2A12-4809-AACE-6706A932FCBD}" srcOrd="0" destOrd="0" presId="urn:microsoft.com/office/officeart/2005/8/layout/hierarchy1"/>
    <dgm:cxn modelId="{1D056AB3-77EC-4B58-B2E4-0A049AD5FD16}" type="presOf" srcId="{B68C1DA2-BC92-4706-919D-B1E3C6FCEF47}" destId="{62C5452C-9150-47E4-A9D0-D8F29A94BF1C}" srcOrd="0" destOrd="0" presId="urn:microsoft.com/office/officeart/2005/8/layout/hierarchy1"/>
    <dgm:cxn modelId="{E45D32E2-ADA4-4E58-8265-FD248FC43B2A}" type="presOf" srcId="{617F4A82-4DC0-4566-B181-D5EC1A14D7FB}" destId="{0E551DDB-8AE4-4A24-B7CB-F16BE43C6E88}" srcOrd="0" destOrd="0" presId="urn:microsoft.com/office/officeart/2005/8/layout/hierarchy1"/>
    <dgm:cxn modelId="{9C71913C-C602-40E0-A01B-6A355E3E5CEF}" srcId="{B93C0E96-0C44-4DA7-8EF5-7E08452A9D19}" destId="{06F59819-EC31-443F-A17F-793138EA1CE3}" srcOrd="1" destOrd="0" parTransId="{C0F9CD2B-3E98-4EB7-BE59-8AEDDED0EC18}" sibTransId="{D9EF762C-6211-4C3E-B571-3494A2AF0469}"/>
    <dgm:cxn modelId="{207AB4EC-9EE0-43C7-9EA8-D8182810F292}" type="presOf" srcId="{01D7A416-958E-48CB-AA04-B4A4E9657AA8}" destId="{0EA5458F-EC01-42C8-A919-83F455905C5D}" srcOrd="0" destOrd="0" presId="urn:microsoft.com/office/officeart/2005/8/layout/hierarchy1"/>
    <dgm:cxn modelId="{A7067B5C-C581-4451-A501-6B79E2A463FD}" type="presOf" srcId="{0FBA54FB-0EE5-405C-9DA9-FDC9664C2367}" destId="{BD8E69F2-63AE-4532-855E-10C863ACFAC9}" srcOrd="0" destOrd="0" presId="urn:microsoft.com/office/officeart/2005/8/layout/hierarchy1"/>
    <dgm:cxn modelId="{EC7D07D4-3949-414D-85D1-DF9E44FB3D35}" type="presOf" srcId="{68AB00C8-16B6-41E6-B8A5-389DF5736300}" destId="{0B370476-F647-48C4-92F7-EFAD0F281B39}" srcOrd="0" destOrd="0" presId="urn:microsoft.com/office/officeart/2005/8/layout/hierarchy1"/>
    <dgm:cxn modelId="{101EB219-CD67-48C7-9EDA-5E70F63DB11E}" type="presOf" srcId="{06F59819-EC31-443F-A17F-793138EA1CE3}" destId="{004916B4-CFB9-45D9-A110-8E508FA98D6E}" srcOrd="0" destOrd="0" presId="urn:microsoft.com/office/officeart/2005/8/layout/hierarchy1"/>
    <dgm:cxn modelId="{ADE0ED0E-638E-4F8E-A8E2-D6A959B64912}" type="presOf" srcId="{AEE26733-4C36-48CC-8607-9B1FDB74E85C}" destId="{8F9CB4A8-6BB4-4568-B5FA-93236D5DC3C2}" srcOrd="0" destOrd="0" presId="urn:microsoft.com/office/officeart/2005/8/layout/hierarchy1"/>
    <dgm:cxn modelId="{484F7548-93C4-4706-BC71-8DF3E7C253B6}" srcId="{1A34E547-DDC2-4563-ACB2-3E924F9BFEA8}" destId="{AF33832F-32CC-40AF-883E-CDFE523B1FA2}" srcOrd="0" destOrd="0" parTransId="{ECD65FD5-969F-4192-9A4F-A7A1B759592C}" sibTransId="{15094C85-920B-4729-A35C-F42AF833D9ED}"/>
    <dgm:cxn modelId="{9311430F-1777-4B6D-B59D-FCD80E61642A}" type="presOf" srcId="{B7B309C5-64A5-46E3-9620-C0A0B246341A}" destId="{20BCFE9A-C10D-49DB-8521-E8ACB9409F65}" srcOrd="0" destOrd="0" presId="urn:microsoft.com/office/officeart/2005/8/layout/hierarchy1"/>
    <dgm:cxn modelId="{726C93C3-BB83-412C-B128-DC3BBBD923D8}" type="presOf" srcId="{C3AE1E3F-4BB1-41B8-B320-E6E541EE877F}" destId="{0E8E3C61-C209-4BBF-B1BB-F9A0D40C092E}" srcOrd="0" destOrd="0" presId="urn:microsoft.com/office/officeart/2005/8/layout/hierarchy1"/>
    <dgm:cxn modelId="{7130598C-2B78-4D08-B8D8-8B9A54A1FDC0}" srcId="{AF33832F-32CC-40AF-883E-CDFE523B1FA2}" destId="{AEE26733-4C36-48CC-8607-9B1FDB74E85C}" srcOrd="1" destOrd="0" parTransId="{5090B564-B98E-4A91-871A-6AC1F9D07EDC}" sibTransId="{AFDAEB4D-FEFF-4411-A37C-17B62E978BC0}"/>
    <dgm:cxn modelId="{97E03301-AA66-4898-B286-63240EEB4A67}" srcId="{39F5AD40-E28B-41AA-9A1E-F07F29E2C5E0}" destId="{B93C0E96-0C44-4DA7-8EF5-7E08452A9D19}" srcOrd="0" destOrd="0" parTransId="{3C45595A-910B-49C7-9896-FB27B7D522D8}" sibTransId="{9C00EEB5-66BD-4077-869A-7D9A32DC7377}"/>
    <dgm:cxn modelId="{AAB53317-8AAC-415F-BF55-F161685CCFC9}" type="presOf" srcId="{5090B564-B98E-4A91-871A-6AC1F9D07EDC}" destId="{8DCF3E0D-EDCC-4246-B500-CBA6C0293F45}" srcOrd="0" destOrd="0" presId="urn:microsoft.com/office/officeart/2005/8/layout/hierarchy1"/>
    <dgm:cxn modelId="{82F9A541-52C7-439C-B703-B19769C5E665}" srcId="{AF33832F-32CC-40AF-883E-CDFE523B1FA2}" destId="{68AB00C8-16B6-41E6-B8A5-389DF5736300}" srcOrd="2" destOrd="0" parTransId="{A89F964B-AE4D-441A-88D7-19FFD554E876}" sibTransId="{A79DF145-F077-413D-A7B1-7C19EEF4AA83}"/>
    <dgm:cxn modelId="{56AF1836-AF34-4DD4-94FA-45C7D1818291}" type="presOf" srcId="{5E504991-298D-40D2-A77C-63634331796F}" destId="{0F83E8E0-FBCA-48D3-89A9-716E3BD7259E}" srcOrd="0" destOrd="0" presId="urn:microsoft.com/office/officeart/2005/8/layout/hierarchy1"/>
    <dgm:cxn modelId="{E562EEB3-21AB-4077-B2BB-8AD6854DD5AC}" type="presOf" srcId="{0DF04010-629C-4F5A-8855-29BACB84498A}" destId="{2208B9B7-B32A-41EA-AD76-C255F94111E1}" srcOrd="0" destOrd="0" presId="urn:microsoft.com/office/officeart/2005/8/layout/hierarchy1"/>
    <dgm:cxn modelId="{C06314BB-A619-45C5-979E-2D0BC6DE8881}" type="presOf" srcId="{5C94FED2-C0F0-4167-BEB5-5D8AF949FE21}" destId="{514934A7-0531-406F-8444-2D12F94C5393}" srcOrd="0" destOrd="0" presId="urn:microsoft.com/office/officeart/2005/8/layout/hierarchy1"/>
    <dgm:cxn modelId="{2B32420D-DB10-4ADA-B8B8-37779E5FAAED}" type="presOf" srcId="{3F9F0D71-0D4B-4B85-AAEB-0137C402AA2F}" destId="{2CA1E815-1B54-418A-AA5F-C2F89903A4A4}" srcOrd="0" destOrd="0" presId="urn:microsoft.com/office/officeart/2005/8/layout/hierarchy1"/>
    <dgm:cxn modelId="{D8B14966-EA4C-49B5-8932-0DFA60D59489}" srcId="{C3AE1E3F-4BB1-41B8-B320-E6E541EE877F}" destId="{323FCB35-71DE-4B41-A68A-9AFE76410811}" srcOrd="0" destOrd="0" parTransId="{33572893-3A83-4976-A931-779C7340D8BD}" sibTransId="{B8736D78-39E7-430E-8711-089A39C67DCF}"/>
    <dgm:cxn modelId="{29454F9F-B6E9-4391-B9F3-CD5AA11FA78D}" type="presOf" srcId="{DCE52416-E466-47D0-BF34-B1373ADD5F5F}" destId="{5E7E06BD-DE2E-40D3-8FF0-FC211521CD4F}" srcOrd="0" destOrd="0" presId="urn:microsoft.com/office/officeart/2005/8/layout/hierarchy1"/>
    <dgm:cxn modelId="{270B8FB6-D3C6-4562-8A21-ADF9422EA8F2}" type="presOf" srcId="{C0F9CD2B-3E98-4EB7-BE59-8AEDDED0EC18}" destId="{381B9CD4-1D79-49CF-9253-8E82403AB37C}" srcOrd="0" destOrd="0" presId="urn:microsoft.com/office/officeart/2005/8/layout/hierarchy1"/>
    <dgm:cxn modelId="{84A32889-E881-4E56-87A4-B6DB7D016637}" type="presOf" srcId="{C87AFAC8-39A0-48CE-8522-4086E06F865D}" destId="{61D15AC1-C4BA-486B-A371-6B8A05681208}" srcOrd="0" destOrd="0" presId="urn:microsoft.com/office/officeart/2005/8/layout/hierarchy1"/>
    <dgm:cxn modelId="{E8401C8D-CC01-4A20-B9CC-2D803DD3A210}" srcId="{DFCF81B1-7BF0-4982-9527-6D7378767CE5}" destId="{FE644E46-A0D2-4C2C-B20E-E8C0D946744D}" srcOrd="1" destOrd="0" parTransId="{620BB554-384C-477E-B06B-FBA72951148F}" sibTransId="{E7286029-EFDB-414E-B822-1EEDC6FF8738}"/>
    <dgm:cxn modelId="{FAD734E1-87BD-4E7E-9ED2-E122CEF83403}" type="presOf" srcId="{323FCB35-71DE-4B41-A68A-9AFE76410811}" destId="{9A3FB502-E9FE-4A87-B7A2-97A20E62DC1B}" srcOrd="0" destOrd="0" presId="urn:microsoft.com/office/officeart/2005/8/layout/hierarchy1"/>
    <dgm:cxn modelId="{DF014D6E-2FDB-41BE-86C8-CE1B45759002}" srcId="{AF33832F-32CC-40AF-883E-CDFE523B1FA2}" destId="{930720CD-072F-4DEA-AED2-E8EA6CEB0B46}" srcOrd="0" destOrd="0" parTransId="{7E35767A-4A8A-4B5F-86ED-9E6910D8A4C8}" sibTransId="{7FDED4A9-3A88-49C5-99CF-11216408E304}"/>
    <dgm:cxn modelId="{A5E05DDF-DF7D-4129-9A9F-C643C8144A9F}" type="presOf" srcId="{8897EDD5-7504-40C6-A4CD-6909F5C91B88}" destId="{22380030-06A3-413E-BE9B-63E74E763B1B}" srcOrd="0" destOrd="0" presId="urn:microsoft.com/office/officeart/2005/8/layout/hierarchy1"/>
    <dgm:cxn modelId="{6E846E22-16A0-438C-94C0-285FDEB59BB3}" type="presOf" srcId="{ECD65FD5-969F-4192-9A4F-A7A1B759592C}" destId="{01505EC1-C6BB-4A03-A691-B7B56C6803A3}" srcOrd="0" destOrd="0" presId="urn:microsoft.com/office/officeart/2005/8/layout/hierarchy1"/>
    <dgm:cxn modelId="{CC4DD60A-4253-4713-A2EF-1AC13FE5E64E}" type="presOf" srcId="{3C45595A-910B-49C7-9896-FB27B7D522D8}" destId="{5035B9DA-AD92-4068-9FA2-E074456674CE}" srcOrd="0" destOrd="0" presId="urn:microsoft.com/office/officeart/2005/8/layout/hierarchy1"/>
    <dgm:cxn modelId="{1306E3EC-1AB8-410B-A52A-58F360A060B0}" type="presOf" srcId="{7E35767A-4A8A-4B5F-86ED-9E6910D8A4C8}" destId="{5859CEB4-C93E-4FB0-A2E0-8EC5AD91AE86}" srcOrd="0" destOrd="0" presId="urn:microsoft.com/office/officeart/2005/8/layout/hierarchy1"/>
    <dgm:cxn modelId="{3B6B5BC9-3B03-4A5D-BBDE-443E1C7871DF}" srcId="{8897EDD5-7504-40C6-A4CD-6909F5C91B88}" destId="{B7B309C5-64A5-46E3-9620-C0A0B246341A}" srcOrd="0" destOrd="0" parTransId="{3F9F0D71-0D4B-4B85-AAEB-0137C402AA2F}" sibTransId="{ADB6394B-023A-44FE-BE99-8A28C8DECAE7}"/>
    <dgm:cxn modelId="{6E7A11BC-6431-4A71-8500-266B2447294C}" type="presOf" srcId="{3D69239F-55A9-4322-AB85-3ABCEA8D90DD}" destId="{A12B5581-E817-4595-9EC3-F125D651CF57}" srcOrd="0" destOrd="0" presId="urn:microsoft.com/office/officeart/2005/8/layout/hierarchy1"/>
    <dgm:cxn modelId="{2986DF4C-1EC1-477F-9A56-D4F8DC744310}" type="presOf" srcId="{930720CD-072F-4DEA-AED2-E8EA6CEB0B46}" destId="{52D058CF-23E0-4170-85BD-794F8B908DBC}" srcOrd="0" destOrd="0" presId="urn:microsoft.com/office/officeart/2005/8/layout/hierarchy1"/>
    <dgm:cxn modelId="{76053BBA-1D57-4EBF-8783-046D4B319683}" srcId="{323FCB35-71DE-4B41-A68A-9AFE76410811}" destId="{39F5AD40-E28B-41AA-9A1E-F07F29E2C5E0}" srcOrd="1" destOrd="0" parTransId="{C8346F43-EBC3-4009-85E3-DB4742C30E9A}" sibTransId="{3ABA5351-5722-4F4E-B2E2-D31354B757E7}"/>
    <dgm:cxn modelId="{E7E851B9-6E4B-421B-A00D-CA7857592BD8}" type="presOf" srcId="{E506F75C-EE25-433C-BAF2-83523763F7C4}" destId="{8A0152D2-DA54-4DBB-8107-22485DFBED20}" srcOrd="0" destOrd="0" presId="urn:microsoft.com/office/officeart/2005/8/layout/hierarchy1"/>
    <dgm:cxn modelId="{4EEB470E-6CE3-4824-B010-EE3DDB8A137F}" type="presParOf" srcId="{0E8E3C61-C209-4BBF-B1BB-F9A0D40C092E}" destId="{4D279FF0-3975-45F8-A23C-C6B8897830B5}" srcOrd="0" destOrd="0" presId="urn:microsoft.com/office/officeart/2005/8/layout/hierarchy1"/>
    <dgm:cxn modelId="{56DEF2EE-A4E1-426C-918E-FE09184DEE44}" type="presParOf" srcId="{4D279FF0-3975-45F8-A23C-C6B8897830B5}" destId="{C45C86DC-BD7C-4896-BF05-7035EA9D0029}" srcOrd="0" destOrd="0" presId="urn:microsoft.com/office/officeart/2005/8/layout/hierarchy1"/>
    <dgm:cxn modelId="{BD70E5FD-FF81-42A7-BA69-7742FC5F3D05}" type="presParOf" srcId="{C45C86DC-BD7C-4896-BF05-7035EA9D0029}" destId="{B86B6C38-1EA5-42F9-A2F5-D56D42BC74CC}" srcOrd="0" destOrd="0" presId="urn:microsoft.com/office/officeart/2005/8/layout/hierarchy1"/>
    <dgm:cxn modelId="{3A75AC34-D297-41B5-B93C-117ADC0FD325}" type="presParOf" srcId="{C45C86DC-BD7C-4896-BF05-7035EA9D0029}" destId="{9A3FB502-E9FE-4A87-B7A2-97A20E62DC1B}" srcOrd="1" destOrd="0" presId="urn:microsoft.com/office/officeart/2005/8/layout/hierarchy1"/>
    <dgm:cxn modelId="{498ED80A-52A7-4286-BB00-3613A586EE09}" type="presParOf" srcId="{4D279FF0-3975-45F8-A23C-C6B8897830B5}" destId="{19F8EF68-FCDE-460B-B255-36A528E76163}" srcOrd="1" destOrd="0" presId="urn:microsoft.com/office/officeart/2005/8/layout/hierarchy1"/>
    <dgm:cxn modelId="{47670E2C-AA8E-4BB9-9EF9-38914FB7B6CA}" type="presParOf" srcId="{19F8EF68-FCDE-460B-B255-36A528E76163}" destId="{0F83E8E0-FBCA-48D3-89A9-716E3BD7259E}" srcOrd="0" destOrd="0" presId="urn:microsoft.com/office/officeart/2005/8/layout/hierarchy1"/>
    <dgm:cxn modelId="{4DE02DF1-2195-4F53-AE10-A816A2AB5945}" type="presParOf" srcId="{19F8EF68-FCDE-460B-B255-36A528E76163}" destId="{E85C31D1-9AB0-4460-94D9-CA9016972314}" srcOrd="1" destOrd="0" presId="urn:microsoft.com/office/officeart/2005/8/layout/hierarchy1"/>
    <dgm:cxn modelId="{3F4B0E8E-A418-4A7D-AD53-0F8C03B45D13}" type="presParOf" srcId="{E85C31D1-9AB0-4460-94D9-CA9016972314}" destId="{B9DFA751-C3C5-47B5-8198-56A61CCA09FF}" srcOrd="0" destOrd="0" presId="urn:microsoft.com/office/officeart/2005/8/layout/hierarchy1"/>
    <dgm:cxn modelId="{67444DA1-22C4-4E59-8A75-0E9D1A3C80EA}" type="presParOf" srcId="{B9DFA751-C3C5-47B5-8198-56A61CCA09FF}" destId="{85DC020B-8793-4E48-BDD0-59483AE3BE28}" srcOrd="0" destOrd="0" presId="urn:microsoft.com/office/officeart/2005/8/layout/hierarchy1"/>
    <dgm:cxn modelId="{386E76A0-A820-4854-88BD-F48F2651A786}" type="presParOf" srcId="{B9DFA751-C3C5-47B5-8198-56A61CCA09FF}" destId="{DA4503CF-7324-420D-949A-A9ADB4B56557}" srcOrd="1" destOrd="0" presId="urn:microsoft.com/office/officeart/2005/8/layout/hierarchy1"/>
    <dgm:cxn modelId="{51DD2310-1EB5-45A7-A322-F98ECAFEC0E4}" type="presParOf" srcId="{E85C31D1-9AB0-4460-94D9-CA9016972314}" destId="{EB9C0338-C611-4AE4-ACA5-B185E4D89EDE}" srcOrd="1" destOrd="0" presId="urn:microsoft.com/office/officeart/2005/8/layout/hierarchy1"/>
    <dgm:cxn modelId="{709DB890-6103-4B57-94F9-79C58EB33CBE}" type="presParOf" srcId="{EB9C0338-C611-4AE4-ACA5-B185E4D89EDE}" destId="{01505EC1-C6BB-4A03-A691-B7B56C6803A3}" srcOrd="0" destOrd="0" presId="urn:microsoft.com/office/officeart/2005/8/layout/hierarchy1"/>
    <dgm:cxn modelId="{F882FD9F-2E82-415C-B5BB-066573D4C752}" type="presParOf" srcId="{EB9C0338-C611-4AE4-ACA5-B185E4D89EDE}" destId="{F5435A33-CB3F-4AB1-A45B-F718E60C53A5}" srcOrd="1" destOrd="0" presId="urn:microsoft.com/office/officeart/2005/8/layout/hierarchy1"/>
    <dgm:cxn modelId="{6EC01559-A2B3-4E3B-ACFF-E7E44FB4E8E4}" type="presParOf" srcId="{F5435A33-CB3F-4AB1-A45B-F718E60C53A5}" destId="{75340DEB-DD6B-4AA4-AB95-0955AB14B5F1}" srcOrd="0" destOrd="0" presId="urn:microsoft.com/office/officeart/2005/8/layout/hierarchy1"/>
    <dgm:cxn modelId="{23DE4720-0DC0-41B6-A19C-5F58232B3E62}" type="presParOf" srcId="{75340DEB-DD6B-4AA4-AB95-0955AB14B5F1}" destId="{A89D4233-94D6-4570-96E9-4153E0AE9554}" srcOrd="0" destOrd="0" presId="urn:microsoft.com/office/officeart/2005/8/layout/hierarchy1"/>
    <dgm:cxn modelId="{02AA3293-304C-4AEA-876A-984AE5DAD3E5}" type="presParOf" srcId="{75340DEB-DD6B-4AA4-AB95-0955AB14B5F1}" destId="{9DF54347-2A12-4809-AACE-6706A932FCBD}" srcOrd="1" destOrd="0" presId="urn:microsoft.com/office/officeart/2005/8/layout/hierarchy1"/>
    <dgm:cxn modelId="{3E5F0050-5B9C-428B-926C-68A9830676DF}" type="presParOf" srcId="{F5435A33-CB3F-4AB1-A45B-F718E60C53A5}" destId="{43C35C8E-7909-4970-AD95-4357F73BEA89}" srcOrd="1" destOrd="0" presId="urn:microsoft.com/office/officeart/2005/8/layout/hierarchy1"/>
    <dgm:cxn modelId="{74619041-983F-4C2A-A166-104C37E4118B}" type="presParOf" srcId="{43C35C8E-7909-4970-AD95-4357F73BEA89}" destId="{5859CEB4-C93E-4FB0-A2E0-8EC5AD91AE86}" srcOrd="0" destOrd="0" presId="urn:microsoft.com/office/officeart/2005/8/layout/hierarchy1"/>
    <dgm:cxn modelId="{3C942A5F-C73B-4FBB-A6A6-95692D68DFD4}" type="presParOf" srcId="{43C35C8E-7909-4970-AD95-4357F73BEA89}" destId="{AF4B2DDC-F290-4FA3-B662-58C33ADBF3DD}" srcOrd="1" destOrd="0" presId="urn:microsoft.com/office/officeart/2005/8/layout/hierarchy1"/>
    <dgm:cxn modelId="{FF24F07D-352F-4AC9-A3B1-BE716FEAE798}" type="presParOf" srcId="{AF4B2DDC-F290-4FA3-B662-58C33ADBF3DD}" destId="{B53B3874-A5B2-4EE6-99CB-452465941B10}" srcOrd="0" destOrd="0" presId="urn:microsoft.com/office/officeart/2005/8/layout/hierarchy1"/>
    <dgm:cxn modelId="{5273907A-579E-4D8D-839D-991F5BCD906B}" type="presParOf" srcId="{B53B3874-A5B2-4EE6-99CB-452465941B10}" destId="{7380D38D-EDC3-4B3C-8496-B444B2B782D3}" srcOrd="0" destOrd="0" presId="urn:microsoft.com/office/officeart/2005/8/layout/hierarchy1"/>
    <dgm:cxn modelId="{5D76E0EF-4D8D-484A-95ED-4BA1E90546CF}" type="presParOf" srcId="{B53B3874-A5B2-4EE6-99CB-452465941B10}" destId="{52D058CF-23E0-4170-85BD-794F8B908DBC}" srcOrd="1" destOrd="0" presId="urn:microsoft.com/office/officeart/2005/8/layout/hierarchy1"/>
    <dgm:cxn modelId="{368E4097-079F-453E-ADFA-FD99E70C7600}" type="presParOf" srcId="{AF4B2DDC-F290-4FA3-B662-58C33ADBF3DD}" destId="{7AA89F80-DB34-4671-A873-435577660511}" srcOrd="1" destOrd="0" presId="urn:microsoft.com/office/officeart/2005/8/layout/hierarchy1"/>
    <dgm:cxn modelId="{2D028168-B1DC-4D1E-BEF9-C22EB2ECDCBB}" type="presParOf" srcId="{43C35C8E-7909-4970-AD95-4357F73BEA89}" destId="{8DCF3E0D-EDCC-4246-B500-CBA6C0293F45}" srcOrd="2" destOrd="0" presId="urn:microsoft.com/office/officeart/2005/8/layout/hierarchy1"/>
    <dgm:cxn modelId="{334B5E84-AEEE-4696-BD23-26F4F62F311C}" type="presParOf" srcId="{43C35C8E-7909-4970-AD95-4357F73BEA89}" destId="{8909BF53-F4D5-48B0-9C25-3DE3E4CCF1A1}" srcOrd="3" destOrd="0" presId="urn:microsoft.com/office/officeart/2005/8/layout/hierarchy1"/>
    <dgm:cxn modelId="{EA902B16-CA81-412A-B521-2429AD74BFEA}" type="presParOf" srcId="{8909BF53-F4D5-48B0-9C25-3DE3E4CCF1A1}" destId="{38CD6E5D-CCB1-4BF8-B779-2A55C8329BE7}" srcOrd="0" destOrd="0" presId="urn:microsoft.com/office/officeart/2005/8/layout/hierarchy1"/>
    <dgm:cxn modelId="{9A6155ED-08AA-4F95-8AC6-6046E6B3B7FE}" type="presParOf" srcId="{38CD6E5D-CCB1-4BF8-B779-2A55C8329BE7}" destId="{BDE80D1C-FF7C-4B6A-860E-317787A645EA}" srcOrd="0" destOrd="0" presId="urn:microsoft.com/office/officeart/2005/8/layout/hierarchy1"/>
    <dgm:cxn modelId="{E9D98CD1-DC18-4ACB-99AA-519B2313093B}" type="presParOf" srcId="{38CD6E5D-CCB1-4BF8-B779-2A55C8329BE7}" destId="{8F9CB4A8-6BB4-4568-B5FA-93236D5DC3C2}" srcOrd="1" destOrd="0" presId="urn:microsoft.com/office/officeart/2005/8/layout/hierarchy1"/>
    <dgm:cxn modelId="{B3047780-220E-47E0-AF10-D5290A1E9266}" type="presParOf" srcId="{8909BF53-F4D5-48B0-9C25-3DE3E4CCF1A1}" destId="{527DAA8A-4607-45F5-8F48-D807E3530F55}" srcOrd="1" destOrd="0" presId="urn:microsoft.com/office/officeart/2005/8/layout/hierarchy1"/>
    <dgm:cxn modelId="{E34CC6EE-9AC4-446B-B842-C6EB5A987FE8}" type="presParOf" srcId="{43C35C8E-7909-4970-AD95-4357F73BEA89}" destId="{224C7AFB-EFC6-4969-A7C0-594DF5C1F756}" srcOrd="4" destOrd="0" presId="urn:microsoft.com/office/officeart/2005/8/layout/hierarchy1"/>
    <dgm:cxn modelId="{380A37E3-E7C5-4200-B90D-9D1B89FC5663}" type="presParOf" srcId="{43C35C8E-7909-4970-AD95-4357F73BEA89}" destId="{65801E3D-78D8-494E-A1C3-1A1E16B60A9F}" srcOrd="5" destOrd="0" presId="urn:microsoft.com/office/officeart/2005/8/layout/hierarchy1"/>
    <dgm:cxn modelId="{6CB31CE7-4802-4EEE-9907-2468BAAE6370}" type="presParOf" srcId="{65801E3D-78D8-494E-A1C3-1A1E16B60A9F}" destId="{6D67E7C1-9873-40F9-A284-07291DD9AF56}" srcOrd="0" destOrd="0" presId="urn:microsoft.com/office/officeart/2005/8/layout/hierarchy1"/>
    <dgm:cxn modelId="{77858805-736F-4B82-894C-9135E4DCEACC}" type="presParOf" srcId="{6D67E7C1-9873-40F9-A284-07291DD9AF56}" destId="{7C0C4BDE-CCDA-42F6-9D3C-32057049B235}" srcOrd="0" destOrd="0" presId="urn:microsoft.com/office/officeart/2005/8/layout/hierarchy1"/>
    <dgm:cxn modelId="{F6331B5D-1A55-4E04-A01D-AAE066AA2365}" type="presParOf" srcId="{6D67E7C1-9873-40F9-A284-07291DD9AF56}" destId="{0B370476-F647-48C4-92F7-EFAD0F281B39}" srcOrd="1" destOrd="0" presId="urn:microsoft.com/office/officeart/2005/8/layout/hierarchy1"/>
    <dgm:cxn modelId="{2B153AEB-6B47-430F-A42A-B3F5403D6756}" type="presParOf" srcId="{65801E3D-78D8-494E-A1C3-1A1E16B60A9F}" destId="{D34E2F35-87B2-453D-9343-92061744D269}" srcOrd="1" destOrd="0" presId="urn:microsoft.com/office/officeart/2005/8/layout/hierarchy1"/>
    <dgm:cxn modelId="{E8972C13-845C-42C6-8450-26147F50B9F3}" type="presParOf" srcId="{EB9C0338-C611-4AE4-ACA5-B185E4D89EDE}" destId="{62C5452C-9150-47E4-A9D0-D8F29A94BF1C}" srcOrd="2" destOrd="0" presId="urn:microsoft.com/office/officeart/2005/8/layout/hierarchy1"/>
    <dgm:cxn modelId="{C1AE395B-1678-4175-B2B6-02F7BEDC6914}" type="presParOf" srcId="{EB9C0338-C611-4AE4-ACA5-B185E4D89EDE}" destId="{54B96B94-87DE-4AFB-BC17-35B690B75906}" srcOrd="3" destOrd="0" presId="urn:microsoft.com/office/officeart/2005/8/layout/hierarchy1"/>
    <dgm:cxn modelId="{28AA7145-B6EC-4CF7-9319-3C890AE0757A}" type="presParOf" srcId="{54B96B94-87DE-4AFB-BC17-35B690B75906}" destId="{57B318EA-689F-46CA-9C34-2669AF592027}" srcOrd="0" destOrd="0" presId="urn:microsoft.com/office/officeart/2005/8/layout/hierarchy1"/>
    <dgm:cxn modelId="{8F3AC105-8733-479F-97E6-42A2C2739CB2}" type="presParOf" srcId="{57B318EA-689F-46CA-9C34-2669AF592027}" destId="{728A4A9E-147B-4685-8298-B02A1D7F35E7}" srcOrd="0" destOrd="0" presId="urn:microsoft.com/office/officeart/2005/8/layout/hierarchy1"/>
    <dgm:cxn modelId="{C5BF5F2A-759C-4CD3-8658-8F4B4249FDC7}" type="presParOf" srcId="{57B318EA-689F-46CA-9C34-2669AF592027}" destId="{FEDF974C-2D37-48B2-8380-3C7A241028C8}" srcOrd="1" destOrd="0" presId="urn:microsoft.com/office/officeart/2005/8/layout/hierarchy1"/>
    <dgm:cxn modelId="{E9BE2550-3C4F-4735-9248-E03E9D1238BA}" type="presParOf" srcId="{54B96B94-87DE-4AFB-BC17-35B690B75906}" destId="{EE2F683B-BFE7-4A17-88FF-8F4BDA1428A3}" srcOrd="1" destOrd="0" presId="urn:microsoft.com/office/officeart/2005/8/layout/hierarchy1"/>
    <dgm:cxn modelId="{733AAE96-86FD-411F-8943-88DADD68A42E}" type="presParOf" srcId="{EE2F683B-BFE7-4A17-88FF-8F4BDA1428A3}" destId="{5E7E06BD-DE2E-40D3-8FF0-FC211521CD4F}" srcOrd="0" destOrd="0" presId="urn:microsoft.com/office/officeart/2005/8/layout/hierarchy1"/>
    <dgm:cxn modelId="{E57E959D-CC00-47D5-AD8E-2B56474E4D27}" type="presParOf" srcId="{EE2F683B-BFE7-4A17-88FF-8F4BDA1428A3}" destId="{5197D112-8018-4BF4-A4D3-56A4A7DA0A40}" srcOrd="1" destOrd="0" presId="urn:microsoft.com/office/officeart/2005/8/layout/hierarchy1"/>
    <dgm:cxn modelId="{DFF9AA16-C3EC-45D4-9902-6A80B4AAD077}" type="presParOf" srcId="{5197D112-8018-4BF4-A4D3-56A4A7DA0A40}" destId="{AC1464DD-A543-4CE5-A13B-BDF087C7C198}" srcOrd="0" destOrd="0" presId="urn:microsoft.com/office/officeart/2005/8/layout/hierarchy1"/>
    <dgm:cxn modelId="{2FCDB56F-847B-4DFC-A6E1-5A577C854149}" type="presParOf" srcId="{AC1464DD-A543-4CE5-A13B-BDF087C7C198}" destId="{87F3E96A-9184-487D-A9E8-C7ECE40AE56F}" srcOrd="0" destOrd="0" presId="urn:microsoft.com/office/officeart/2005/8/layout/hierarchy1"/>
    <dgm:cxn modelId="{11C30375-B6DA-4E86-8622-6AAB3E3FB5F9}" type="presParOf" srcId="{AC1464DD-A543-4CE5-A13B-BDF087C7C198}" destId="{1E113764-AC88-46F8-8C69-71913DC3F1AC}" srcOrd="1" destOrd="0" presId="urn:microsoft.com/office/officeart/2005/8/layout/hierarchy1"/>
    <dgm:cxn modelId="{F9777C27-CFE3-4BD8-B37A-F634739A1586}" type="presParOf" srcId="{5197D112-8018-4BF4-A4D3-56A4A7DA0A40}" destId="{91D0C354-1247-4745-AB19-03E4A62E2AC8}" srcOrd="1" destOrd="0" presId="urn:microsoft.com/office/officeart/2005/8/layout/hierarchy1"/>
    <dgm:cxn modelId="{1376F79E-D738-47FF-BB45-9DFD0EEB59E7}" type="presParOf" srcId="{EE2F683B-BFE7-4A17-88FF-8F4BDA1428A3}" destId="{89289DB7-0E13-4434-BB61-4276BB77D10B}" srcOrd="2" destOrd="0" presId="urn:microsoft.com/office/officeart/2005/8/layout/hierarchy1"/>
    <dgm:cxn modelId="{D2BCCED5-ABBE-4483-9045-4580D481888F}" type="presParOf" srcId="{EE2F683B-BFE7-4A17-88FF-8F4BDA1428A3}" destId="{2C1C0872-3BF6-4EC0-A0D1-E1C6D5C7BC28}" srcOrd="3" destOrd="0" presId="urn:microsoft.com/office/officeart/2005/8/layout/hierarchy1"/>
    <dgm:cxn modelId="{E8D92549-A064-4D8D-A5AB-5284A6049841}" type="presParOf" srcId="{2C1C0872-3BF6-4EC0-A0D1-E1C6D5C7BC28}" destId="{592EC76B-98DD-49B1-AABC-4E2E434850DC}" srcOrd="0" destOrd="0" presId="urn:microsoft.com/office/officeart/2005/8/layout/hierarchy1"/>
    <dgm:cxn modelId="{07479E6C-41B5-47C3-BD66-38EC305B33D2}" type="presParOf" srcId="{592EC76B-98DD-49B1-AABC-4E2E434850DC}" destId="{78353A0F-6FE0-4847-A281-52CC821EE4B6}" srcOrd="0" destOrd="0" presId="urn:microsoft.com/office/officeart/2005/8/layout/hierarchy1"/>
    <dgm:cxn modelId="{769CF204-5757-4D52-A102-EF2609B34D4F}" type="presParOf" srcId="{592EC76B-98DD-49B1-AABC-4E2E434850DC}" destId="{F5E0BE3A-20F2-46FD-87E9-3EFF6A3D06DA}" srcOrd="1" destOrd="0" presId="urn:microsoft.com/office/officeart/2005/8/layout/hierarchy1"/>
    <dgm:cxn modelId="{7CC50D6F-9DA5-49A9-9356-69F370EC8DD4}" type="presParOf" srcId="{2C1C0872-3BF6-4EC0-A0D1-E1C6D5C7BC28}" destId="{982BD893-7E09-4B71-BA36-471AEF05B5E2}" srcOrd="1" destOrd="0" presId="urn:microsoft.com/office/officeart/2005/8/layout/hierarchy1"/>
    <dgm:cxn modelId="{36881D63-DC80-42C5-840E-D68A03B10B59}" type="presParOf" srcId="{EE2F683B-BFE7-4A17-88FF-8F4BDA1428A3}" destId="{A12B5581-E817-4595-9EC3-F125D651CF57}" srcOrd="4" destOrd="0" presId="urn:microsoft.com/office/officeart/2005/8/layout/hierarchy1"/>
    <dgm:cxn modelId="{C607DC4E-0B49-4B9C-A952-AC6437A5E15E}" type="presParOf" srcId="{EE2F683B-BFE7-4A17-88FF-8F4BDA1428A3}" destId="{F52376A7-5D47-4546-99FE-02C7B1457247}" srcOrd="5" destOrd="0" presId="urn:microsoft.com/office/officeart/2005/8/layout/hierarchy1"/>
    <dgm:cxn modelId="{90842241-A14E-4099-BEC4-6C816878BF47}" type="presParOf" srcId="{F52376A7-5D47-4546-99FE-02C7B1457247}" destId="{B6531A0C-0B26-46F7-838C-41324A8800C2}" srcOrd="0" destOrd="0" presId="urn:microsoft.com/office/officeart/2005/8/layout/hierarchy1"/>
    <dgm:cxn modelId="{3A3736FC-9090-4543-A33C-20CB89886730}" type="presParOf" srcId="{B6531A0C-0B26-46F7-838C-41324A8800C2}" destId="{8D345DFC-9463-412A-9124-127DCD7D9959}" srcOrd="0" destOrd="0" presId="urn:microsoft.com/office/officeart/2005/8/layout/hierarchy1"/>
    <dgm:cxn modelId="{D161A0EF-CB42-410D-A16F-F283C94BC737}" type="presParOf" srcId="{B6531A0C-0B26-46F7-838C-41324A8800C2}" destId="{F42F99AC-F994-4ECA-A1A2-88DDB335B4F0}" srcOrd="1" destOrd="0" presId="urn:microsoft.com/office/officeart/2005/8/layout/hierarchy1"/>
    <dgm:cxn modelId="{FE26100D-6F8A-4434-A645-A81BDD1D67AC}" type="presParOf" srcId="{F52376A7-5D47-4546-99FE-02C7B1457247}" destId="{B47684E5-9700-46FB-BC60-CEF98AAED46E}" srcOrd="1" destOrd="0" presId="urn:microsoft.com/office/officeart/2005/8/layout/hierarchy1"/>
    <dgm:cxn modelId="{77D3E5B6-8F82-43C6-B76E-8E652015DAD9}" type="presParOf" srcId="{19F8EF68-FCDE-460B-B255-36A528E76163}" destId="{6B7E7703-4CBD-4EF0-92DF-960E1C376C3D}" srcOrd="2" destOrd="0" presId="urn:microsoft.com/office/officeart/2005/8/layout/hierarchy1"/>
    <dgm:cxn modelId="{15E1FBD2-ED2A-4F36-A41D-8158F27817E8}" type="presParOf" srcId="{19F8EF68-FCDE-460B-B255-36A528E76163}" destId="{57139C8D-3269-4839-9E55-6F9B018DC12B}" srcOrd="3" destOrd="0" presId="urn:microsoft.com/office/officeart/2005/8/layout/hierarchy1"/>
    <dgm:cxn modelId="{65D82370-3813-4480-AB6C-625BDAF636C1}" type="presParOf" srcId="{57139C8D-3269-4839-9E55-6F9B018DC12B}" destId="{A2FF242A-F616-4311-9E14-80BE6A977774}" srcOrd="0" destOrd="0" presId="urn:microsoft.com/office/officeart/2005/8/layout/hierarchy1"/>
    <dgm:cxn modelId="{DE42A05C-1F17-4942-B9D3-EE15DBB4B0A9}" type="presParOf" srcId="{A2FF242A-F616-4311-9E14-80BE6A977774}" destId="{B0D02396-8B89-45C2-8AC2-36F3D63187CD}" srcOrd="0" destOrd="0" presId="urn:microsoft.com/office/officeart/2005/8/layout/hierarchy1"/>
    <dgm:cxn modelId="{20311F0F-76DD-4CC5-95A0-5EE746124482}" type="presParOf" srcId="{A2FF242A-F616-4311-9E14-80BE6A977774}" destId="{14E36AB6-049D-4632-BB1C-F9F633A2FC42}" srcOrd="1" destOrd="0" presId="urn:microsoft.com/office/officeart/2005/8/layout/hierarchy1"/>
    <dgm:cxn modelId="{8EE881AA-2939-4CC6-B82A-D20C19F0202C}" type="presParOf" srcId="{57139C8D-3269-4839-9E55-6F9B018DC12B}" destId="{0D7264D4-D04F-4DC1-B3E8-354462CFC5F7}" srcOrd="1" destOrd="0" presId="urn:microsoft.com/office/officeart/2005/8/layout/hierarchy1"/>
    <dgm:cxn modelId="{5AEE63EB-BDD2-4A82-8186-26B5ED886D15}" type="presParOf" srcId="{0D7264D4-D04F-4DC1-B3E8-354462CFC5F7}" destId="{5035B9DA-AD92-4068-9FA2-E074456674CE}" srcOrd="0" destOrd="0" presId="urn:microsoft.com/office/officeart/2005/8/layout/hierarchy1"/>
    <dgm:cxn modelId="{6D6B7D5E-4BED-4B7A-B89B-F2CE0F94479B}" type="presParOf" srcId="{0D7264D4-D04F-4DC1-B3E8-354462CFC5F7}" destId="{2D211F3F-8B4A-4BAF-B73A-AB5A8D25F3AE}" srcOrd="1" destOrd="0" presId="urn:microsoft.com/office/officeart/2005/8/layout/hierarchy1"/>
    <dgm:cxn modelId="{7FDA9CCF-B2A4-4A73-8909-FB2A2EBBCD55}" type="presParOf" srcId="{2D211F3F-8B4A-4BAF-B73A-AB5A8D25F3AE}" destId="{DAF1ABEB-A6F6-46DF-9F03-7B35A13D0F06}" srcOrd="0" destOrd="0" presId="urn:microsoft.com/office/officeart/2005/8/layout/hierarchy1"/>
    <dgm:cxn modelId="{53BC3EFE-2139-4E00-AFF2-D87D3C886C4B}" type="presParOf" srcId="{DAF1ABEB-A6F6-46DF-9F03-7B35A13D0F06}" destId="{3B0F15E5-BC52-4328-95A4-A69A94BBA697}" srcOrd="0" destOrd="0" presId="urn:microsoft.com/office/officeart/2005/8/layout/hierarchy1"/>
    <dgm:cxn modelId="{5160C666-4024-48B3-8DA0-693D7CA9664C}" type="presParOf" srcId="{DAF1ABEB-A6F6-46DF-9F03-7B35A13D0F06}" destId="{C5BC661E-CF8F-49BE-ADB4-818ACAE05F51}" srcOrd="1" destOrd="0" presId="urn:microsoft.com/office/officeart/2005/8/layout/hierarchy1"/>
    <dgm:cxn modelId="{85EF5554-47EC-415B-8654-97459734C180}" type="presParOf" srcId="{2D211F3F-8B4A-4BAF-B73A-AB5A8D25F3AE}" destId="{62E70D2F-137A-4120-8465-DD92DAF7CBA2}" srcOrd="1" destOrd="0" presId="urn:microsoft.com/office/officeart/2005/8/layout/hierarchy1"/>
    <dgm:cxn modelId="{21B77806-EBA7-4462-8525-75C1FE0221B1}" type="presParOf" srcId="{62E70D2F-137A-4120-8465-DD92DAF7CBA2}" destId="{514934A7-0531-406F-8444-2D12F94C5393}" srcOrd="0" destOrd="0" presId="urn:microsoft.com/office/officeart/2005/8/layout/hierarchy1"/>
    <dgm:cxn modelId="{C01233CC-B38A-4515-9701-E1920E0237FB}" type="presParOf" srcId="{62E70D2F-137A-4120-8465-DD92DAF7CBA2}" destId="{975D4C49-0A5E-4301-9936-8B573B14A6F7}" srcOrd="1" destOrd="0" presId="urn:microsoft.com/office/officeart/2005/8/layout/hierarchy1"/>
    <dgm:cxn modelId="{F2B36846-9132-464B-BAB3-131793F806E7}" type="presParOf" srcId="{975D4C49-0A5E-4301-9936-8B573B14A6F7}" destId="{AC2EA95D-3438-4CB0-9B54-00B6F52396BE}" srcOrd="0" destOrd="0" presId="urn:microsoft.com/office/officeart/2005/8/layout/hierarchy1"/>
    <dgm:cxn modelId="{74B31D02-6CC1-4348-B23F-4D68CCEBA01D}" type="presParOf" srcId="{AC2EA95D-3438-4CB0-9B54-00B6F52396BE}" destId="{D7E8AD84-9A55-412F-959B-0B9AE1301B6D}" srcOrd="0" destOrd="0" presId="urn:microsoft.com/office/officeart/2005/8/layout/hierarchy1"/>
    <dgm:cxn modelId="{6B15AFC5-7F75-4679-983A-A59EFCC31EC7}" type="presParOf" srcId="{AC2EA95D-3438-4CB0-9B54-00B6F52396BE}" destId="{0E551DDB-8AE4-4A24-B7CB-F16BE43C6E88}" srcOrd="1" destOrd="0" presId="urn:microsoft.com/office/officeart/2005/8/layout/hierarchy1"/>
    <dgm:cxn modelId="{178EDBC7-36B3-4BF7-B847-AF122A40D96F}" type="presParOf" srcId="{975D4C49-0A5E-4301-9936-8B573B14A6F7}" destId="{B7E22775-4DE0-421A-99D1-67A66D20F8CF}" srcOrd="1" destOrd="0" presId="urn:microsoft.com/office/officeart/2005/8/layout/hierarchy1"/>
    <dgm:cxn modelId="{57627784-4AB8-4420-B88C-19B7AA733777}" type="presParOf" srcId="{62E70D2F-137A-4120-8465-DD92DAF7CBA2}" destId="{381B9CD4-1D79-49CF-9253-8E82403AB37C}" srcOrd="2" destOrd="0" presId="urn:microsoft.com/office/officeart/2005/8/layout/hierarchy1"/>
    <dgm:cxn modelId="{CD923E8B-B794-468B-A04F-E8F6E1EEA999}" type="presParOf" srcId="{62E70D2F-137A-4120-8465-DD92DAF7CBA2}" destId="{0299E928-B631-4171-A008-643B8DECC8E3}" srcOrd="3" destOrd="0" presId="urn:microsoft.com/office/officeart/2005/8/layout/hierarchy1"/>
    <dgm:cxn modelId="{2BC0BE53-A943-4986-BD8F-1BD77768A2A1}" type="presParOf" srcId="{0299E928-B631-4171-A008-643B8DECC8E3}" destId="{9954B51F-5ADE-4AD6-97FB-D3FF46B7FFE1}" srcOrd="0" destOrd="0" presId="urn:microsoft.com/office/officeart/2005/8/layout/hierarchy1"/>
    <dgm:cxn modelId="{FA1AB291-37E1-4E1F-AF00-FFDD0F22723A}" type="presParOf" srcId="{9954B51F-5ADE-4AD6-97FB-D3FF46B7FFE1}" destId="{84C848DC-742D-4281-8FBA-7D2E6EEACB49}" srcOrd="0" destOrd="0" presId="urn:microsoft.com/office/officeart/2005/8/layout/hierarchy1"/>
    <dgm:cxn modelId="{D2D2DA9E-2F65-4F54-A7F8-F8D5D7FAFACD}" type="presParOf" srcId="{9954B51F-5ADE-4AD6-97FB-D3FF46B7FFE1}" destId="{004916B4-CFB9-45D9-A110-8E508FA98D6E}" srcOrd="1" destOrd="0" presId="urn:microsoft.com/office/officeart/2005/8/layout/hierarchy1"/>
    <dgm:cxn modelId="{49A209ED-2CC3-473A-9069-EC8864A95CE7}" type="presParOf" srcId="{0299E928-B631-4171-A008-643B8DECC8E3}" destId="{B9B00D75-9C84-41EB-AE94-7FAA992590F4}" srcOrd="1" destOrd="0" presId="urn:microsoft.com/office/officeart/2005/8/layout/hierarchy1"/>
    <dgm:cxn modelId="{8CAEA940-7545-4BFC-96A1-37810C36AF19}" type="presParOf" srcId="{62E70D2F-137A-4120-8465-DD92DAF7CBA2}" destId="{0EA5458F-EC01-42C8-A919-83F455905C5D}" srcOrd="4" destOrd="0" presId="urn:microsoft.com/office/officeart/2005/8/layout/hierarchy1"/>
    <dgm:cxn modelId="{642FA6C0-4591-4BAE-9634-09C2701A8F1D}" type="presParOf" srcId="{62E70D2F-137A-4120-8465-DD92DAF7CBA2}" destId="{34BA7749-67EA-423F-8D74-AA1F2719BBD3}" srcOrd="5" destOrd="0" presId="urn:microsoft.com/office/officeart/2005/8/layout/hierarchy1"/>
    <dgm:cxn modelId="{58003676-60AF-4678-B65E-781F63BEC03C}" type="presParOf" srcId="{34BA7749-67EA-423F-8D74-AA1F2719BBD3}" destId="{B74E2249-6DD0-439C-8476-0E939F7100A1}" srcOrd="0" destOrd="0" presId="urn:microsoft.com/office/officeart/2005/8/layout/hierarchy1"/>
    <dgm:cxn modelId="{266700E3-DCF6-4C76-8A9F-668314DC57EE}" type="presParOf" srcId="{B74E2249-6DD0-439C-8476-0E939F7100A1}" destId="{DD37CAD5-583C-4E88-BBFF-AB7E89C63E39}" srcOrd="0" destOrd="0" presId="urn:microsoft.com/office/officeart/2005/8/layout/hierarchy1"/>
    <dgm:cxn modelId="{017EC8A0-9D24-45F7-B24E-E6D5A54DCAF0}" type="presParOf" srcId="{B74E2249-6DD0-439C-8476-0E939F7100A1}" destId="{BD8E69F2-63AE-4532-855E-10C863ACFAC9}" srcOrd="1" destOrd="0" presId="urn:microsoft.com/office/officeart/2005/8/layout/hierarchy1"/>
    <dgm:cxn modelId="{898D8BE4-4281-4AFD-BFF3-2E4D1FD2510F}" type="presParOf" srcId="{34BA7749-67EA-423F-8D74-AA1F2719BBD3}" destId="{1276F47B-CE0A-43D6-8239-D088C74EDF57}" srcOrd="1" destOrd="0" presId="urn:microsoft.com/office/officeart/2005/8/layout/hierarchy1"/>
    <dgm:cxn modelId="{4AFE889A-945A-4BB0-8658-6257AF4B7D7E}" type="presParOf" srcId="{0D7264D4-D04F-4DC1-B3E8-354462CFC5F7}" destId="{8A0152D2-DA54-4DBB-8107-22485DFBED20}" srcOrd="2" destOrd="0" presId="urn:microsoft.com/office/officeart/2005/8/layout/hierarchy1"/>
    <dgm:cxn modelId="{BE2FC2DA-02C4-455C-B4E7-DAF3C56E6967}" type="presParOf" srcId="{0D7264D4-D04F-4DC1-B3E8-354462CFC5F7}" destId="{4F75829C-29D7-4553-B850-47FBC5131D3E}" srcOrd="3" destOrd="0" presId="urn:microsoft.com/office/officeart/2005/8/layout/hierarchy1"/>
    <dgm:cxn modelId="{402650BC-8D2B-4B26-B426-A43B4383EE43}" type="presParOf" srcId="{4F75829C-29D7-4553-B850-47FBC5131D3E}" destId="{7D77C575-4A99-4F6E-9334-A5D1918135D9}" srcOrd="0" destOrd="0" presId="urn:microsoft.com/office/officeart/2005/8/layout/hierarchy1"/>
    <dgm:cxn modelId="{5C6F17B2-4B2E-4983-A987-EBA56CF50A33}" type="presParOf" srcId="{7D77C575-4A99-4F6E-9334-A5D1918135D9}" destId="{64832586-715F-4AC3-B3F7-8A64339DD70D}" srcOrd="0" destOrd="0" presId="urn:microsoft.com/office/officeart/2005/8/layout/hierarchy1"/>
    <dgm:cxn modelId="{AD707E13-08EF-4132-8607-63EF0B94E0C8}" type="presParOf" srcId="{7D77C575-4A99-4F6E-9334-A5D1918135D9}" destId="{22380030-06A3-413E-BE9B-63E74E763B1B}" srcOrd="1" destOrd="0" presId="urn:microsoft.com/office/officeart/2005/8/layout/hierarchy1"/>
    <dgm:cxn modelId="{21E7DB00-0094-4852-89C6-6290B41E1502}" type="presParOf" srcId="{4F75829C-29D7-4553-B850-47FBC5131D3E}" destId="{EC726021-1599-44DB-A7BD-DABFEB445716}" srcOrd="1" destOrd="0" presId="urn:microsoft.com/office/officeart/2005/8/layout/hierarchy1"/>
    <dgm:cxn modelId="{BAD3C01E-C529-4BE1-ADC7-0C5D7B0D4E8E}" type="presParOf" srcId="{EC726021-1599-44DB-A7BD-DABFEB445716}" destId="{2CA1E815-1B54-418A-AA5F-C2F89903A4A4}" srcOrd="0" destOrd="0" presId="urn:microsoft.com/office/officeart/2005/8/layout/hierarchy1"/>
    <dgm:cxn modelId="{A0D56E56-8C8D-4ED8-AA17-BD8DBB856FB1}" type="presParOf" srcId="{EC726021-1599-44DB-A7BD-DABFEB445716}" destId="{DE29564C-9C0E-4D98-8B47-F2D244E38788}" srcOrd="1" destOrd="0" presId="urn:microsoft.com/office/officeart/2005/8/layout/hierarchy1"/>
    <dgm:cxn modelId="{4589AD70-FAB2-4B09-91D1-4FD4687C64B0}" type="presParOf" srcId="{DE29564C-9C0E-4D98-8B47-F2D244E38788}" destId="{EFE6174F-BEBF-47F2-B652-47F22A9C9FBD}" srcOrd="0" destOrd="0" presId="urn:microsoft.com/office/officeart/2005/8/layout/hierarchy1"/>
    <dgm:cxn modelId="{F9FA183D-384F-45A2-8E7F-96BFB587766D}" type="presParOf" srcId="{EFE6174F-BEBF-47F2-B652-47F22A9C9FBD}" destId="{647246EF-7206-4029-A4D2-D57775829928}" srcOrd="0" destOrd="0" presId="urn:microsoft.com/office/officeart/2005/8/layout/hierarchy1"/>
    <dgm:cxn modelId="{85BD4724-7613-4055-89F8-CFF929A37940}" type="presParOf" srcId="{EFE6174F-BEBF-47F2-B652-47F22A9C9FBD}" destId="{20BCFE9A-C10D-49DB-8521-E8ACB9409F65}" srcOrd="1" destOrd="0" presId="urn:microsoft.com/office/officeart/2005/8/layout/hierarchy1"/>
    <dgm:cxn modelId="{3F1D1774-A7AD-4F73-91CC-11CFF39E2725}" type="presParOf" srcId="{DE29564C-9C0E-4D98-8B47-F2D244E38788}" destId="{6F1AEC0E-E7D1-4384-803F-0716FF4A58AD}" srcOrd="1" destOrd="0" presId="urn:microsoft.com/office/officeart/2005/8/layout/hierarchy1"/>
    <dgm:cxn modelId="{AED08E73-1E1C-4D87-A156-61FE0B987C51}" type="presParOf" srcId="{EC726021-1599-44DB-A7BD-DABFEB445716}" destId="{5D2FC06B-85C4-4578-8CD9-0BCDF54D2D73}" srcOrd="2" destOrd="0" presId="urn:microsoft.com/office/officeart/2005/8/layout/hierarchy1"/>
    <dgm:cxn modelId="{4BE5BE1C-0723-42BE-AB6B-0EE079D238B5}" type="presParOf" srcId="{EC726021-1599-44DB-A7BD-DABFEB445716}" destId="{4393AB7A-3150-451B-9C72-C6A574B22DDD}" srcOrd="3" destOrd="0" presId="urn:microsoft.com/office/officeart/2005/8/layout/hierarchy1"/>
    <dgm:cxn modelId="{FC6AB877-3EDD-43A0-823B-62495AB2499B}" type="presParOf" srcId="{4393AB7A-3150-451B-9C72-C6A574B22DDD}" destId="{6138E41B-0E92-4880-93B4-DB0F6DF43214}" srcOrd="0" destOrd="0" presId="urn:microsoft.com/office/officeart/2005/8/layout/hierarchy1"/>
    <dgm:cxn modelId="{E5FA7060-FD06-4140-AFB5-65BC81695357}" type="presParOf" srcId="{6138E41B-0E92-4880-93B4-DB0F6DF43214}" destId="{10496025-7742-4987-80BB-AD3BA5F5AD31}" srcOrd="0" destOrd="0" presId="urn:microsoft.com/office/officeart/2005/8/layout/hierarchy1"/>
    <dgm:cxn modelId="{0A644318-CDA3-4E12-9C94-8199844373BC}" type="presParOf" srcId="{6138E41B-0E92-4880-93B4-DB0F6DF43214}" destId="{61D15AC1-C4BA-486B-A371-6B8A05681208}" srcOrd="1" destOrd="0" presId="urn:microsoft.com/office/officeart/2005/8/layout/hierarchy1"/>
    <dgm:cxn modelId="{9F456463-72AA-4A5E-9E77-13EA05BBD54E}" type="presParOf" srcId="{4393AB7A-3150-451B-9C72-C6A574B22DDD}" destId="{89688DC5-6313-48B4-B933-7A6A3DC08DCA}" srcOrd="1" destOrd="0" presId="urn:microsoft.com/office/officeart/2005/8/layout/hierarchy1"/>
    <dgm:cxn modelId="{6CB58C74-DA02-4578-97C9-443A828BFFD9}" type="presParOf" srcId="{EC726021-1599-44DB-A7BD-DABFEB445716}" destId="{2208B9B7-B32A-41EA-AD76-C255F94111E1}" srcOrd="4" destOrd="0" presId="urn:microsoft.com/office/officeart/2005/8/layout/hierarchy1"/>
    <dgm:cxn modelId="{B3E52816-8917-466E-B5F3-64EAC0C67D86}" type="presParOf" srcId="{EC726021-1599-44DB-A7BD-DABFEB445716}" destId="{6554EE1B-1DAF-4524-B3EF-0488BC0B60C4}" srcOrd="5" destOrd="0" presId="urn:microsoft.com/office/officeart/2005/8/layout/hierarchy1"/>
    <dgm:cxn modelId="{D8A76771-F8D7-4D45-9883-E5295674A545}" type="presParOf" srcId="{6554EE1B-1DAF-4524-B3EF-0488BC0B60C4}" destId="{AF2435EB-9CA0-4843-AC45-F84B1DA95D53}" srcOrd="0" destOrd="0" presId="urn:microsoft.com/office/officeart/2005/8/layout/hierarchy1"/>
    <dgm:cxn modelId="{E325A41E-1AF0-4EBE-A6BE-CB78A96C41FC}" type="presParOf" srcId="{AF2435EB-9CA0-4843-AC45-F84B1DA95D53}" destId="{10E1FA96-19F5-440B-A4E0-AF0DC38FB8D1}" srcOrd="0" destOrd="0" presId="urn:microsoft.com/office/officeart/2005/8/layout/hierarchy1"/>
    <dgm:cxn modelId="{568AB53E-4F21-43CF-AA7D-726EB2FB2BBC}" type="presParOf" srcId="{AF2435EB-9CA0-4843-AC45-F84B1DA95D53}" destId="{B2D96498-F065-49BE-95C9-80EB16D43058}" srcOrd="1" destOrd="0" presId="urn:microsoft.com/office/officeart/2005/8/layout/hierarchy1"/>
    <dgm:cxn modelId="{794781E1-3F19-4F0F-BEDB-0AFBAB88CA45}" type="presParOf" srcId="{6554EE1B-1DAF-4524-B3EF-0488BC0B60C4}" destId="{F01EE8ED-ECED-467D-A0CD-A9C732AF7872}" srcOrd="1" destOrd="0" presId="urn:microsoft.com/office/officeart/2005/8/layout/hierarchy1"/>
  </dgm:cxnLst>
  <dgm:bg>
    <a:noFill/>
  </dgm:bg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  <a:ext uri="{C62137D5-CB1D-491B-B009-E17868A290BF}">
      <dgm14:recolorImg xmlns:dgm14="http://schemas.microsoft.com/office/drawing/2010/diagram" val="1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2208B9B7-B32A-41EA-AD76-C255F94111E1}">
      <dsp:nvSpPr>
        <dsp:cNvPr id="0" name=""/>
        <dsp:cNvSpPr/>
      </dsp:nvSpPr>
      <dsp:spPr>
        <a:xfrm>
          <a:off x="10463614" y="3894464"/>
          <a:ext cx="1004922" cy="239125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62957"/>
              </a:lnTo>
              <a:lnTo>
                <a:pt x="1004922" y="162957"/>
              </a:lnTo>
              <a:lnTo>
                <a:pt x="1004922" y="239125"/>
              </a:lnTo>
            </a:path>
          </a:pathLst>
        </a:custGeom>
        <a:noFill/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</dsp:sp>
    <dsp:sp modelId="{5D2FC06B-85C4-4578-8CD9-0BCDF54D2D73}">
      <dsp:nvSpPr>
        <dsp:cNvPr id="0" name=""/>
        <dsp:cNvSpPr/>
      </dsp:nvSpPr>
      <dsp:spPr>
        <a:xfrm>
          <a:off x="10417894" y="3894464"/>
          <a:ext cx="91440" cy="239125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239125"/>
              </a:lnTo>
            </a:path>
          </a:pathLst>
        </a:custGeom>
        <a:noFill/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</dsp:sp>
    <dsp:sp modelId="{2CA1E815-1B54-418A-AA5F-C2F89903A4A4}">
      <dsp:nvSpPr>
        <dsp:cNvPr id="0" name=""/>
        <dsp:cNvSpPr/>
      </dsp:nvSpPr>
      <dsp:spPr>
        <a:xfrm>
          <a:off x="9458691" y="3894464"/>
          <a:ext cx="1004922" cy="239125"/>
        </a:xfrm>
        <a:custGeom>
          <a:avLst/>
          <a:gdLst/>
          <a:ahLst/>
          <a:cxnLst/>
          <a:rect l="0" t="0" r="0" b="0"/>
          <a:pathLst>
            <a:path>
              <a:moveTo>
                <a:pt x="1004922" y="0"/>
              </a:moveTo>
              <a:lnTo>
                <a:pt x="1004922" y="162957"/>
              </a:lnTo>
              <a:lnTo>
                <a:pt x="0" y="162957"/>
              </a:lnTo>
              <a:lnTo>
                <a:pt x="0" y="239125"/>
              </a:lnTo>
            </a:path>
          </a:pathLst>
        </a:custGeom>
        <a:noFill/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</dsp:sp>
    <dsp:sp modelId="{8A0152D2-DA54-4DBB-8107-22485DFBED20}">
      <dsp:nvSpPr>
        <dsp:cNvPr id="0" name=""/>
        <dsp:cNvSpPr/>
      </dsp:nvSpPr>
      <dsp:spPr>
        <a:xfrm>
          <a:off x="8961417" y="3133236"/>
          <a:ext cx="1502197" cy="239125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62957"/>
              </a:lnTo>
              <a:lnTo>
                <a:pt x="1502197" y="162957"/>
              </a:lnTo>
              <a:lnTo>
                <a:pt x="1502197" y="239125"/>
              </a:lnTo>
            </a:path>
          </a:pathLst>
        </a:custGeom>
        <a:noFill/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</dsp:sp>
    <dsp:sp modelId="{0EA5458F-EC01-42C8-A919-83F455905C5D}">
      <dsp:nvSpPr>
        <dsp:cNvPr id="0" name=""/>
        <dsp:cNvSpPr/>
      </dsp:nvSpPr>
      <dsp:spPr>
        <a:xfrm>
          <a:off x="7448847" y="3894464"/>
          <a:ext cx="1004922" cy="239125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62957"/>
              </a:lnTo>
              <a:lnTo>
                <a:pt x="1004922" y="162957"/>
              </a:lnTo>
              <a:lnTo>
                <a:pt x="1004922" y="239125"/>
              </a:lnTo>
            </a:path>
          </a:pathLst>
        </a:custGeom>
        <a:noFill/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</dsp:sp>
    <dsp:sp modelId="{381B9CD4-1D79-49CF-9253-8E82403AB37C}">
      <dsp:nvSpPr>
        <dsp:cNvPr id="0" name=""/>
        <dsp:cNvSpPr/>
      </dsp:nvSpPr>
      <dsp:spPr>
        <a:xfrm>
          <a:off x="7403127" y="3894464"/>
          <a:ext cx="91440" cy="239125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239125"/>
              </a:lnTo>
            </a:path>
          </a:pathLst>
        </a:custGeom>
        <a:noFill/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</dsp:sp>
    <dsp:sp modelId="{514934A7-0531-406F-8444-2D12F94C5393}">
      <dsp:nvSpPr>
        <dsp:cNvPr id="0" name=""/>
        <dsp:cNvSpPr/>
      </dsp:nvSpPr>
      <dsp:spPr>
        <a:xfrm>
          <a:off x="6443925" y="3894464"/>
          <a:ext cx="1004922" cy="239125"/>
        </a:xfrm>
        <a:custGeom>
          <a:avLst/>
          <a:gdLst/>
          <a:ahLst/>
          <a:cxnLst/>
          <a:rect l="0" t="0" r="0" b="0"/>
          <a:pathLst>
            <a:path>
              <a:moveTo>
                <a:pt x="1004922" y="0"/>
              </a:moveTo>
              <a:lnTo>
                <a:pt x="1004922" y="162957"/>
              </a:lnTo>
              <a:lnTo>
                <a:pt x="0" y="162957"/>
              </a:lnTo>
              <a:lnTo>
                <a:pt x="0" y="239125"/>
              </a:lnTo>
            </a:path>
          </a:pathLst>
        </a:custGeom>
        <a:noFill/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</dsp:sp>
    <dsp:sp modelId="{5035B9DA-AD92-4068-9FA2-E074456674CE}">
      <dsp:nvSpPr>
        <dsp:cNvPr id="0" name=""/>
        <dsp:cNvSpPr/>
      </dsp:nvSpPr>
      <dsp:spPr>
        <a:xfrm>
          <a:off x="7448847" y="3133236"/>
          <a:ext cx="1512569" cy="239125"/>
        </a:xfrm>
        <a:custGeom>
          <a:avLst/>
          <a:gdLst/>
          <a:ahLst/>
          <a:cxnLst/>
          <a:rect l="0" t="0" r="0" b="0"/>
          <a:pathLst>
            <a:path>
              <a:moveTo>
                <a:pt x="1512569" y="0"/>
              </a:moveTo>
              <a:lnTo>
                <a:pt x="1512569" y="162957"/>
              </a:lnTo>
              <a:lnTo>
                <a:pt x="0" y="162957"/>
              </a:lnTo>
              <a:lnTo>
                <a:pt x="0" y="239125"/>
              </a:lnTo>
            </a:path>
          </a:pathLst>
        </a:custGeom>
        <a:noFill/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</dsp:sp>
    <dsp:sp modelId="{6B7E7703-4CBD-4EF0-92DF-960E1C376C3D}">
      <dsp:nvSpPr>
        <dsp:cNvPr id="0" name=""/>
        <dsp:cNvSpPr/>
      </dsp:nvSpPr>
      <dsp:spPr>
        <a:xfrm>
          <a:off x="5991165" y="2372007"/>
          <a:ext cx="2970251" cy="239125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62957"/>
              </a:lnTo>
              <a:lnTo>
                <a:pt x="2970251" y="162957"/>
              </a:lnTo>
              <a:lnTo>
                <a:pt x="2970251" y="239125"/>
              </a:lnTo>
            </a:path>
          </a:pathLst>
        </a:custGeom>
        <a:noFill/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</dsp:sp>
    <dsp:sp modelId="{A12B5581-E817-4595-9EC3-F125D651CF57}">
      <dsp:nvSpPr>
        <dsp:cNvPr id="0" name=""/>
        <dsp:cNvSpPr/>
      </dsp:nvSpPr>
      <dsp:spPr>
        <a:xfrm>
          <a:off x="4434081" y="3894464"/>
          <a:ext cx="1004922" cy="239125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62957"/>
              </a:lnTo>
              <a:lnTo>
                <a:pt x="1004922" y="162957"/>
              </a:lnTo>
              <a:lnTo>
                <a:pt x="1004922" y="239125"/>
              </a:lnTo>
            </a:path>
          </a:pathLst>
        </a:custGeom>
        <a:noFill/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</dsp:sp>
    <dsp:sp modelId="{89289DB7-0E13-4434-BB61-4276BB77D10B}">
      <dsp:nvSpPr>
        <dsp:cNvPr id="0" name=""/>
        <dsp:cNvSpPr/>
      </dsp:nvSpPr>
      <dsp:spPr>
        <a:xfrm>
          <a:off x="4388361" y="3894464"/>
          <a:ext cx="91440" cy="239125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239125"/>
              </a:lnTo>
            </a:path>
          </a:pathLst>
        </a:custGeom>
        <a:noFill/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</dsp:sp>
    <dsp:sp modelId="{5E7E06BD-DE2E-40D3-8FF0-FC211521CD4F}">
      <dsp:nvSpPr>
        <dsp:cNvPr id="0" name=""/>
        <dsp:cNvSpPr/>
      </dsp:nvSpPr>
      <dsp:spPr>
        <a:xfrm>
          <a:off x="3429159" y="3894464"/>
          <a:ext cx="1004922" cy="239125"/>
        </a:xfrm>
        <a:custGeom>
          <a:avLst/>
          <a:gdLst/>
          <a:ahLst/>
          <a:cxnLst/>
          <a:rect l="0" t="0" r="0" b="0"/>
          <a:pathLst>
            <a:path>
              <a:moveTo>
                <a:pt x="1004922" y="0"/>
              </a:moveTo>
              <a:lnTo>
                <a:pt x="1004922" y="162957"/>
              </a:lnTo>
              <a:lnTo>
                <a:pt x="0" y="162957"/>
              </a:lnTo>
              <a:lnTo>
                <a:pt x="0" y="239125"/>
              </a:lnTo>
            </a:path>
          </a:pathLst>
        </a:custGeom>
        <a:noFill/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</dsp:sp>
    <dsp:sp modelId="{62C5452C-9150-47E4-A9D0-D8F29A94BF1C}">
      <dsp:nvSpPr>
        <dsp:cNvPr id="0" name=""/>
        <dsp:cNvSpPr/>
      </dsp:nvSpPr>
      <dsp:spPr>
        <a:xfrm>
          <a:off x="2969685" y="3133236"/>
          <a:ext cx="1464395" cy="239125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62957"/>
              </a:lnTo>
              <a:lnTo>
                <a:pt x="1464395" y="162957"/>
              </a:lnTo>
              <a:lnTo>
                <a:pt x="1464395" y="239125"/>
              </a:lnTo>
            </a:path>
          </a:pathLst>
        </a:custGeom>
        <a:noFill/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</dsp:sp>
    <dsp:sp modelId="{224C7AFB-EFC6-4969-A7C0-594DF5C1F756}">
      <dsp:nvSpPr>
        <dsp:cNvPr id="0" name=""/>
        <dsp:cNvSpPr/>
      </dsp:nvSpPr>
      <dsp:spPr>
        <a:xfrm>
          <a:off x="1419315" y="3894464"/>
          <a:ext cx="1004922" cy="239125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62957"/>
              </a:lnTo>
              <a:lnTo>
                <a:pt x="1004922" y="162957"/>
              </a:lnTo>
              <a:lnTo>
                <a:pt x="1004922" y="239125"/>
              </a:lnTo>
            </a:path>
          </a:pathLst>
        </a:custGeom>
        <a:noFill/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</dsp:sp>
    <dsp:sp modelId="{8DCF3E0D-EDCC-4246-B500-CBA6C0293F45}">
      <dsp:nvSpPr>
        <dsp:cNvPr id="0" name=""/>
        <dsp:cNvSpPr/>
      </dsp:nvSpPr>
      <dsp:spPr>
        <a:xfrm>
          <a:off x="1373595" y="3894464"/>
          <a:ext cx="91440" cy="239125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239125"/>
              </a:lnTo>
            </a:path>
          </a:pathLst>
        </a:custGeom>
        <a:noFill/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</dsp:sp>
    <dsp:sp modelId="{5859CEB4-C93E-4FB0-A2E0-8EC5AD91AE86}">
      <dsp:nvSpPr>
        <dsp:cNvPr id="0" name=""/>
        <dsp:cNvSpPr/>
      </dsp:nvSpPr>
      <dsp:spPr>
        <a:xfrm>
          <a:off x="414393" y="3894464"/>
          <a:ext cx="1004922" cy="239125"/>
        </a:xfrm>
        <a:custGeom>
          <a:avLst/>
          <a:gdLst/>
          <a:ahLst/>
          <a:cxnLst/>
          <a:rect l="0" t="0" r="0" b="0"/>
          <a:pathLst>
            <a:path>
              <a:moveTo>
                <a:pt x="1004922" y="0"/>
              </a:moveTo>
              <a:lnTo>
                <a:pt x="1004922" y="162957"/>
              </a:lnTo>
              <a:lnTo>
                <a:pt x="0" y="162957"/>
              </a:lnTo>
              <a:lnTo>
                <a:pt x="0" y="239125"/>
              </a:lnTo>
            </a:path>
          </a:pathLst>
        </a:custGeom>
        <a:noFill/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</dsp:sp>
    <dsp:sp modelId="{01505EC1-C6BB-4A03-A691-B7B56C6803A3}">
      <dsp:nvSpPr>
        <dsp:cNvPr id="0" name=""/>
        <dsp:cNvSpPr/>
      </dsp:nvSpPr>
      <dsp:spPr>
        <a:xfrm>
          <a:off x="1419315" y="3133236"/>
          <a:ext cx="1550370" cy="239125"/>
        </a:xfrm>
        <a:custGeom>
          <a:avLst/>
          <a:gdLst/>
          <a:ahLst/>
          <a:cxnLst/>
          <a:rect l="0" t="0" r="0" b="0"/>
          <a:pathLst>
            <a:path>
              <a:moveTo>
                <a:pt x="1550370" y="0"/>
              </a:moveTo>
              <a:lnTo>
                <a:pt x="1550370" y="162957"/>
              </a:lnTo>
              <a:lnTo>
                <a:pt x="0" y="162957"/>
              </a:lnTo>
              <a:lnTo>
                <a:pt x="0" y="239125"/>
              </a:lnTo>
            </a:path>
          </a:pathLst>
        </a:custGeom>
        <a:noFill/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</dsp:sp>
    <dsp:sp modelId="{0F83E8E0-FBCA-48D3-89A9-716E3BD7259E}">
      <dsp:nvSpPr>
        <dsp:cNvPr id="0" name=""/>
        <dsp:cNvSpPr/>
      </dsp:nvSpPr>
      <dsp:spPr>
        <a:xfrm>
          <a:off x="2969685" y="2372007"/>
          <a:ext cx="3021479" cy="239125"/>
        </a:xfrm>
        <a:custGeom>
          <a:avLst/>
          <a:gdLst/>
          <a:ahLst/>
          <a:cxnLst/>
          <a:rect l="0" t="0" r="0" b="0"/>
          <a:pathLst>
            <a:path>
              <a:moveTo>
                <a:pt x="3021479" y="0"/>
              </a:moveTo>
              <a:lnTo>
                <a:pt x="3021479" y="162957"/>
              </a:lnTo>
              <a:lnTo>
                <a:pt x="0" y="162957"/>
              </a:lnTo>
              <a:lnTo>
                <a:pt x="0" y="239125"/>
              </a:lnTo>
            </a:path>
          </a:pathLst>
        </a:custGeom>
        <a:noFill/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</dsp:sp>
    <dsp:sp modelId="{B86B6C38-1EA5-42F9-A2F5-D56D42BC74CC}">
      <dsp:nvSpPr>
        <dsp:cNvPr id="0" name=""/>
        <dsp:cNvSpPr/>
      </dsp:nvSpPr>
      <dsp:spPr>
        <a:xfrm>
          <a:off x="4697896" y="1849905"/>
          <a:ext cx="2586537" cy="522102"/>
        </a:xfrm>
        <a:prstGeom prst="roundRect">
          <a:avLst>
            <a:gd name="adj" fmla="val 10000"/>
          </a:avLst>
        </a:prstGeom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</dsp:sp>
    <dsp:sp modelId="{9A3FB502-E9FE-4A87-B7A2-97A20E62DC1B}">
      <dsp:nvSpPr>
        <dsp:cNvPr id="0" name=""/>
        <dsp:cNvSpPr/>
      </dsp:nvSpPr>
      <dsp:spPr>
        <a:xfrm>
          <a:off x="4789252" y="1936693"/>
          <a:ext cx="2586537" cy="522102"/>
        </a:xfrm>
        <a:prstGeom prst="roundRect">
          <a:avLst>
            <a:gd name="adj" fmla="val 10000"/>
          </a:avLst>
        </a:prstGeom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lvl="0" algn="ctr" defTabSz="444500" rtl="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>
              <a:cs typeface="+mj-cs"/>
            </a:rPr>
            <a:t> Umbilical Hernias</a:t>
          </a:r>
        </a:p>
        <a:p>
          <a:pPr lvl="0" algn="ctr" defTabSz="444500" rtl="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smtClean="0">
              <a:cs typeface="+mj-cs"/>
            </a:rPr>
            <a:t>267 calves</a:t>
          </a:r>
          <a:r>
            <a:rPr lang="en-US" sz="1000" kern="1200" dirty="0" smtClean="0">
              <a:cs typeface="+mj-cs"/>
            </a:rPr>
            <a:t/>
          </a:r>
          <a:br>
            <a:rPr lang="en-US" sz="1000" kern="1200" dirty="0" smtClean="0">
              <a:cs typeface="+mj-cs"/>
            </a:rPr>
          </a:br>
          <a:r>
            <a:rPr lang="en-US" sz="1000" kern="1200" dirty="0" smtClean="0">
              <a:cs typeface="+mj-cs"/>
            </a:rPr>
            <a:t>(Husbandry system)</a:t>
          </a:r>
          <a:endParaRPr lang="en-US" sz="1000" kern="1200" dirty="0">
            <a:cs typeface="+mj-cs"/>
          </a:endParaRPr>
        </a:p>
      </dsp:txBody>
      <dsp:txXfrm>
        <a:off x="4804544" y="1951985"/>
        <a:ext cx="2555953" cy="491518"/>
      </dsp:txXfrm>
    </dsp:sp>
    <dsp:sp modelId="{85DC020B-8793-4E48-BDD0-59483AE3BE28}">
      <dsp:nvSpPr>
        <dsp:cNvPr id="0" name=""/>
        <dsp:cNvSpPr/>
      </dsp:nvSpPr>
      <dsp:spPr>
        <a:xfrm>
          <a:off x="2235432" y="2611133"/>
          <a:ext cx="1468506" cy="522102"/>
        </a:xfrm>
        <a:prstGeom prst="roundRect">
          <a:avLst>
            <a:gd name="adj" fmla="val 10000"/>
          </a:avLst>
        </a:prstGeom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</dsp:sp>
    <dsp:sp modelId="{DA4503CF-7324-420D-949A-A9ADB4B56557}">
      <dsp:nvSpPr>
        <dsp:cNvPr id="0" name=""/>
        <dsp:cNvSpPr/>
      </dsp:nvSpPr>
      <dsp:spPr>
        <a:xfrm>
          <a:off x="2326789" y="2697922"/>
          <a:ext cx="1468506" cy="522102"/>
        </a:xfrm>
        <a:prstGeom prst="roundRect">
          <a:avLst>
            <a:gd name="adj" fmla="val 10000"/>
          </a:avLst>
        </a:prstGeom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lvl="0" algn="ctr" defTabSz="444500" rtl="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>
              <a:cs typeface="+mj-cs"/>
            </a:rPr>
            <a:t>Range 255 (95.5%)</a:t>
          </a:r>
        </a:p>
      </dsp:txBody>
      <dsp:txXfrm>
        <a:off x="2342081" y="2713214"/>
        <a:ext cx="1437922" cy="491518"/>
      </dsp:txXfrm>
    </dsp:sp>
    <dsp:sp modelId="{A89D4233-94D6-4570-96E9-4153E0AE9554}">
      <dsp:nvSpPr>
        <dsp:cNvPr id="0" name=""/>
        <dsp:cNvSpPr/>
      </dsp:nvSpPr>
      <dsp:spPr>
        <a:xfrm>
          <a:off x="854079" y="3372362"/>
          <a:ext cx="1130471" cy="522102"/>
        </a:xfrm>
        <a:prstGeom prst="roundRect">
          <a:avLst>
            <a:gd name="adj" fmla="val 10000"/>
          </a:avLst>
        </a:prstGeom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</dsp:sp>
    <dsp:sp modelId="{9DF54347-2A12-4809-AACE-6706A932FCBD}">
      <dsp:nvSpPr>
        <dsp:cNvPr id="0" name=""/>
        <dsp:cNvSpPr/>
      </dsp:nvSpPr>
      <dsp:spPr>
        <a:xfrm>
          <a:off x="945436" y="3459150"/>
          <a:ext cx="1130471" cy="522102"/>
        </a:xfrm>
        <a:prstGeom prst="roundRect">
          <a:avLst>
            <a:gd name="adj" fmla="val 10000"/>
          </a:avLst>
        </a:prstGeom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lvl="0" algn="ctr" defTabSz="444500" rtl="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>
              <a:cs typeface="+mj-cs"/>
            </a:rPr>
            <a:t>Simple 220 (86%)</a:t>
          </a:r>
        </a:p>
      </dsp:txBody>
      <dsp:txXfrm>
        <a:off x="960728" y="3474442"/>
        <a:ext cx="1099887" cy="491518"/>
      </dsp:txXfrm>
    </dsp:sp>
    <dsp:sp modelId="{7380D38D-EDC3-4B3C-8496-B444B2B782D3}">
      <dsp:nvSpPr>
        <dsp:cNvPr id="0" name=""/>
        <dsp:cNvSpPr/>
      </dsp:nvSpPr>
      <dsp:spPr>
        <a:xfrm>
          <a:off x="3288" y="4133590"/>
          <a:ext cx="822208" cy="522102"/>
        </a:xfrm>
        <a:prstGeom prst="roundRect">
          <a:avLst>
            <a:gd name="adj" fmla="val 10000"/>
          </a:avLst>
        </a:prstGeom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</dsp:sp>
    <dsp:sp modelId="{52D058CF-23E0-4170-85BD-794F8B908DBC}">
      <dsp:nvSpPr>
        <dsp:cNvPr id="0" name=""/>
        <dsp:cNvSpPr/>
      </dsp:nvSpPr>
      <dsp:spPr>
        <a:xfrm>
          <a:off x="94645" y="4220379"/>
          <a:ext cx="822208" cy="522102"/>
        </a:xfrm>
        <a:prstGeom prst="roundRect">
          <a:avLst>
            <a:gd name="adj" fmla="val 10000"/>
          </a:avLst>
        </a:prstGeom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lvl="0" algn="ctr" defTabSz="444500" rtl="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>
              <a:cs typeface="+mj-cs"/>
            </a:rPr>
            <a:t>Holstein</a:t>
          </a:r>
        </a:p>
        <a:p>
          <a:pPr lvl="0" algn="ctr" defTabSz="444500" rtl="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>
              <a:cs typeface="+mj-cs"/>
            </a:rPr>
            <a:t>188 (85%)</a:t>
          </a:r>
          <a:endParaRPr lang="en-US" sz="1000" kern="1200" dirty="0">
            <a:cs typeface="+mj-cs"/>
          </a:endParaRPr>
        </a:p>
      </dsp:txBody>
      <dsp:txXfrm>
        <a:off x="109937" y="4235671"/>
        <a:ext cx="791624" cy="491518"/>
      </dsp:txXfrm>
    </dsp:sp>
    <dsp:sp modelId="{BDE80D1C-FF7C-4B6A-860E-317787A645EA}">
      <dsp:nvSpPr>
        <dsp:cNvPr id="0" name=""/>
        <dsp:cNvSpPr/>
      </dsp:nvSpPr>
      <dsp:spPr>
        <a:xfrm>
          <a:off x="1008210" y="4133590"/>
          <a:ext cx="822208" cy="522102"/>
        </a:xfrm>
        <a:prstGeom prst="roundRect">
          <a:avLst>
            <a:gd name="adj" fmla="val 10000"/>
          </a:avLst>
        </a:prstGeom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</dsp:sp>
    <dsp:sp modelId="{8F9CB4A8-6BB4-4568-B5FA-93236D5DC3C2}">
      <dsp:nvSpPr>
        <dsp:cNvPr id="0" name=""/>
        <dsp:cNvSpPr/>
      </dsp:nvSpPr>
      <dsp:spPr>
        <a:xfrm>
          <a:off x="1099567" y="4220379"/>
          <a:ext cx="822208" cy="522102"/>
        </a:xfrm>
        <a:prstGeom prst="roundRect">
          <a:avLst>
            <a:gd name="adj" fmla="val 10000"/>
          </a:avLst>
        </a:prstGeom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lvl="0" algn="ctr" defTabSz="444500" rtl="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>
              <a:cs typeface="+mj-cs"/>
            </a:rPr>
            <a:t>Native</a:t>
          </a:r>
        </a:p>
        <a:p>
          <a:pPr lvl="0" algn="ctr" defTabSz="444500" rtl="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>
              <a:cs typeface="+mj-cs"/>
            </a:rPr>
            <a:t>21 (10%)</a:t>
          </a:r>
          <a:endParaRPr lang="en-US" sz="1000" kern="1200" dirty="0">
            <a:cs typeface="+mj-cs"/>
          </a:endParaRPr>
        </a:p>
      </dsp:txBody>
      <dsp:txXfrm>
        <a:off x="1114859" y="4235671"/>
        <a:ext cx="791624" cy="491518"/>
      </dsp:txXfrm>
    </dsp:sp>
    <dsp:sp modelId="{7C0C4BDE-CCDA-42F6-9D3C-32057049B235}">
      <dsp:nvSpPr>
        <dsp:cNvPr id="0" name=""/>
        <dsp:cNvSpPr/>
      </dsp:nvSpPr>
      <dsp:spPr>
        <a:xfrm>
          <a:off x="2013132" y="4133590"/>
          <a:ext cx="822208" cy="522102"/>
        </a:xfrm>
        <a:prstGeom prst="roundRect">
          <a:avLst>
            <a:gd name="adj" fmla="val 10000"/>
          </a:avLst>
        </a:prstGeom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</dsp:sp>
    <dsp:sp modelId="{0B370476-F647-48C4-92F7-EFAD0F281B39}">
      <dsp:nvSpPr>
        <dsp:cNvPr id="0" name=""/>
        <dsp:cNvSpPr/>
      </dsp:nvSpPr>
      <dsp:spPr>
        <a:xfrm>
          <a:off x="2104489" y="4220379"/>
          <a:ext cx="822208" cy="522102"/>
        </a:xfrm>
        <a:prstGeom prst="roundRect">
          <a:avLst>
            <a:gd name="adj" fmla="val 10000"/>
          </a:avLst>
        </a:prstGeom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lvl="0" algn="ctr" defTabSz="444500" rtl="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>
              <a:cs typeface="+mj-cs"/>
            </a:rPr>
            <a:t>Others</a:t>
          </a:r>
        </a:p>
        <a:p>
          <a:pPr lvl="0" algn="ctr" defTabSz="444500" rtl="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>
              <a:cs typeface="+mj-cs"/>
            </a:rPr>
            <a:t>11 (5%)</a:t>
          </a:r>
          <a:endParaRPr lang="en-US" sz="1000" kern="1200" dirty="0">
            <a:cs typeface="+mj-cs"/>
          </a:endParaRPr>
        </a:p>
      </dsp:txBody>
      <dsp:txXfrm>
        <a:off x="2119781" y="4235671"/>
        <a:ext cx="791624" cy="491518"/>
      </dsp:txXfrm>
    </dsp:sp>
    <dsp:sp modelId="{728A4A9E-147B-4685-8298-B02A1D7F35E7}">
      <dsp:nvSpPr>
        <dsp:cNvPr id="0" name=""/>
        <dsp:cNvSpPr/>
      </dsp:nvSpPr>
      <dsp:spPr>
        <a:xfrm>
          <a:off x="3782871" y="3372362"/>
          <a:ext cx="1302420" cy="522102"/>
        </a:xfrm>
        <a:prstGeom prst="roundRect">
          <a:avLst>
            <a:gd name="adj" fmla="val 10000"/>
          </a:avLst>
        </a:prstGeom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</dsp:sp>
    <dsp:sp modelId="{FEDF974C-2D37-48B2-8380-3C7A241028C8}">
      <dsp:nvSpPr>
        <dsp:cNvPr id="0" name=""/>
        <dsp:cNvSpPr/>
      </dsp:nvSpPr>
      <dsp:spPr>
        <a:xfrm>
          <a:off x="3874228" y="3459150"/>
          <a:ext cx="1302420" cy="522102"/>
        </a:xfrm>
        <a:prstGeom prst="roundRect">
          <a:avLst>
            <a:gd name="adj" fmla="val 10000"/>
          </a:avLst>
        </a:prstGeom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lvl="0" algn="ctr" defTabSz="444500" rtl="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>
              <a:cs typeface="+mj-cs"/>
            </a:rPr>
            <a:t>Complicated 35 (14%)</a:t>
          </a:r>
          <a:endParaRPr lang="en-US" sz="1000" kern="1200" dirty="0">
            <a:cs typeface="+mj-cs"/>
          </a:endParaRPr>
        </a:p>
      </dsp:txBody>
      <dsp:txXfrm>
        <a:off x="3889520" y="3474442"/>
        <a:ext cx="1271836" cy="491518"/>
      </dsp:txXfrm>
    </dsp:sp>
    <dsp:sp modelId="{87F3E96A-9184-487D-A9E8-C7ECE40AE56F}">
      <dsp:nvSpPr>
        <dsp:cNvPr id="0" name=""/>
        <dsp:cNvSpPr/>
      </dsp:nvSpPr>
      <dsp:spPr>
        <a:xfrm>
          <a:off x="3018055" y="4133590"/>
          <a:ext cx="822208" cy="522102"/>
        </a:xfrm>
        <a:prstGeom prst="roundRect">
          <a:avLst>
            <a:gd name="adj" fmla="val 10000"/>
          </a:avLst>
        </a:prstGeom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</dsp:sp>
    <dsp:sp modelId="{1E113764-AC88-46F8-8C69-71913DC3F1AC}">
      <dsp:nvSpPr>
        <dsp:cNvPr id="0" name=""/>
        <dsp:cNvSpPr/>
      </dsp:nvSpPr>
      <dsp:spPr>
        <a:xfrm>
          <a:off x="3109411" y="4220379"/>
          <a:ext cx="822208" cy="522102"/>
        </a:xfrm>
        <a:prstGeom prst="roundRect">
          <a:avLst>
            <a:gd name="adj" fmla="val 10000"/>
          </a:avLst>
        </a:prstGeom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lvl="0" algn="ctr" defTabSz="444500" rtl="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>
              <a:cs typeface="+mj-cs"/>
            </a:rPr>
            <a:t>Holstein</a:t>
          </a:r>
        </a:p>
        <a:p>
          <a:pPr lvl="0" algn="ctr" defTabSz="444500" rtl="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>
              <a:cs typeface="+mj-cs"/>
            </a:rPr>
            <a:t>28 (80%)</a:t>
          </a:r>
          <a:endParaRPr lang="en-US" sz="1000" kern="1200" dirty="0">
            <a:cs typeface="+mj-cs"/>
          </a:endParaRPr>
        </a:p>
      </dsp:txBody>
      <dsp:txXfrm>
        <a:off x="3124703" y="4235671"/>
        <a:ext cx="791624" cy="491518"/>
      </dsp:txXfrm>
    </dsp:sp>
    <dsp:sp modelId="{78353A0F-6FE0-4847-A281-52CC821EE4B6}">
      <dsp:nvSpPr>
        <dsp:cNvPr id="0" name=""/>
        <dsp:cNvSpPr/>
      </dsp:nvSpPr>
      <dsp:spPr>
        <a:xfrm>
          <a:off x="4022977" y="4133590"/>
          <a:ext cx="822208" cy="522102"/>
        </a:xfrm>
        <a:prstGeom prst="roundRect">
          <a:avLst>
            <a:gd name="adj" fmla="val 10000"/>
          </a:avLst>
        </a:prstGeom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</dsp:sp>
    <dsp:sp modelId="{F5E0BE3A-20F2-46FD-87E9-3EFF6A3D06DA}">
      <dsp:nvSpPr>
        <dsp:cNvPr id="0" name=""/>
        <dsp:cNvSpPr/>
      </dsp:nvSpPr>
      <dsp:spPr>
        <a:xfrm>
          <a:off x="4114333" y="4220379"/>
          <a:ext cx="822208" cy="522102"/>
        </a:xfrm>
        <a:prstGeom prst="roundRect">
          <a:avLst>
            <a:gd name="adj" fmla="val 10000"/>
          </a:avLst>
        </a:prstGeom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lvl="0" algn="ctr" defTabSz="444500" rtl="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>
              <a:cs typeface="+mj-cs"/>
            </a:rPr>
            <a:t>Native</a:t>
          </a:r>
        </a:p>
        <a:p>
          <a:pPr lvl="0" algn="ctr" defTabSz="444500" rtl="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>
              <a:cs typeface="+mj-cs"/>
            </a:rPr>
            <a:t>5 (14%)</a:t>
          </a:r>
          <a:endParaRPr lang="en-US" sz="1000" kern="1200" dirty="0">
            <a:cs typeface="+mj-cs"/>
          </a:endParaRPr>
        </a:p>
      </dsp:txBody>
      <dsp:txXfrm>
        <a:off x="4129625" y="4235671"/>
        <a:ext cx="791624" cy="491518"/>
      </dsp:txXfrm>
    </dsp:sp>
    <dsp:sp modelId="{8D345DFC-9463-412A-9124-127DCD7D9959}">
      <dsp:nvSpPr>
        <dsp:cNvPr id="0" name=""/>
        <dsp:cNvSpPr/>
      </dsp:nvSpPr>
      <dsp:spPr>
        <a:xfrm>
          <a:off x="5027899" y="4133590"/>
          <a:ext cx="822208" cy="522102"/>
        </a:xfrm>
        <a:prstGeom prst="roundRect">
          <a:avLst>
            <a:gd name="adj" fmla="val 10000"/>
          </a:avLst>
        </a:prstGeom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</dsp:sp>
    <dsp:sp modelId="{F42F99AC-F994-4ECA-A1A2-88DDB335B4F0}">
      <dsp:nvSpPr>
        <dsp:cNvPr id="0" name=""/>
        <dsp:cNvSpPr/>
      </dsp:nvSpPr>
      <dsp:spPr>
        <a:xfrm>
          <a:off x="5119255" y="4220379"/>
          <a:ext cx="822208" cy="522102"/>
        </a:xfrm>
        <a:prstGeom prst="roundRect">
          <a:avLst>
            <a:gd name="adj" fmla="val 10000"/>
          </a:avLst>
        </a:prstGeom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lvl="0" algn="ctr" defTabSz="444500" rtl="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>
              <a:cs typeface="+mj-cs"/>
            </a:rPr>
            <a:t>Others</a:t>
          </a:r>
        </a:p>
        <a:p>
          <a:pPr lvl="0" algn="ctr" defTabSz="444500" rtl="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>
              <a:cs typeface="+mj-cs"/>
            </a:rPr>
            <a:t>2 (6%)</a:t>
          </a:r>
          <a:endParaRPr lang="en-US" sz="1000" kern="1200" dirty="0">
            <a:cs typeface="+mj-cs"/>
          </a:endParaRPr>
        </a:p>
      </dsp:txBody>
      <dsp:txXfrm>
        <a:off x="5134547" y="4235671"/>
        <a:ext cx="791624" cy="491518"/>
      </dsp:txXfrm>
    </dsp:sp>
    <dsp:sp modelId="{B0D02396-8B89-45C2-8AC2-36F3D63187CD}">
      <dsp:nvSpPr>
        <dsp:cNvPr id="0" name=""/>
        <dsp:cNvSpPr/>
      </dsp:nvSpPr>
      <dsp:spPr>
        <a:xfrm>
          <a:off x="8175936" y="2611133"/>
          <a:ext cx="1570961" cy="522102"/>
        </a:xfrm>
        <a:prstGeom prst="roundRect">
          <a:avLst>
            <a:gd name="adj" fmla="val 10000"/>
          </a:avLst>
        </a:prstGeom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</dsp:sp>
    <dsp:sp modelId="{14E36AB6-049D-4632-BB1C-F9F633A2FC42}">
      <dsp:nvSpPr>
        <dsp:cNvPr id="0" name=""/>
        <dsp:cNvSpPr/>
      </dsp:nvSpPr>
      <dsp:spPr>
        <a:xfrm>
          <a:off x="8267292" y="2697922"/>
          <a:ext cx="1570961" cy="522102"/>
        </a:xfrm>
        <a:prstGeom prst="roundRect">
          <a:avLst>
            <a:gd name="adj" fmla="val 10000"/>
          </a:avLst>
        </a:prstGeom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lvl="0" algn="ctr" defTabSz="444500" rtl="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>
              <a:cs typeface="+mj-cs"/>
            </a:rPr>
            <a:t>Smallholder 12 (4.5%) </a:t>
          </a:r>
        </a:p>
      </dsp:txBody>
      <dsp:txXfrm>
        <a:off x="8282584" y="2713214"/>
        <a:ext cx="1540377" cy="491518"/>
      </dsp:txXfrm>
    </dsp:sp>
    <dsp:sp modelId="{3B0F15E5-BC52-4328-95A4-A69A94BBA697}">
      <dsp:nvSpPr>
        <dsp:cNvPr id="0" name=""/>
        <dsp:cNvSpPr/>
      </dsp:nvSpPr>
      <dsp:spPr>
        <a:xfrm>
          <a:off x="6862863" y="3372362"/>
          <a:ext cx="1171968" cy="522102"/>
        </a:xfrm>
        <a:prstGeom prst="roundRect">
          <a:avLst>
            <a:gd name="adj" fmla="val 10000"/>
          </a:avLst>
        </a:prstGeom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</dsp:sp>
    <dsp:sp modelId="{C5BC661E-CF8F-49BE-ADB4-818ACAE05F51}">
      <dsp:nvSpPr>
        <dsp:cNvPr id="0" name=""/>
        <dsp:cNvSpPr/>
      </dsp:nvSpPr>
      <dsp:spPr>
        <a:xfrm>
          <a:off x="6954220" y="3459150"/>
          <a:ext cx="1171968" cy="522102"/>
        </a:xfrm>
        <a:prstGeom prst="roundRect">
          <a:avLst>
            <a:gd name="adj" fmla="val 10000"/>
          </a:avLst>
        </a:prstGeom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lvl="0" algn="ctr" defTabSz="444500" rtl="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>
              <a:cs typeface="+mj-cs"/>
            </a:rPr>
            <a:t>Simple 9 (75%)</a:t>
          </a:r>
          <a:endParaRPr lang="en-US" sz="1000" kern="1200" dirty="0">
            <a:cs typeface="+mj-cs"/>
          </a:endParaRPr>
        </a:p>
      </dsp:txBody>
      <dsp:txXfrm>
        <a:off x="6969512" y="3474442"/>
        <a:ext cx="1141384" cy="491518"/>
      </dsp:txXfrm>
    </dsp:sp>
    <dsp:sp modelId="{D7E8AD84-9A55-412F-959B-0B9AE1301B6D}">
      <dsp:nvSpPr>
        <dsp:cNvPr id="0" name=""/>
        <dsp:cNvSpPr/>
      </dsp:nvSpPr>
      <dsp:spPr>
        <a:xfrm>
          <a:off x="6032821" y="4133590"/>
          <a:ext cx="822208" cy="522102"/>
        </a:xfrm>
        <a:prstGeom prst="roundRect">
          <a:avLst>
            <a:gd name="adj" fmla="val 10000"/>
          </a:avLst>
        </a:prstGeom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</dsp:sp>
    <dsp:sp modelId="{0E551DDB-8AE4-4A24-B7CB-F16BE43C6E88}">
      <dsp:nvSpPr>
        <dsp:cNvPr id="0" name=""/>
        <dsp:cNvSpPr/>
      </dsp:nvSpPr>
      <dsp:spPr>
        <a:xfrm>
          <a:off x="6124177" y="4220379"/>
          <a:ext cx="822208" cy="522102"/>
        </a:xfrm>
        <a:prstGeom prst="roundRect">
          <a:avLst>
            <a:gd name="adj" fmla="val 10000"/>
          </a:avLst>
        </a:prstGeom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lvl="0" algn="ctr" defTabSz="444500" rtl="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>
              <a:cs typeface="+mj-cs"/>
            </a:rPr>
            <a:t>Holstein</a:t>
          </a:r>
        </a:p>
        <a:p>
          <a:pPr lvl="0" algn="ctr" defTabSz="444500" rtl="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>
              <a:cs typeface="+mj-cs"/>
            </a:rPr>
            <a:t>8</a:t>
          </a:r>
          <a:endParaRPr lang="en-US" sz="1000" kern="1200" dirty="0">
            <a:cs typeface="+mj-cs"/>
          </a:endParaRPr>
        </a:p>
      </dsp:txBody>
      <dsp:txXfrm>
        <a:off x="6139469" y="4235671"/>
        <a:ext cx="791624" cy="491518"/>
      </dsp:txXfrm>
    </dsp:sp>
    <dsp:sp modelId="{84C848DC-742D-4281-8FBA-7D2E6EEACB49}">
      <dsp:nvSpPr>
        <dsp:cNvPr id="0" name=""/>
        <dsp:cNvSpPr/>
      </dsp:nvSpPr>
      <dsp:spPr>
        <a:xfrm>
          <a:off x="7037743" y="4133590"/>
          <a:ext cx="822208" cy="522102"/>
        </a:xfrm>
        <a:prstGeom prst="roundRect">
          <a:avLst>
            <a:gd name="adj" fmla="val 10000"/>
          </a:avLst>
        </a:prstGeom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</dsp:sp>
    <dsp:sp modelId="{004916B4-CFB9-45D9-A110-8E508FA98D6E}">
      <dsp:nvSpPr>
        <dsp:cNvPr id="0" name=""/>
        <dsp:cNvSpPr/>
      </dsp:nvSpPr>
      <dsp:spPr>
        <a:xfrm>
          <a:off x="7129099" y="4220379"/>
          <a:ext cx="822208" cy="522102"/>
        </a:xfrm>
        <a:prstGeom prst="roundRect">
          <a:avLst>
            <a:gd name="adj" fmla="val 10000"/>
          </a:avLst>
        </a:prstGeom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lvl="0" algn="ctr" defTabSz="444500" rtl="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>
              <a:cs typeface="+mj-cs"/>
            </a:rPr>
            <a:t>Native</a:t>
          </a:r>
        </a:p>
        <a:p>
          <a:pPr lvl="0" algn="ctr" defTabSz="444500" rtl="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>
              <a:cs typeface="+mj-cs"/>
            </a:rPr>
            <a:t>0</a:t>
          </a:r>
          <a:endParaRPr lang="en-US" sz="1000" kern="1200" dirty="0">
            <a:cs typeface="+mj-cs"/>
          </a:endParaRPr>
        </a:p>
      </dsp:txBody>
      <dsp:txXfrm>
        <a:off x="7144391" y="4235671"/>
        <a:ext cx="791624" cy="491518"/>
      </dsp:txXfrm>
    </dsp:sp>
    <dsp:sp modelId="{DD37CAD5-583C-4E88-BBFF-AB7E89C63E39}">
      <dsp:nvSpPr>
        <dsp:cNvPr id="0" name=""/>
        <dsp:cNvSpPr/>
      </dsp:nvSpPr>
      <dsp:spPr>
        <a:xfrm>
          <a:off x="8042665" y="4133590"/>
          <a:ext cx="822208" cy="522102"/>
        </a:xfrm>
        <a:prstGeom prst="roundRect">
          <a:avLst>
            <a:gd name="adj" fmla="val 10000"/>
          </a:avLst>
        </a:prstGeom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</dsp:sp>
    <dsp:sp modelId="{BD8E69F2-63AE-4532-855E-10C863ACFAC9}">
      <dsp:nvSpPr>
        <dsp:cNvPr id="0" name=""/>
        <dsp:cNvSpPr/>
      </dsp:nvSpPr>
      <dsp:spPr>
        <a:xfrm>
          <a:off x="8134021" y="4220379"/>
          <a:ext cx="822208" cy="522102"/>
        </a:xfrm>
        <a:prstGeom prst="roundRect">
          <a:avLst>
            <a:gd name="adj" fmla="val 10000"/>
          </a:avLst>
        </a:prstGeom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lvl="0" algn="ctr" defTabSz="444500" rtl="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>
              <a:cs typeface="+mj-cs"/>
            </a:rPr>
            <a:t>Others</a:t>
          </a:r>
        </a:p>
        <a:p>
          <a:pPr lvl="0" algn="ctr" defTabSz="444500" rtl="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>
              <a:cs typeface="+mj-cs"/>
            </a:rPr>
            <a:t>1</a:t>
          </a:r>
          <a:endParaRPr lang="en-US" sz="1000" kern="1200" dirty="0">
            <a:cs typeface="+mj-cs"/>
          </a:endParaRPr>
        </a:p>
      </dsp:txBody>
      <dsp:txXfrm>
        <a:off x="8149313" y="4235671"/>
        <a:ext cx="791624" cy="491518"/>
      </dsp:txXfrm>
    </dsp:sp>
    <dsp:sp modelId="{64832586-715F-4AC3-B3F7-8A64339DD70D}">
      <dsp:nvSpPr>
        <dsp:cNvPr id="0" name=""/>
        <dsp:cNvSpPr/>
      </dsp:nvSpPr>
      <dsp:spPr>
        <a:xfrm>
          <a:off x="9867257" y="3372362"/>
          <a:ext cx="1192712" cy="522102"/>
        </a:xfrm>
        <a:prstGeom prst="roundRect">
          <a:avLst>
            <a:gd name="adj" fmla="val 10000"/>
          </a:avLst>
        </a:prstGeom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</dsp:sp>
    <dsp:sp modelId="{22380030-06A3-413E-BE9B-63E74E763B1B}">
      <dsp:nvSpPr>
        <dsp:cNvPr id="0" name=""/>
        <dsp:cNvSpPr/>
      </dsp:nvSpPr>
      <dsp:spPr>
        <a:xfrm>
          <a:off x="9958614" y="3459150"/>
          <a:ext cx="1192712" cy="522102"/>
        </a:xfrm>
        <a:prstGeom prst="roundRect">
          <a:avLst>
            <a:gd name="adj" fmla="val 10000"/>
          </a:avLst>
        </a:prstGeom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lvl="0" algn="ctr" defTabSz="444500" rtl="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>
              <a:cs typeface="+mj-cs"/>
            </a:rPr>
            <a:t>Complicated 3 (25%)</a:t>
          </a:r>
          <a:endParaRPr lang="en-US" sz="1000" kern="1200" dirty="0">
            <a:cs typeface="+mj-cs"/>
          </a:endParaRPr>
        </a:p>
      </dsp:txBody>
      <dsp:txXfrm>
        <a:off x="9973906" y="3474442"/>
        <a:ext cx="1162128" cy="491518"/>
      </dsp:txXfrm>
    </dsp:sp>
    <dsp:sp modelId="{647246EF-7206-4029-A4D2-D57775829928}">
      <dsp:nvSpPr>
        <dsp:cNvPr id="0" name=""/>
        <dsp:cNvSpPr/>
      </dsp:nvSpPr>
      <dsp:spPr>
        <a:xfrm>
          <a:off x="9047587" y="4133590"/>
          <a:ext cx="822208" cy="522102"/>
        </a:xfrm>
        <a:prstGeom prst="roundRect">
          <a:avLst>
            <a:gd name="adj" fmla="val 10000"/>
          </a:avLst>
        </a:prstGeom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</dsp:sp>
    <dsp:sp modelId="{20BCFE9A-C10D-49DB-8521-E8ACB9409F65}">
      <dsp:nvSpPr>
        <dsp:cNvPr id="0" name=""/>
        <dsp:cNvSpPr/>
      </dsp:nvSpPr>
      <dsp:spPr>
        <a:xfrm>
          <a:off x="9138944" y="4220379"/>
          <a:ext cx="822208" cy="522102"/>
        </a:xfrm>
        <a:prstGeom prst="roundRect">
          <a:avLst>
            <a:gd name="adj" fmla="val 10000"/>
          </a:avLst>
        </a:prstGeom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lvl="0" algn="ctr" defTabSz="444500" rtl="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>
              <a:cs typeface="+mj-cs"/>
            </a:rPr>
            <a:t>Holstein</a:t>
          </a:r>
        </a:p>
        <a:p>
          <a:pPr lvl="0" algn="ctr" defTabSz="444500" rtl="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>
              <a:cs typeface="+mj-cs"/>
            </a:rPr>
            <a:t>2</a:t>
          </a:r>
          <a:endParaRPr lang="en-US" sz="1000" kern="1200" dirty="0">
            <a:cs typeface="+mj-cs"/>
          </a:endParaRPr>
        </a:p>
      </dsp:txBody>
      <dsp:txXfrm>
        <a:off x="9154236" y="4235671"/>
        <a:ext cx="791624" cy="491518"/>
      </dsp:txXfrm>
    </dsp:sp>
    <dsp:sp modelId="{10496025-7742-4987-80BB-AD3BA5F5AD31}">
      <dsp:nvSpPr>
        <dsp:cNvPr id="0" name=""/>
        <dsp:cNvSpPr/>
      </dsp:nvSpPr>
      <dsp:spPr>
        <a:xfrm>
          <a:off x="10052509" y="4133590"/>
          <a:ext cx="822208" cy="522102"/>
        </a:xfrm>
        <a:prstGeom prst="roundRect">
          <a:avLst>
            <a:gd name="adj" fmla="val 10000"/>
          </a:avLst>
        </a:prstGeom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</dsp:sp>
    <dsp:sp modelId="{61D15AC1-C4BA-486B-A371-6B8A05681208}">
      <dsp:nvSpPr>
        <dsp:cNvPr id="0" name=""/>
        <dsp:cNvSpPr/>
      </dsp:nvSpPr>
      <dsp:spPr>
        <a:xfrm>
          <a:off x="10143866" y="4220379"/>
          <a:ext cx="822208" cy="522102"/>
        </a:xfrm>
        <a:prstGeom prst="roundRect">
          <a:avLst>
            <a:gd name="adj" fmla="val 10000"/>
          </a:avLst>
        </a:prstGeom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lvl="0" algn="ctr" defTabSz="444500" rtl="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>
              <a:cs typeface="+mj-cs"/>
            </a:rPr>
            <a:t>Native</a:t>
          </a:r>
        </a:p>
        <a:p>
          <a:pPr lvl="0" algn="ctr" defTabSz="444500" rtl="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>
              <a:cs typeface="+mj-cs"/>
            </a:rPr>
            <a:t>0</a:t>
          </a:r>
          <a:endParaRPr lang="en-US" sz="1000" kern="1200" dirty="0">
            <a:cs typeface="+mj-cs"/>
          </a:endParaRPr>
        </a:p>
      </dsp:txBody>
      <dsp:txXfrm>
        <a:off x="10159158" y="4235671"/>
        <a:ext cx="791624" cy="491518"/>
      </dsp:txXfrm>
    </dsp:sp>
    <dsp:sp modelId="{10E1FA96-19F5-440B-A4E0-AF0DC38FB8D1}">
      <dsp:nvSpPr>
        <dsp:cNvPr id="0" name=""/>
        <dsp:cNvSpPr/>
      </dsp:nvSpPr>
      <dsp:spPr>
        <a:xfrm>
          <a:off x="11057431" y="4133590"/>
          <a:ext cx="822208" cy="522102"/>
        </a:xfrm>
        <a:prstGeom prst="roundRect">
          <a:avLst>
            <a:gd name="adj" fmla="val 10000"/>
          </a:avLst>
        </a:prstGeom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</dsp:sp>
    <dsp:sp modelId="{B2D96498-F065-49BE-95C9-80EB16D43058}">
      <dsp:nvSpPr>
        <dsp:cNvPr id="0" name=""/>
        <dsp:cNvSpPr/>
      </dsp:nvSpPr>
      <dsp:spPr>
        <a:xfrm>
          <a:off x="11148788" y="4220379"/>
          <a:ext cx="822208" cy="522102"/>
        </a:xfrm>
        <a:prstGeom prst="roundRect">
          <a:avLst>
            <a:gd name="adj" fmla="val 10000"/>
          </a:avLst>
        </a:prstGeom>
        <a:solidFill>
          <a:schemeClr val="lt1"/>
        </a:solidFill>
        <a:ln w="12700" cap="flat" cmpd="sng" algn="ctr">
          <a:solidFill>
            <a:schemeClr val="dk1"/>
          </a:solidFill>
          <a:prstDash val="solid"/>
          <a:miter lim="800000"/>
        </a:ln>
        <a:effectLst/>
      </dsp:spPr>
      <dsp:style>
        <a:lnRef idx="2">
          <a:schemeClr val="dk1"/>
        </a:lnRef>
        <a:fillRef idx="1">
          <a:schemeClr val="lt1"/>
        </a:fillRef>
        <a:effectRef idx="0">
          <a:schemeClr val="dk1"/>
        </a:effectRef>
        <a:fontRef idx="minor">
          <a:schemeClr val="dk1"/>
        </a:fontRef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lvl="0" algn="ctr" defTabSz="444500" rtl="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>
              <a:cs typeface="+mj-cs"/>
            </a:rPr>
            <a:t>Others</a:t>
          </a:r>
        </a:p>
        <a:p>
          <a:pPr lvl="0" algn="ctr" defTabSz="444500" rtl="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>
              <a:cs typeface="+mj-cs"/>
            </a:rPr>
            <a:t>1</a:t>
          </a:r>
          <a:endParaRPr lang="en-US" sz="1000" kern="1200" dirty="0">
            <a:cs typeface="+mj-cs"/>
          </a:endParaRPr>
        </a:p>
      </dsp:txBody>
      <dsp:txXfrm>
        <a:off x="11164080" y="4235671"/>
        <a:ext cx="791624" cy="491518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hierarchy1">
  <dgm:title val=""/>
  <dgm:desc val=""/>
  <dgm:catLst>
    <dgm:cat type="hierarchy" pri="2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</dgm:ptLst>
      <dgm:cxnLst>
        <dgm:cxn modelId="4" srcId="0" destId="1" srcOrd="0" destOrd="0"/>
        <dgm:cxn modelId="5" srcId="1" destId="2" srcOrd="0" destOrd="0"/>
        <dgm:cxn modelId="6" srcId="1" destId="3" srcOrd="1" destOrd="0"/>
        <dgm:cxn modelId="23" srcId="2" destId="21" srcOrd="0" destOrd="0"/>
        <dgm:cxn modelId="24" srcId="2" destId="22" srcOrd="1" destOrd="0"/>
        <dgm:cxn modelId="33" srcId="3" destId="31" srcOrd="0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12"/>
      </dgm:ptLst>
      <dgm:cxnLst>
        <dgm:cxn modelId="2" srcId="0" destId="1" srcOrd="0" destOrd="0"/>
        <dgm:cxn modelId="13" srcId="1" destId="11" srcOrd="0" destOrd="0"/>
        <dgm:cxn modelId="14" srcId="1" destId="1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21"/>
        <dgm:pt modelId="211"/>
        <dgm:pt modelId="3"/>
        <dgm:pt modelId="31"/>
        <dgm:pt modelId="311"/>
      </dgm:ptLst>
      <dgm:cxnLst>
        <dgm:cxn modelId="4" srcId="0" destId="1" srcOrd="0" destOrd="0"/>
        <dgm:cxn modelId="5" srcId="1" destId="2" srcOrd="0" destOrd="0"/>
        <dgm:cxn modelId="6" srcId="1" destId="3" srcOrd="1" destOrd="0"/>
        <dgm:cxn modelId="23" srcId="2" destId="21" srcOrd="0" destOrd="0"/>
        <dgm:cxn modelId="24" srcId="21" destId="211" srcOrd="0" destOrd="0"/>
        <dgm:cxn modelId="33" srcId="3" destId="31" srcOrd="0" destOrd="0"/>
        <dgm:cxn modelId="34" srcId="31" destId="311" srcOrd="0" destOrd="0"/>
      </dgm:cxnLst>
      <dgm:bg/>
      <dgm:whole/>
    </dgm:dataModel>
  </dgm:clrData>
  <dgm:layoutNode name="hierChild1">
    <dgm:varLst>
      <dgm:chPref val="1"/>
      <dgm:dir/>
      <dgm:animOne val="branch"/>
      <dgm:animLvl val="lvl"/>
      <dgm:resizeHandles/>
    </dgm:varLst>
    <dgm:choose name="Name0">
      <dgm:if name="Name1" func="var" arg="dir" op="equ" val="norm">
        <dgm:alg type="hierChild">
          <dgm:param type="linDir" val="fromL"/>
        </dgm:alg>
      </dgm:if>
      <dgm:else name="Name2">
        <dgm:alg type="hierChild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primFontSz" for="des" ptType="node" op="equ" val="65"/>
      <dgm:constr type="w" for="des" forName="composite" refType="w"/>
      <dgm:constr type="h" for="des" forName="composite" refType="w" refFor="des" refForName="composite" fact="0.667"/>
      <dgm:constr type="w" for="des" forName="composite2" refType="w" refFor="des" refForName="composite"/>
      <dgm:constr type="h" for="des" forName="composite2" refType="h" refFor="des" refForName="composite"/>
      <dgm:constr type="w" for="des" forName="composite3" refType="w" refFor="des" refForName="composite"/>
      <dgm:constr type="h" for="des" forName="composite3" refType="h" refFor="des" refForName="composite"/>
      <dgm:constr type="w" for="des" forName="composite4" refType="w" refFor="des" refForName="composite"/>
      <dgm:constr type="h" for="des" forName="composite4" refType="h" refFor="des" refForName="composite"/>
      <dgm:constr type="w" for="des" forName="composite5" refType="w" refFor="des" refForName="composite"/>
      <dgm:constr type="h" for="des" forName="composite5" refType="h" refFor="des" refForName="composite"/>
      <dgm:constr type="sibSp" refType="w" refFor="des" refForName="composite" fact="0.1"/>
      <dgm:constr type="sibSp" for="des" forName="hierChild2" refType="sibSp"/>
      <dgm:constr type="sibSp" for="des" forName="hierChild3" refType="sibSp"/>
      <dgm:constr type="sibSp" for="des" forName="hierChild4" refType="sibSp"/>
      <dgm:constr type="sibSp" for="des" forName="hierChild5" refType="sibSp"/>
      <dgm:constr type="sibSp" for="des" forName="hierChild6" refType="sibSp"/>
      <dgm:constr type="sp" for="des" forName="hierRoot1" refType="h" refFor="des" refForName="composite" fact="0.25"/>
      <dgm:constr type="sp" for="des" forName="hierRoot2" refType="sp" refFor="des" refForName="hierRoot1"/>
      <dgm:constr type="sp" for="des" forName="hierRoot3" refType="sp" refFor="des" refForName="hierRoot1"/>
      <dgm:constr type="sp" for="des" forName="hierRoot4" refType="sp" refFor="des" refForName="hierRoot1"/>
      <dgm:constr type="sp" for="des" forName="hierRoot5" refType="sp" refFor="des" refForName="hierRoot1"/>
    </dgm:constrLst>
    <dgm:ruleLst/>
    <dgm:forEach name="Name3" axis="ch">
      <dgm:forEach name="Name4" axis="self" ptType="node">
        <dgm:layoutNode name="hierRoot1">
          <dgm:alg type="hierRoot"/>
          <dgm:shape xmlns:r="http://schemas.openxmlformats.org/officeDocument/2006/relationships" r:blip="">
            <dgm:adjLst/>
          </dgm:shape>
          <dgm:presOf/>
          <dgm:constrLst>
            <dgm:constr type="bendDist" for="des" ptType="parTrans" refType="sp" fact="0.5"/>
          </dgm:constrLst>
          <dgm:ruleLst/>
          <dgm:layoutNode name="composite">
            <dgm:alg type="composite"/>
            <dgm:shape xmlns:r="http://schemas.openxmlformats.org/officeDocument/2006/relationships" r:blip="">
              <dgm:adjLst/>
            </dgm:shape>
            <dgm:presOf/>
            <dgm:constrLst>
              <dgm:constr type="w" for="ch" forName="background" refType="w" fact="0.9"/>
              <dgm:constr type="h" for="ch" forName="background" refType="w" refFor="ch" refForName="background" fact="0.635"/>
              <dgm:constr type="t" for="ch" forName="background"/>
              <dgm:constr type="l" for="ch" forName="background"/>
              <dgm:constr type="w" for="ch" forName="text" refType="w" fact="0.9"/>
              <dgm:constr type="h" for="ch" forName="text" refType="w" refFor="ch" refForName="text" fact="0.635"/>
              <dgm:constr type="t" for="ch" forName="text" refType="w" fact="0.095"/>
              <dgm:constr type="l" for="ch" forName="text" refType="w" fact="0.1"/>
            </dgm:constrLst>
            <dgm:ruleLst/>
            <dgm:layoutNode name="background" styleLbl="node0" moveWith="text">
              <dgm:alg type="sp"/>
              <dgm:shape xmlns:r="http://schemas.openxmlformats.org/officeDocument/2006/relationships" type="roundRect" r:blip="">
                <dgm:adjLst>
                  <dgm:adj idx="1" val="0.1"/>
                </dgm:adjLst>
              </dgm:shape>
              <dgm:presOf/>
              <dgm:constrLst/>
              <dgm:ruleLst/>
            </dgm:layoutNode>
            <dgm:layoutNode name="text" styleLbl="fgAcc0">
              <dgm:varLst>
                <dgm:chPref val="3"/>
              </dgm:varLst>
              <dgm:alg type="tx"/>
              <dgm:shape xmlns:r="http://schemas.openxmlformats.org/officeDocument/2006/relationships" type="roundRect" r:blip="">
                <dgm:adjLst>
                  <dgm:adj idx="1" val="0.1"/>
                </dgm:adjLst>
              </dgm:shape>
              <dgm:presOf axis="self"/>
              <dgm:constrLst>
                <dgm:constr type="tMarg" refType="primFontSz" fact="0.3"/>
                <dgm:constr type="bMarg" refType="primFontSz" fact="0.3"/>
                <dgm:constr type="lMarg" refType="primFontSz" fact="0.3"/>
                <dgm:constr type="rMarg" refType="primFontSz" fact="0.3"/>
              </dgm:constrLst>
              <dgm:ruleLst>
                <dgm:rule type="primFontSz" val="5" fact="NaN" max="NaN"/>
              </dgm:ruleLst>
            </dgm:layoutNode>
          </dgm:layoutNode>
          <dgm:layoutNode name="hierChild2">
            <dgm:choose name="Name5">
              <dgm:if name="Name6" func="var" arg="dir" op="equ" val="norm">
                <dgm:alg type="hierChild">
                  <dgm:param type="linDir" val="fromL"/>
                </dgm:alg>
              </dgm:if>
              <dgm:else name="Name7">
                <dgm:alg type="hierChild">
                  <dgm:param type="linDir" val="fromR"/>
                </dgm:alg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Name8" axis="ch">
              <dgm:forEach name="Name9" axis="self" ptType="parTrans" cnt="1">
                <dgm:layoutNode name="Name10">
                  <dgm:alg type="conn">
                    <dgm:param type="dim" val="1D"/>
                    <dgm:param type="endSty" val="noArr"/>
                    <dgm:param type="connRout" val="bend"/>
                    <dgm:param type="bendPt" val="end"/>
                    <dgm:param type="begPts" val="bCtr"/>
                    <dgm:param type="endPts" val="tCtr"/>
                    <dgm:param type="srcNode" val="background"/>
                    <dgm:param type="dstNode" val="background2"/>
                  </dgm:alg>
                  <dgm:shape xmlns:r="http://schemas.openxmlformats.org/officeDocument/2006/relationships" type="conn" r:blip="" zOrderOff="-999">
                    <dgm:adjLst/>
                  </dgm:shape>
                  <dgm:presOf axis="self"/>
                  <dgm:constrLst>
                    <dgm:constr type="begPad"/>
                    <dgm:constr type="endPad"/>
                  </dgm:constrLst>
                  <dgm:ruleLst/>
                </dgm:layoutNode>
              </dgm:forEach>
              <dgm:forEach name="Name11" axis="self" ptType="node">
                <dgm:layoutNode name="hierRoot2">
                  <dgm:alg type="hierRoot"/>
                  <dgm:shape xmlns:r="http://schemas.openxmlformats.org/officeDocument/2006/relationships" r:blip="">
                    <dgm:adjLst/>
                  </dgm:shape>
                  <dgm:presOf/>
                  <dgm:constrLst>
                    <dgm:constr type="bendDist" for="des" ptType="parTrans" refType="sp" fact="0.5"/>
                  </dgm:constrLst>
                  <dgm:ruleLst/>
                  <dgm:layoutNode name="composite2">
                    <dgm:alg type="composite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w" for="ch" forName="background2" refType="w" fact="0.9"/>
                      <dgm:constr type="h" for="ch" forName="background2" refType="w" refFor="ch" refForName="background2" fact="0.635"/>
                      <dgm:constr type="t" for="ch" forName="background2"/>
                      <dgm:constr type="l" for="ch" forName="background2"/>
                      <dgm:constr type="w" for="ch" forName="text2" refType="w" fact="0.9"/>
                      <dgm:constr type="h" for="ch" forName="text2" refType="w" refFor="ch" refForName="text2" fact="0.635"/>
                      <dgm:constr type="t" for="ch" forName="text2" refType="w" fact="0.095"/>
                      <dgm:constr type="l" for="ch" forName="text2" refType="w" fact="0.1"/>
                    </dgm:constrLst>
                    <dgm:ruleLst/>
                    <dgm:layoutNode name="background2" moveWith="text2">
                      <dgm:alg type="sp"/>
                      <dgm:shape xmlns:r="http://schemas.openxmlformats.org/officeDocument/2006/relationships" type="roundRect" r:blip="">
                        <dgm:adjLst>
                          <dgm:adj idx="1" val="0.1"/>
                        </dgm:adjLst>
                      </dgm:shape>
                      <dgm:presOf/>
                      <dgm:constrLst/>
                      <dgm:ruleLst/>
                    </dgm:layoutNode>
                    <dgm:layoutNode name="text2" styleLbl="fgAcc2">
                      <dgm:varLst>
                        <dgm:chPref val="3"/>
                      </dgm:varLst>
                      <dgm:alg type="tx"/>
                      <dgm:shape xmlns:r="http://schemas.openxmlformats.org/officeDocument/2006/relationships" type="roundRect" r:blip="">
                        <dgm:adjLst>
                          <dgm:adj idx="1" val="0.1"/>
                        </dgm:adjLst>
                      </dgm:shape>
                      <dgm:presOf axis="self"/>
                      <dgm:constrLst>
                        <dgm:constr type="tMarg" refType="primFontSz" fact="0.3"/>
                        <dgm:constr type="bMarg" refType="primFontSz" fact="0.3"/>
                        <dgm:constr type="lMarg" refType="primFontSz" fact="0.3"/>
                        <dgm:constr type="rMarg" refType="primFontSz" fact="0.3"/>
                      </dgm:constrLst>
                      <dgm:ruleLst>
                        <dgm:rule type="primFontSz" val="5" fact="NaN" max="NaN"/>
                      </dgm:ruleLst>
                    </dgm:layoutNode>
                  </dgm:layoutNode>
                  <dgm:layoutNode name="hierChild3">
                    <dgm:choose name="Name12">
                      <dgm:if name="Name13" func="var" arg="dir" op="equ" val="norm">
                        <dgm:alg type="hierChild">
                          <dgm:param type="linDir" val="fromL"/>
                        </dgm:alg>
                      </dgm:if>
                      <dgm:else name="Name14">
                        <dgm:alg type="hierChild">
                          <dgm:param type="linDir" val="fromR"/>
                        </dgm:alg>
                      </dgm:else>
                    </dgm:choose>
                    <dgm:shape xmlns:r="http://schemas.openxmlformats.org/officeDocument/2006/relationships" r:blip="">
                      <dgm:adjLst/>
                    </dgm:shape>
                    <dgm:presOf/>
                    <dgm:constrLst/>
                    <dgm:ruleLst/>
                    <dgm:forEach name="Name15" axis="ch">
                      <dgm:forEach name="Name16" axis="self" ptType="parTrans" cnt="1">
                        <dgm:layoutNode name="Name17">
                          <dgm:alg type="conn">
                            <dgm:param type="dim" val="1D"/>
                            <dgm:param type="endSty" val="noArr"/>
                            <dgm:param type="connRout" val="bend"/>
                            <dgm:param type="bendPt" val="end"/>
                            <dgm:param type="begPts" val="bCtr"/>
                            <dgm:param type="endPts" val="tCtr"/>
                            <dgm:param type="srcNode" val="background2"/>
                            <dgm:param type="dstNode" val="background3"/>
                          </dgm:alg>
                          <dgm:shape xmlns:r="http://schemas.openxmlformats.org/officeDocument/2006/relationships" type="conn" r:blip="" zOrderOff="-999">
                            <dgm:adjLst/>
                          </dgm:shape>
                          <dgm:presOf axis="self"/>
                          <dgm:constrLst>
                            <dgm:constr type="begPad"/>
                            <dgm:constr type="endPad"/>
                          </dgm:constrLst>
                          <dgm:ruleLst/>
                        </dgm:layoutNode>
                      </dgm:forEach>
                      <dgm:forEach name="Name18" axis="self" ptType="node">
                        <dgm:layoutNode name="hierRoot3">
                          <dgm:alg type="hierRoot"/>
                          <dgm:shape xmlns:r="http://schemas.openxmlformats.org/officeDocument/2006/relationships" r:blip="">
                            <dgm:adjLst/>
                          </dgm:shape>
                          <dgm:presOf/>
                          <dgm:constrLst>
                            <dgm:constr type="bendDist" for="des" ptType="parTrans" refType="sp" fact="0.5"/>
                          </dgm:constrLst>
                          <dgm:ruleLst/>
                          <dgm:layoutNode name="composite3">
                            <dgm:alg type="composite"/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>
                              <dgm:constr type="w" for="ch" forName="background3" refType="w" fact="0.9"/>
                              <dgm:constr type="h" for="ch" forName="background3" refType="w" refFor="ch" refForName="background3" fact="0.635"/>
                              <dgm:constr type="t" for="ch" forName="background3"/>
                              <dgm:constr type="l" for="ch" forName="background3"/>
                              <dgm:constr type="w" for="ch" forName="text3" refType="w" fact="0.9"/>
                              <dgm:constr type="h" for="ch" forName="text3" refType="w" refFor="ch" refForName="text3" fact="0.635"/>
                              <dgm:constr type="t" for="ch" forName="text3" refType="w" fact="0.095"/>
                              <dgm:constr type="l" for="ch" forName="text3" refType="w" fact="0.1"/>
                            </dgm:constrLst>
                            <dgm:ruleLst/>
                            <dgm:layoutNode name="background3" moveWith="text3">
                              <dgm:alg type="sp"/>
                              <dgm:shape xmlns:r="http://schemas.openxmlformats.org/officeDocument/2006/relationships" type="roundRect" r:blip="">
                                <dgm:adjLst>
                                  <dgm:adj idx="1" val="0.1"/>
                                </dgm:adjLst>
                              </dgm:shape>
                              <dgm:presOf/>
                              <dgm:constrLst/>
                              <dgm:ruleLst/>
                            </dgm:layoutNode>
                            <dgm:layoutNode name="text3" styleLbl="fgAcc3">
                              <dgm:varLst>
                                <dgm:chPref val="3"/>
                              </dgm:varLst>
                              <dgm:alg type="tx"/>
                              <dgm:shape xmlns:r="http://schemas.openxmlformats.org/officeDocument/2006/relationships" type="roundRect" r:blip="">
                                <dgm:adjLst>
                                  <dgm:adj idx="1" val="0.1"/>
                                </dgm:adjLst>
                              </dgm:shape>
                              <dgm:presOf axis="self"/>
                              <dgm:constrLst>
                                <dgm:constr type="tMarg" refType="primFontSz" fact="0.3"/>
                                <dgm:constr type="bMarg" refType="primFontSz" fact="0.3"/>
                                <dgm:constr type="lMarg" refType="primFontSz" fact="0.3"/>
                                <dgm:constr type="rMarg" refType="primFontSz" fact="0.3"/>
                              </dgm:constrLst>
                              <dgm:ruleLst>
                                <dgm:rule type="primFontSz" val="5" fact="NaN" max="NaN"/>
                              </dgm:ruleLst>
                            </dgm:layoutNode>
                          </dgm:layoutNode>
                          <dgm:layoutNode name="hierChild4">
                            <dgm:choose name="Name19">
                              <dgm:if name="Name20" func="var" arg="dir" op="equ" val="norm">
                                <dgm:alg type="hierChild">
                                  <dgm:param type="linDir" val="fromL"/>
                                </dgm:alg>
                              </dgm:if>
                              <dgm:else name="Name21">
                                <dgm:alg type="hierChild">
                                  <dgm:param type="linDir" val="fromR"/>
                                </dgm:alg>
                              </dgm:else>
                            </dgm:choose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/>
                            <dgm:ruleLst/>
                            <dgm:forEach name="repeat" axis="ch">
                              <dgm:forEach name="Name22" axis="self" ptType="parTrans" cnt="1">
                                <dgm:layoutNode name="Name23">
                                  <dgm:choose name="Name24">
                                    <dgm:if name="Name25" axis="self" func="depth" op="lte" val="4">
                                      <dgm:alg type="conn">
                                        <dgm:param type="dim" val="1D"/>
                                        <dgm:param type="endSty" val="noArr"/>
                                        <dgm:param type="connRout" val="bend"/>
                                        <dgm:param type="bendPt" val="end"/>
                                        <dgm:param type="begPts" val="bCtr"/>
                                        <dgm:param type="endPts" val="tCtr"/>
                                        <dgm:param type="srcNode" val="background3"/>
                                        <dgm:param type="dstNode" val="background4"/>
                                      </dgm:alg>
                                    </dgm:if>
                                    <dgm:else name="Name26">
                                      <dgm:alg type="conn">
                                        <dgm:param type="dim" val="1D"/>
                                        <dgm:param type="endSty" val="noArr"/>
                                        <dgm:param type="connRout" val="bend"/>
                                        <dgm:param type="bendPt" val="end"/>
                                        <dgm:param type="begPts" val="bCtr"/>
                                        <dgm:param type="endPts" val="tCtr"/>
                                        <dgm:param type="srcNode" val="background4"/>
                                        <dgm:param type="dstNode" val="background4"/>
                                      </dgm:alg>
                                    </dgm:else>
                                  </dgm:choose>
                                  <dgm:shape xmlns:r="http://schemas.openxmlformats.org/officeDocument/2006/relationships" type="conn" r:blip="" zOrderOff="-999">
                                    <dgm:adjLst/>
                                  </dgm:shape>
                                  <dgm:presOf axis="self"/>
                                  <dgm:constrLst>
                                    <dgm:constr type="begPad"/>
                                    <dgm:constr type="endPad"/>
                                  </dgm:constrLst>
                                  <dgm:ruleLst/>
                                </dgm:layoutNode>
                              </dgm:forEach>
                              <dgm:forEach name="Name27" axis="self" ptType="node">
                                <dgm:layoutNode name="hierRoot4">
                                  <dgm:alg type="hierRoot"/>
                                  <dgm:shape xmlns:r="http://schemas.openxmlformats.org/officeDocument/2006/relationships" r:blip="">
                                    <dgm:adjLst/>
                                  </dgm:shape>
                                  <dgm:presOf/>
                                  <dgm:constrLst>
                                    <dgm:constr type="bendDist" for="des" ptType="parTrans" refType="sp" fact="0.5"/>
                                  </dgm:constrLst>
                                  <dgm:ruleLst/>
                                  <dgm:layoutNode name="composite4">
                                    <dgm:alg type="composite"/>
                                    <dgm:shape xmlns:r="http://schemas.openxmlformats.org/officeDocument/2006/relationships" r:blip="">
                                      <dgm:adjLst/>
                                    </dgm:shape>
                                    <dgm:presOf/>
                                    <dgm:constrLst>
                                      <dgm:constr type="w" for="ch" forName="background4" refType="w" fact="0.9"/>
                                      <dgm:constr type="h" for="ch" forName="background4" refType="w" refFor="ch" refForName="background4" fact="0.635"/>
                                      <dgm:constr type="t" for="ch" forName="background4"/>
                                      <dgm:constr type="l" for="ch" forName="background4"/>
                                      <dgm:constr type="w" for="ch" forName="text4" refType="w" fact="0.9"/>
                                      <dgm:constr type="h" for="ch" forName="text4" refType="w" refFor="ch" refForName="text4" fact="0.635"/>
                                      <dgm:constr type="t" for="ch" forName="text4" refType="w" fact="0.095"/>
                                      <dgm:constr type="l" for="ch" forName="text4" refType="w" fact="0.1"/>
                                    </dgm:constrLst>
                                    <dgm:ruleLst/>
                                    <dgm:layoutNode name="background4" moveWith="text4">
                                      <dgm:alg type="sp"/>
                                      <dgm:shape xmlns:r="http://schemas.openxmlformats.org/officeDocument/2006/relationships" type="roundRect" r:blip="">
                                        <dgm:adjLst>
                                          <dgm:adj idx="1" val="0.1"/>
                                        </dgm:adjLst>
                                      </dgm:shape>
                                      <dgm:presOf/>
                                      <dgm:constrLst/>
                                      <dgm:ruleLst/>
                                    </dgm:layoutNode>
                                    <dgm:layoutNode name="text4" styleLbl="fgAcc4">
                                      <dgm:varLst>
                                        <dgm:chPref val="3"/>
                                      </dgm:varLst>
                                      <dgm:alg type="tx"/>
                                      <dgm:shape xmlns:r="http://schemas.openxmlformats.org/officeDocument/2006/relationships" type="roundRect" r:blip="">
                                        <dgm:adjLst>
                                          <dgm:adj idx="1" val="0.1"/>
                                        </dgm:adjLst>
                                      </dgm:shape>
                                      <dgm:presOf axis="self"/>
                                      <dgm:constrLst>
                                        <dgm:constr type="tMarg" refType="primFontSz" fact="0.3"/>
                                        <dgm:constr type="bMarg" refType="primFontSz" fact="0.3"/>
                                        <dgm:constr type="lMarg" refType="primFontSz" fact="0.3"/>
                                        <dgm:constr type="rMarg" refType="primFontSz" fact="0.3"/>
                                      </dgm:constrLst>
                                      <dgm:ruleLst>
                                        <dgm:rule type="primFontSz" val="5" fact="NaN" max="NaN"/>
                                      </dgm:ruleLst>
                                    </dgm:layoutNode>
                                  </dgm:layoutNode>
                                  <dgm:layoutNode name="hierChild5">
                                    <dgm:choose name="Name28">
                                      <dgm:if name="Name29" func="var" arg="dir" op="equ" val="norm">
                                        <dgm:alg type="hierChild">
                                          <dgm:param type="linDir" val="fromL"/>
                                        </dgm:alg>
                                      </dgm:if>
                                      <dgm:else name="Name30">
                                        <dgm:alg type="hierChild">
                                          <dgm:param type="linDir" val="fromR"/>
                                        </dgm:alg>
                                      </dgm:else>
                                    </dgm:choose>
                                    <dgm:shape xmlns:r="http://schemas.openxmlformats.org/officeDocument/2006/relationships" r:blip="">
                                      <dgm:adjLst/>
                                    </dgm:shape>
                                    <dgm:presOf/>
                                    <dgm:constrLst/>
                                    <dgm:ruleLst/>
                                    <dgm:forEach name="Name31" ref="repeat"/>
                                  </dgm:layoutNode>
                                </dgm:layoutNode>
                              </dgm:forEach>
                            </dgm:forEach>
                          </dgm:layoutNode>
                        </dgm:layoutNode>
                      </dgm:forEach>
                    </dgm:forEach>
                  </dgm:layoutNode>
                </dgm:layoutNode>
              </dgm:forEach>
            </dgm:forEach>
          </dgm:layoutNod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A6D727-EC4D-4634-B203-471C1D5E213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E4CBFA2-8797-4B63-8BDA-B463B4CB9ED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CFC0E5-17F1-4E62-8671-491943C49D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2309A-4672-4324-832B-FC1521352CED}" type="datetimeFigureOut">
              <a:rPr lang="en-US" smtClean="0"/>
              <a:t>1/1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87AC7D-42D7-4E45-982F-590F6CF994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09AAB7-2509-4427-B512-6FB03CEBB8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4BD68A-685B-4611-A919-5CD35D64A2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98736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384B96-517A-44B6-9FC5-01EDE652C1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EBC770E-4B26-4F93-B05B-9BE5E3D75DF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B12839-6700-4295-BB5D-85B59C2F07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2309A-4672-4324-832B-FC1521352CED}" type="datetimeFigureOut">
              <a:rPr lang="en-US" smtClean="0"/>
              <a:t>1/1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0D084F-4A58-4132-89B3-E19B1A8F20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56298E-0C43-4643-9A95-36C3E46028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4BD68A-685B-4611-A919-5CD35D64A2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32673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EEE1B64-9676-40C2-BCAF-DEACEB90758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1970CF1-736F-470E-958E-926670839C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8F1A63-7343-4C65-92BE-7D6808ADC0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2309A-4672-4324-832B-FC1521352CED}" type="datetimeFigureOut">
              <a:rPr lang="en-US" smtClean="0"/>
              <a:t>1/1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65ACCE-616A-4312-A2C6-0B4D5D3A87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C9D2C9-7339-4F54-8084-E4B63F968C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4BD68A-685B-4611-A919-5CD35D64A2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41399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132661-34E4-4967-930D-B523C4BDB3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657FF29-7E2E-4976-BE72-C00CACA3A24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9DA03C-3439-47F1-B94B-CD02FF8A0D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2309A-4672-4324-832B-FC1521352CED}" type="datetimeFigureOut">
              <a:rPr lang="en-US" smtClean="0"/>
              <a:t>1/1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46C14A-CF41-41DE-BD71-2FD60F96B3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86BE1F-90ED-404E-BDB5-92B88E35BB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4BD68A-685B-4611-A919-5CD35D64A2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34047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A4DB24-E564-4959-89A6-7858600059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06586AB-3165-42A8-9EA2-1A81B0184D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E39BE8-C1EC-49DA-9098-4520A033AF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2309A-4672-4324-832B-FC1521352CED}" type="datetimeFigureOut">
              <a:rPr lang="en-US" smtClean="0"/>
              <a:t>1/1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DA7EF2-8205-423E-9712-770416996A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8C3167-7C90-4C5E-B788-A277F58187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4BD68A-685B-4611-A919-5CD35D64A2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65686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F37DE5-2D89-483F-8EDE-7EC300670E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CA155D3-C7C9-446D-BC92-EC3A6A6ED4C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40EE642-6B9D-4741-9658-4FB058892B7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32ABFCA-BD00-4707-8CB9-D91F73AA3C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2309A-4672-4324-832B-FC1521352CED}" type="datetimeFigureOut">
              <a:rPr lang="en-US" smtClean="0"/>
              <a:t>1/1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4A57B94-01E7-4C8E-B33A-4A2A5FBFF1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7DC9A0B-D928-4C1D-B76D-46CA976A6F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4BD68A-685B-4611-A919-5CD35D64A2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09020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01D1FF-FD2C-4033-A6C9-4CCC73B0E1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D8D5E89-E0A4-41E1-9183-15906A12A3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D01DB3E-7B79-44D0-9958-63E335FE08F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A116F70-9BBF-4FE6-95BC-F009746BEF0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AC4A865-1B9A-4BAC-88B2-D22671B628E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65D2A03-314E-4C75-BFC3-0CA3A09738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2309A-4672-4324-832B-FC1521352CED}" type="datetimeFigureOut">
              <a:rPr lang="en-US" smtClean="0"/>
              <a:t>1/14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81BCC27-CFA9-4A39-9281-BCA265CAF4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80FB2F3-489B-4E08-B4F3-3A4251ADD7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4BD68A-685B-4611-A919-5CD35D64A2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15892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90B1C1-536E-4DCA-9677-49A891B193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4F33FBA-C369-4F73-A818-FF883B4501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2309A-4672-4324-832B-FC1521352CED}" type="datetimeFigureOut">
              <a:rPr lang="en-US" smtClean="0"/>
              <a:t>1/14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3B3F229-4CBE-40AB-AC89-D958D5A7FD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60F12BE-DAB7-46C5-856E-D7165F4939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4BD68A-685B-4611-A919-5CD35D64A2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36391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AB3C804-D3CF-47CA-BE79-6338E6B43E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2309A-4672-4324-832B-FC1521352CED}" type="datetimeFigureOut">
              <a:rPr lang="en-US" smtClean="0"/>
              <a:t>1/14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23FC718-CB3A-4F72-AD08-745E8496CA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93868FE-0616-475F-9CC9-C16004A04E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4BD68A-685B-4611-A919-5CD35D64A2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22231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3A3140-CC9D-437E-97F4-5076B6E690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041F841-791C-4246-B81D-054FC29B5E4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9FD672D-15B5-423C-9FDB-D26ADE5BA56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976E942-E3B8-41D4-8AF3-34EA077D79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2309A-4672-4324-832B-FC1521352CED}" type="datetimeFigureOut">
              <a:rPr lang="en-US" smtClean="0"/>
              <a:t>1/1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D3533F9-0962-4090-9EA9-17C791BD42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3F12A5E-6434-432D-80C0-1EB75CBDB3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4BD68A-685B-4611-A919-5CD35D64A2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29963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EBCFDA-C663-4FB0-861D-F8BD6FBD7D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E295141-7191-4880-A2D5-30A043833DC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AFBC5D1-EF38-4F44-947C-CFD23782DC7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85D276-472A-4293-A4FC-B0C21A1EBA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2309A-4672-4324-832B-FC1521352CED}" type="datetimeFigureOut">
              <a:rPr lang="en-US" smtClean="0"/>
              <a:t>1/1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2C223ED-8C95-400A-A417-881AF50448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99E07BC-E679-4837-BE68-FAB931914D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4BD68A-685B-4611-A919-5CD35D64A2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10744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53AEFD3-08E1-4A25-98C4-54D95AE10F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4511880-E156-4A5B-987C-F8DAFE870A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BBABC1-9DA5-4458-8A6B-AB5091D46EB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42309A-4672-4324-832B-FC1521352CED}" type="datetimeFigureOut">
              <a:rPr lang="en-US" smtClean="0"/>
              <a:t>1/1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1853D3-2F9A-4287-A357-9E87F8418AB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626E0F-439E-4C1C-A7B3-F869CC9ED7C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4BD68A-685B-4611-A919-5CD35D64A2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67378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7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Diagram 3"/>
          <p:cNvGraphicFramePr/>
          <p:nvPr>
            <p:extLst>
              <p:ext uri="{D42A27DB-BD31-4B8C-83A1-F6EECF244321}">
                <p14:modId xmlns:p14="http://schemas.microsoft.com/office/powerpoint/2010/main" val="916024345"/>
              </p:ext>
            </p:extLst>
          </p:nvPr>
        </p:nvGraphicFramePr>
        <p:xfrm>
          <a:off x="95794" y="130629"/>
          <a:ext cx="11974286" cy="6592387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1676400" y="5257800"/>
            <a:ext cx="7132320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 smtClean="0">
                <a:cs typeface="+mj-cs"/>
              </a:rPr>
              <a:t>Diagram 1</a:t>
            </a:r>
            <a:r>
              <a:rPr lang="en-US" sz="1200" dirty="0">
                <a:cs typeface="+mj-cs"/>
              </a:rPr>
              <a:t>: Prevalence of umbilical hernia was highest in Holstein dairy calves managed under the range system</a:t>
            </a:r>
            <a:endParaRPr lang="fa-IR" sz="1200" dirty="0">
              <a:cs typeface="+mj-cs"/>
            </a:endParaRPr>
          </a:p>
        </p:txBody>
      </p:sp>
    </p:spTree>
    <p:extLst>
      <p:ext uri="{BB962C8B-B14F-4D97-AF65-F5344CB8AC3E}">
        <p14:creationId xmlns:p14="http://schemas.microsoft.com/office/powerpoint/2010/main" val="25228914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0</TotalTime>
  <Words>95</Words>
  <Application>Microsoft Office PowerPoint</Application>
  <PresentationFormat>Widescreen</PresentationFormat>
  <Paragraphs>3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RT</dc:creator>
  <cp:lastModifiedBy>Poya System</cp:lastModifiedBy>
  <cp:revision>29</cp:revision>
  <dcterms:created xsi:type="dcterms:W3CDTF">2023-10-18T17:59:16Z</dcterms:created>
  <dcterms:modified xsi:type="dcterms:W3CDTF">2025-01-14T15:31:48Z</dcterms:modified>
</cp:coreProperties>
</file>